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C55E300-6EE3-44A8-987D-52B0E36D327D}" v="23" dt="2023-07-27T11:10:07.769"/>
    <p1510:client id="{FC63E179-9B02-418D-8240-7420614BA435}" v="1" dt="2023-07-27T02:30:00.2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5" d="100"/>
          <a:sy n="95" d="100"/>
        </p:scale>
        <p:origin x="182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raig" userId="d588c584-9c58-4480-93d4-d317c75b1e10" providerId="ADAL" clId="{FC55E300-6EE3-44A8-987D-52B0E36D327D}"/>
    <pc:docChg chg="undo custSel modSld">
      <pc:chgData name="Craig" userId="d588c584-9c58-4480-93d4-d317c75b1e10" providerId="ADAL" clId="{FC55E300-6EE3-44A8-987D-52B0E36D327D}" dt="2023-07-27T11:11:27.862" v="356" actId="14100"/>
      <pc:docMkLst>
        <pc:docMk/>
      </pc:docMkLst>
      <pc:sldChg chg="addSp modSp mod">
        <pc:chgData name="Craig" userId="d588c584-9c58-4480-93d4-d317c75b1e10" providerId="ADAL" clId="{FC55E300-6EE3-44A8-987D-52B0E36D327D}" dt="2023-07-27T11:11:27.862" v="356" actId="14100"/>
        <pc:sldMkLst>
          <pc:docMk/>
          <pc:sldMk cId="162657991" sldId="256"/>
        </pc:sldMkLst>
        <pc:spChg chg="add mod">
          <ac:chgData name="Craig" userId="d588c584-9c58-4480-93d4-d317c75b1e10" providerId="ADAL" clId="{FC55E300-6EE3-44A8-987D-52B0E36D327D}" dt="2023-07-23T22:09:35.373" v="104" actId="113"/>
          <ac:spMkLst>
            <pc:docMk/>
            <pc:sldMk cId="162657991" sldId="256"/>
            <ac:spMk id="2" creationId="{337F93DD-4198-4195-B818-85423E9B1E8B}"/>
          </ac:spMkLst>
        </pc:spChg>
        <pc:spChg chg="add mod">
          <ac:chgData name="Craig" userId="d588c584-9c58-4480-93d4-d317c75b1e10" providerId="ADAL" clId="{FC55E300-6EE3-44A8-987D-52B0E36D327D}" dt="2023-07-27T11:11:27.862" v="356" actId="14100"/>
          <ac:spMkLst>
            <pc:docMk/>
            <pc:sldMk cId="162657991" sldId="256"/>
            <ac:spMk id="3" creationId="{8C20E274-51CC-A112-B710-F70051423E78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162657991" sldId="256"/>
            <ac:spMk id="30" creationId="{DDDF19F5-BC9F-4FA9-CCC5-A65B6BD18BA3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162657991" sldId="256"/>
            <ac:spMk id="44" creationId="{6ED0E8A2-16FD-45A7-2EAD-103F52E1B771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162657991" sldId="256"/>
            <ac:spMk id="69" creationId="{A898E86F-D68C-56CF-3422-9EE79206327C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162657991" sldId="256"/>
            <ac:spMk id="88" creationId="{10767390-8581-E456-5A90-AD8D17F90993}"/>
          </ac:spMkLst>
        </pc:spChg>
        <pc:spChg chg="mod">
          <ac:chgData name="Craig" userId="d588c584-9c58-4480-93d4-d317c75b1e10" providerId="ADAL" clId="{FC55E300-6EE3-44A8-987D-52B0E36D327D}" dt="2023-07-11T18:39:32.520" v="8" actId="20577"/>
          <ac:spMkLst>
            <pc:docMk/>
            <pc:sldMk cId="162657991" sldId="256"/>
            <ac:spMk id="99" creationId="{6B9C4F51-F5FE-EFE0-8FEB-71220DB1EFAC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162657991" sldId="256"/>
            <ac:spMk id="102" creationId="{3FB55661-9761-9918-8116-61D2278DA046}"/>
          </ac:spMkLst>
        </pc:spChg>
        <pc:cxnChg chg="mod">
          <ac:chgData name="Craig" userId="d588c584-9c58-4480-93d4-d317c75b1e10" providerId="ADAL" clId="{FC55E300-6EE3-44A8-987D-52B0E36D327D}" dt="2023-07-11T18:41:44.486" v="23" actId="1035"/>
          <ac:cxnSpMkLst>
            <pc:docMk/>
            <pc:sldMk cId="162657991" sldId="256"/>
            <ac:cxnSpMk id="114" creationId="{E38A8045-A98F-7A83-6396-FC1CF350A1CD}"/>
          </ac:cxnSpMkLst>
        </pc:cxnChg>
      </pc:sldChg>
      <pc:sldChg chg="addSp delSp modSp mod">
        <pc:chgData name="Craig" userId="d588c584-9c58-4480-93d4-d317c75b1e10" providerId="ADAL" clId="{FC55E300-6EE3-44A8-987D-52B0E36D327D}" dt="2023-07-27T11:11:22.669" v="355" actId="14100"/>
        <pc:sldMkLst>
          <pc:docMk/>
          <pc:sldMk cId="1285761949" sldId="257"/>
        </pc:sldMkLst>
        <pc:spChg chg="add mod">
          <ac:chgData name="Craig" userId="d588c584-9c58-4480-93d4-d317c75b1e10" providerId="ADAL" clId="{FC55E300-6EE3-44A8-987D-52B0E36D327D}" dt="2023-07-23T22:10:04.809" v="116" actId="20577"/>
          <ac:spMkLst>
            <pc:docMk/>
            <pc:sldMk cId="1285761949" sldId="257"/>
            <ac:spMk id="2" creationId="{12FFA017-7B0F-989F-F4DC-C3624CD3EEAF}"/>
          </ac:spMkLst>
        </pc:spChg>
        <pc:spChg chg="del">
          <ac:chgData name="Craig" userId="d588c584-9c58-4480-93d4-d317c75b1e10" providerId="ADAL" clId="{FC55E300-6EE3-44A8-987D-52B0E36D327D}" dt="2023-07-27T10:58:16.571" v="253" actId="478"/>
          <ac:spMkLst>
            <pc:docMk/>
            <pc:sldMk cId="1285761949" sldId="257"/>
            <ac:spMk id="3" creationId="{AB8DAF73-4040-9815-FD1A-CF6AFFC0190E}"/>
          </ac:spMkLst>
        </pc:spChg>
        <pc:spChg chg="add del mod">
          <ac:chgData name="Craig" userId="d588c584-9c58-4480-93d4-d317c75b1e10" providerId="ADAL" clId="{FC55E300-6EE3-44A8-987D-52B0E36D327D}" dt="2023-07-27T11:05:18.109" v="304" actId="478"/>
          <ac:spMkLst>
            <pc:docMk/>
            <pc:sldMk cId="1285761949" sldId="257"/>
            <ac:spMk id="4" creationId="{4919FBAE-AF0C-5149-FF7B-DA53A22B82EF}"/>
          </ac:spMkLst>
        </pc:spChg>
        <pc:spChg chg="add mod">
          <ac:chgData name="Craig" userId="d588c584-9c58-4480-93d4-d317c75b1e10" providerId="ADAL" clId="{FC55E300-6EE3-44A8-987D-52B0E36D327D}" dt="2023-07-27T11:11:22.669" v="355" actId="14100"/>
          <ac:spMkLst>
            <pc:docMk/>
            <pc:sldMk cId="1285761949" sldId="257"/>
            <ac:spMk id="6" creationId="{EE6A1E75-2B3F-0CBD-30BA-88E708FBF626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1285761949" sldId="257"/>
            <ac:spMk id="19" creationId="{B7EA828D-B9F5-483E-9DAA-9B6D79B3EF02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1285761949" sldId="257"/>
            <ac:spMk id="30" creationId="{DDDF19F5-BC9F-4FA9-CCC5-A65B6BD18BA3}"/>
          </ac:spMkLst>
        </pc:spChg>
        <pc:spChg chg="mod">
          <ac:chgData name="Craig" userId="d588c584-9c58-4480-93d4-d317c75b1e10" providerId="ADAL" clId="{FC55E300-6EE3-44A8-987D-52B0E36D327D}" dt="2023-07-11T18:41:08.187" v="14" actId="108"/>
          <ac:spMkLst>
            <pc:docMk/>
            <pc:sldMk cId="1285761949" sldId="257"/>
            <ac:spMk id="46" creationId="{8EE99552-126D-51A7-89E3-1E4546488C94}"/>
          </ac:spMkLst>
        </pc:spChg>
        <pc:spChg chg="mod">
          <ac:chgData name="Craig" userId="d588c584-9c58-4480-93d4-d317c75b1e10" providerId="ADAL" clId="{FC55E300-6EE3-44A8-987D-52B0E36D327D}" dt="2023-07-11T18:42:28.457" v="54" actId="20577"/>
          <ac:spMkLst>
            <pc:docMk/>
            <pc:sldMk cId="1285761949" sldId="257"/>
            <ac:spMk id="47" creationId="{047F0D2D-ADE3-DA91-A500-37C654E004E0}"/>
          </ac:spMkLst>
        </pc:spChg>
        <pc:spChg chg="mod">
          <ac:chgData name="Craig" userId="d588c584-9c58-4480-93d4-d317c75b1e10" providerId="ADAL" clId="{FC55E300-6EE3-44A8-987D-52B0E36D327D}" dt="2023-07-11T18:42:04.094" v="43" actId="108"/>
          <ac:spMkLst>
            <pc:docMk/>
            <pc:sldMk cId="1285761949" sldId="257"/>
            <ac:spMk id="49" creationId="{EA22AB20-077A-2D66-9D26-1625BB037606}"/>
          </ac:spMkLst>
        </pc:spChg>
        <pc:spChg chg="mod">
          <ac:chgData name="Craig" userId="d588c584-9c58-4480-93d4-d317c75b1e10" providerId="ADAL" clId="{FC55E300-6EE3-44A8-987D-52B0E36D327D}" dt="2023-07-11T18:41:55.873" v="41" actId="1036"/>
          <ac:spMkLst>
            <pc:docMk/>
            <pc:sldMk cId="1285761949" sldId="257"/>
            <ac:spMk id="50" creationId="{9C267704-220A-39DE-1551-0CCBAC5F7AF0}"/>
          </ac:spMkLst>
        </pc:spChg>
        <pc:cxnChg chg="mod">
          <ac:chgData name="Craig" userId="d588c584-9c58-4480-93d4-d317c75b1e10" providerId="ADAL" clId="{FC55E300-6EE3-44A8-987D-52B0E36D327D}" dt="2023-07-11T18:42:11.129" v="44" actId="108"/>
          <ac:cxnSpMkLst>
            <pc:docMk/>
            <pc:sldMk cId="1285761949" sldId="257"/>
            <ac:cxnSpMk id="43" creationId="{37E8ECAF-A08E-194D-F055-0AF3185EC2AF}"/>
          </ac:cxnSpMkLst>
        </pc:cxnChg>
        <pc:cxnChg chg="mod">
          <ac:chgData name="Craig" userId="d588c584-9c58-4480-93d4-d317c75b1e10" providerId="ADAL" clId="{FC55E300-6EE3-44A8-987D-52B0E36D327D}" dt="2023-07-11T18:41:13.338" v="15" actId="108"/>
          <ac:cxnSpMkLst>
            <pc:docMk/>
            <pc:sldMk cId="1285761949" sldId="257"/>
            <ac:cxnSpMk id="45" creationId="{3CDF5CD2-8E8B-01D8-90D5-89720B458DDB}"/>
          </ac:cxnSpMkLst>
        </pc:cxnChg>
      </pc:sldChg>
      <pc:sldChg chg="addSp delSp modSp mod">
        <pc:chgData name="Craig" userId="d588c584-9c58-4480-93d4-d317c75b1e10" providerId="ADAL" clId="{FC55E300-6EE3-44A8-987D-52B0E36D327D}" dt="2023-07-27T11:09:44.674" v="342" actId="14100"/>
        <pc:sldMkLst>
          <pc:docMk/>
          <pc:sldMk cId="985054504" sldId="258"/>
        </pc:sldMkLst>
        <pc:spChg chg="add mod">
          <ac:chgData name="Craig" userId="d588c584-9c58-4480-93d4-d317c75b1e10" providerId="ADAL" clId="{FC55E300-6EE3-44A8-987D-52B0E36D327D}" dt="2023-07-23T22:10:16.711" v="119" actId="20577"/>
          <ac:spMkLst>
            <pc:docMk/>
            <pc:sldMk cId="985054504" sldId="258"/>
            <ac:spMk id="2" creationId="{BFBE6CFA-D5D1-FD58-EB6E-1AAAD58E35B4}"/>
          </ac:spMkLst>
        </pc:spChg>
        <pc:spChg chg="add del mod">
          <ac:chgData name="Craig" userId="d588c584-9c58-4480-93d4-d317c75b1e10" providerId="ADAL" clId="{FC55E300-6EE3-44A8-987D-52B0E36D327D}" dt="2023-07-27T10:55:31.892" v="221" actId="478"/>
          <ac:spMkLst>
            <pc:docMk/>
            <pc:sldMk cId="985054504" sldId="258"/>
            <ac:spMk id="3" creationId="{7E38D18F-ECFD-D34C-5FB9-F3397AC23AA7}"/>
          </ac:spMkLst>
        </pc:spChg>
        <pc:spChg chg="add del mod">
          <ac:chgData name="Craig" userId="d588c584-9c58-4480-93d4-d317c75b1e10" providerId="ADAL" clId="{FC55E300-6EE3-44A8-987D-52B0E36D327D}" dt="2023-07-27T11:05:30.910" v="307" actId="478"/>
          <ac:spMkLst>
            <pc:docMk/>
            <pc:sldMk cId="985054504" sldId="258"/>
            <ac:spMk id="4" creationId="{94CAC005-D738-1BB8-D5D0-DEC740893A93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985054504" sldId="258"/>
            <ac:spMk id="18" creationId="{BD003571-515F-8944-EF01-B641B9A0229B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985054504" sldId="258"/>
            <ac:spMk id="19" creationId="{B7EA828D-B9F5-483E-9DAA-9B6D79B3EF02}"/>
          </ac:spMkLst>
        </pc:spChg>
        <pc:spChg chg="add mod">
          <ac:chgData name="Craig" userId="d588c584-9c58-4480-93d4-d317c75b1e10" providerId="ADAL" clId="{FC55E300-6EE3-44A8-987D-52B0E36D327D}" dt="2023-07-27T11:09:44.674" v="342" actId="14100"/>
          <ac:spMkLst>
            <pc:docMk/>
            <pc:sldMk cId="985054504" sldId="258"/>
            <ac:spMk id="38" creationId="{B6D6C500-14D5-B1D9-CEBD-5E5079CA7AC8}"/>
          </ac:spMkLst>
        </pc:spChg>
      </pc:sldChg>
      <pc:sldChg chg="addSp delSp modSp mod">
        <pc:chgData name="Craig" userId="d588c584-9c58-4480-93d4-d317c75b1e10" providerId="ADAL" clId="{FC55E300-6EE3-44A8-987D-52B0E36D327D}" dt="2023-07-27T11:09:50.856" v="343" actId="14100"/>
        <pc:sldMkLst>
          <pc:docMk/>
          <pc:sldMk cId="2536820367" sldId="259"/>
        </pc:sldMkLst>
        <pc:spChg chg="add mod">
          <ac:chgData name="Craig" userId="d588c584-9c58-4480-93d4-d317c75b1e10" providerId="ADAL" clId="{FC55E300-6EE3-44A8-987D-52B0E36D327D}" dt="2023-07-23T22:10:30.551" v="122" actId="20577"/>
          <ac:spMkLst>
            <pc:docMk/>
            <pc:sldMk cId="2536820367" sldId="259"/>
            <ac:spMk id="2" creationId="{0DB83AD6-C5CF-9A36-A4AC-1D075931E0C0}"/>
          </ac:spMkLst>
        </pc:spChg>
        <pc:spChg chg="add del mod">
          <ac:chgData name="Craig" userId="d588c584-9c58-4480-93d4-d317c75b1e10" providerId="ADAL" clId="{FC55E300-6EE3-44A8-987D-52B0E36D327D}" dt="2023-07-27T11:05:44.408" v="310" actId="478"/>
          <ac:spMkLst>
            <pc:docMk/>
            <pc:sldMk cId="2536820367" sldId="259"/>
            <ac:spMk id="3" creationId="{45AAD587-008C-F653-4FFB-0A97EC617E08}"/>
          </ac:spMkLst>
        </pc:spChg>
        <pc:spChg chg="add mod">
          <ac:chgData name="Craig" userId="d588c584-9c58-4480-93d4-d317c75b1e10" providerId="ADAL" clId="{FC55E300-6EE3-44A8-987D-52B0E36D327D}" dt="2023-07-27T11:09:50.856" v="343" actId="14100"/>
          <ac:spMkLst>
            <pc:docMk/>
            <pc:sldMk cId="2536820367" sldId="259"/>
            <ac:spMk id="4" creationId="{3B50BAD7-44F0-4A2D-2AF6-5BAED6716943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536820367" sldId="259"/>
            <ac:spMk id="19" creationId="{B7EA828D-B9F5-483E-9DAA-9B6D79B3EF02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536820367" sldId="259"/>
            <ac:spMk id="30" creationId="{DDDF19F5-BC9F-4FA9-CCC5-A65B6BD18BA3}"/>
          </ac:spMkLst>
        </pc:spChg>
        <pc:spChg chg="mod">
          <ac:chgData name="Craig" userId="d588c584-9c58-4480-93d4-d317c75b1e10" providerId="ADAL" clId="{FC55E300-6EE3-44A8-987D-52B0E36D327D}" dt="2023-07-11T18:45:07.349" v="57" actId="108"/>
          <ac:spMkLst>
            <pc:docMk/>
            <pc:sldMk cId="2536820367" sldId="259"/>
            <ac:spMk id="40" creationId="{45851F7E-F8AB-1B23-B665-0C0E41B27987}"/>
          </ac:spMkLst>
        </pc:spChg>
        <pc:spChg chg="mod">
          <ac:chgData name="Craig" userId="d588c584-9c58-4480-93d4-d317c75b1e10" providerId="ADAL" clId="{FC55E300-6EE3-44A8-987D-52B0E36D327D}" dt="2023-07-11T18:44:54.058" v="55" actId="108"/>
          <ac:spMkLst>
            <pc:docMk/>
            <pc:sldMk cId="2536820367" sldId="259"/>
            <ac:spMk id="41" creationId="{E3DEC511-9FD5-45DD-E65C-0BC34732714D}"/>
          </ac:spMkLst>
        </pc:spChg>
        <pc:spChg chg="mod">
          <ac:chgData name="Craig" userId="d588c584-9c58-4480-93d4-d317c75b1e10" providerId="ADAL" clId="{FC55E300-6EE3-44A8-987D-52B0E36D327D}" dt="2023-07-11T18:45:18.959" v="59" actId="108"/>
          <ac:spMkLst>
            <pc:docMk/>
            <pc:sldMk cId="2536820367" sldId="259"/>
            <ac:spMk id="47" creationId="{047F0D2D-ADE3-DA91-A500-37C654E004E0}"/>
          </ac:spMkLst>
        </pc:spChg>
        <pc:cxnChg chg="mod">
          <ac:chgData name="Craig" userId="d588c584-9c58-4480-93d4-d317c75b1e10" providerId="ADAL" clId="{FC55E300-6EE3-44A8-987D-52B0E36D327D}" dt="2023-07-11T18:45:11.696" v="58" actId="108"/>
          <ac:cxnSpMkLst>
            <pc:docMk/>
            <pc:sldMk cId="2536820367" sldId="259"/>
            <ac:cxnSpMk id="39" creationId="{F0FBD3CA-BBEE-B44F-FA53-11F08A6ECD7E}"/>
          </ac:cxnSpMkLst>
        </pc:cxnChg>
        <pc:cxnChg chg="mod">
          <ac:chgData name="Craig" userId="d588c584-9c58-4480-93d4-d317c75b1e10" providerId="ADAL" clId="{FC55E300-6EE3-44A8-987D-52B0E36D327D}" dt="2023-07-11T18:45:32.866" v="60" actId="108"/>
          <ac:cxnSpMkLst>
            <pc:docMk/>
            <pc:sldMk cId="2536820367" sldId="259"/>
            <ac:cxnSpMk id="45" creationId="{3CDF5CD2-8E8B-01D8-90D5-89720B458DDB}"/>
          </ac:cxnSpMkLst>
        </pc:cxnChg>
      </pc:sldChg>
      <pc:sldChg chg="addSp delSp modSp mod">
        <pc:chgData name="Craig" userId="d588c584-9c58-4480-93d4-d317c75b1e10" providerId="ADAL" clId="{FC55E300-6EE3-44A8-987D-52B0E36D327D}" dt="2023-07-27T11:09:55.851" v="344" actId="14100"/>
        <pc:sldMkLst>
          <pc:docMk/>
          <pc:sldMk cId="1001350528" sldId="260"/>
        </pc:sldMkLst>
        <pc:spChg chg="add mod">
          <ac:chgData name="Craig" userId="d588c584-9c58-4480-93d4-d317c75b1e10" providerId="ADAL" clId="{FC55E300-6EE3-44A8-987D-52B0E36D327D}" dt="2023-07-23T22:10:48.258" v="125" actId="20577"/>
          <ac:spMkLst>
            <pc:docMk/>
            <pc:sldMk cId="1001350528" sldId="260"/>
            <ac:spMk id="2" creationId="{DD035347-DC2A-A261-F12A-E0C6116DB04D}"/>
          </ac:spMkLst>
        </pc:spChg>
        <pc:spChg chg="add del mod">
          <ac:chgData name="Craig" userId="d588c584-9c58-4480-93d4-d317c75b1e10" providerId="ADAL" clId="{FC55E300-6EE3-44A8-987D-52B0E36D327D}" dt="2023-07-27T10:55:59.244" v="229"/>
          <ac:spMkLst>
            <pc:docMk/>
            <pc:sldMk cId="1001350528" sldId="260"/>
            <ac:spMk id="3" creationId="{66A2CD12-A630-D4CE-40A7-8C40D68D2310}"/>
          </ac:spMkLst>
        </pc:spChg>
        <pc:spChg chg="add del mod">
          <ac:chgData name="Craig" userId="d588c584-9c58-4480-93d4-d317c75b1e10" providerId="ADAL" clId="{FC55E300-6EE3-44A8-987D-52B0E36D327D}" dt="2023-07-27T11:05:59.064" v="313" actId="478"/>
          <ac:spMkLst>
            <pc:docMk/>
            <pc:sldMk cId="1001350528" sldId="260"/>
            <ac:spMk id="4" creationId="{54E93473-3C51-C5B0-4C5A-1358793A91E4}"/>
          </ac:spMkLst>
        </pc:spChg>
        <pc:spChg chg="add mod">
          <ac:chgData name="Craig" userId="d588c584-9c58-4480-93d4-d317c75b1e10" providerId="ADAL" clId="{FC55E300-6EE3-44A8-987D-52B0E36D327D}" dt="2023-07-27T11:09:55.851" v="344" actId="14100"/>
          <ac:spMkLst>
            <pc:docMk/>
            <pc:sldMk cId="1001350528" sldId="260"/>
            <ac:spMk id="7" creationId="{D79F8225-6627-663C-75A4-156BBB815897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1001350528" sldId="260"/>
            <ac:spMk id="44" creationId="{6ED0E8A2-16FD-45A7-2EAD-103F52E1B771}"/>
          </ac:spMkLst>
        </pc:spChg>
      </pc:sldChg>
      <pc:sldChg chg="addSp delSp modSp mod">
        <pc:chgData name="Craig" userId="d588c584-9c58-4480-93d4-d317c75b1e10" providerId="ADAL" clId="{FC55E300-6EE3-44A8-987D-52B0E36D327D}" dt="2023-07-27T11:10:19.700" v="350" actId="478"/>
        <pc:sldMkLst>
          <pc:docMk/>
          <pc:sldMk cId="2962312190" sldId="261"/>
        </pc:sldMkLst>
        <pc:spChg chg="add mod">
          <ac:chgData name="Craig" userId="d588c584-9c58-4480-93d4-d317c75b1e10" providerId="ADAL" clId="{FC55E300-6EE3-44A8-987D-52B0E36D327D}" dt="2023-07-23T22:11:03.139" v="128" actId="20577"/>
          <ac:spMkLst>
            <pc:docMk/>
            <pc:sldMk cId="2962312190" sldId="261"/>
            <ac:spMk id="2" creationId="{9BC2A85C-E661-04AE-4A41-7CE8F184B27F}"/>
          </ac:spMkLst>
        </pc:spChg>
        <pc:spChg chg="add del mod ord">
          <ac:chgData name="Craig" userId="d588c584-9c58-4480-93d4-d317c75b1e10" providerId="ADAL" clId="{FC55E300-6EE3-44A8-987D-52B0E36D327D}" dt="2023-07-27T11:10:19.700" v="350" actId="478"/>
          <ac:spMkLst>
            <pc:docMk/>
            <pc:sldMk cId="2962312190" sldId="261"/>
            <ac:spMk id="3" creationId="{DAF22B0F-FF45-AD16-AF49-3D5A2A4A8771}"/>
          </ac:spMkLst>
        </pc:spChg>
        <pc:spChg chg="add del mod">
          <ac:chgData name="Craig" userId="d588c584-9c58-4480-93d4-d317c75b1e10" providerId="ADAL" clId="{FC55E300-6EE3-44A8-987D-52B0E36D327D}" dt="2023-07-27T11:06:07.193" v="315"/>
          <ac:spMkLst>
            <pc:docMk/>
            <pc:sldMk cId="2962312190" sldId="261"/>
            <ac:spMk id="4" creationId="{69C2CC68-E441-2403-5D9D-D5FB985155C6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962312190" sldId="261"/>
            <ac:spMk id="6" creationId="{7DC470C7-4FF4-D342-99E8-E8F821044953}"/>
          </ac:spMkLst>
        </pc:spChg>
        <pc:spChg chg="add mod">
          <ac:chgData name="Craig" userId="d588c584-9c58-4480-93d4-d317c75b1e10" providerId="ADAL" clId="{FC55E300-6EE3-44A8-987D-52B0E36D327D}" dt="2023-07-27T11:10:17.269" v="349" actId="404"/>
          <ac:spMkLst>
            <pc:docMk/>
            <pc:sldMk cId="2962312190" sldId="261"/>
            <ac:spMk id="7" creationId="{D99B5647-EFD4-71B5-6EC2-5AD59E87E46D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962312190" sldId="261"/>
            <ac:spMk id="51" creationId="{EFD281FA-6659-C669-8958-649C0D1040A5}"/>
          </ac:spMkLst>
        </pc:spChg>
        <pc:spChg chg="mod">
          <ac:chgData name="Craig" userId="d588c584-9c58-4480-93d4-d317c75b1e10" providerId="ADAL" clId="{FC55E300-6EE3-44A8-987D-52B0E36D327D}" dt="2023-07-11T18:51:59.041" v="68" actId="20577"/>
          <ac:spMkLst>
            <pc:docMk/>
            <pc:sldMk cId="2962312190" sldId="261"/>
            <ac:spMk id="92" creationId="{6DB0A5E7-8C0B-15B6-36E3-BCD1AF5930FC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962312190" sldId="261"/>
            <ac:spMk id="96" creationId="{F13738EC-3793-09D7-BBDF-2F5AE551B241}"/>
          </ac:spMkLst>
        </pc:spChg>
        <pc:spChg chg="mod">
          <ac:chgData name="Craig" userId="d588c584-9c58-4480-93d4-d317c75b1e10" providerId="ADAL" clId="{FC55E300-6EE3-44A8-987D-52B0E36D327D}" dt="2023-07-11T18:52:40.012" v="70" actId="20577"/>
          <ac:spMkLst>
            <pc:docMk/>
            <pc:sldMk cId="2962312190" sldId="261"/>
            <ac:spMk id="105" creationId="{CEC01645-D6EC-6BA5-66A4-CFCDDEBA913E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962312190" sldId="261"/>
            <ac:spMk id="110" creationId="{906CE280-783E-A2B9-4D8E-2FC8A4A82A7E}"/>
          </ac:spMkLst>
        </pc:spChg>
      </pc:sldChg>
      <pc:sldChg chg="addSp delSp modSp mod">
        <pc:chgData name="Craig" userId="d588c584-9c58-4480-93d4-d317c75b1e10" providerId="ADAL" clId="{FC55E300-6EE3-44A8-987D-52B0E36D327D}" dt="2023-07-27T11:10:27.554" v="351" actId="14100"/>
        <pc:sldMkLst>
          <pc:docMk/>
          <pc:sldMk cId="24661109" sldId="262"/>
        </pc:sldMkLst>
        <pc:spChg chg="add mod">
          <ac:chgData name="Craig" userId="d588c584-9c58-4480-93d4-d317c75b1e10" providerId="ADAL" clId="{FC55E300-6EE3-44A8-987D-52B0E36D327D}" dt="2023-07-23T22:11:21.554" v="131" actId="6549"/>
          <ac:spMkLst>
            <pc:docMk/>
            <pc:sldMk cId="24661109" sldId="262"/>
            <ac:spMk id="2" creationId="{7F3DE7E5-C64D-90E1-D2AA-9FDBFECF3430}"/>
          </ac:spMkLst>
        </pc:spChg>
        <pc:spChg chg="add del mod">
          <ac:chgData name="Craig" userId="d588c584-9c58-4480-93d4-d317c75b1e10" providerId="ADAL" clId="{FC55E300-6EE3-44A8-987D-52B0E36D327D}" dt="2023-07-27T11:01:26.050" v="277"/>
          <ac:spMkLst>
            <pc:docMk/>
            <pc:sldMk cId="24661109" sldId="262"/>
            <ac:spMk id="3" creationId="{FCBD1763-6DA9-69BE-8AF2-C6489E370C71}"/>
          </ac:spMkLst>
        </pc:spChg>
        <pc:spChg chg="add del mod">
          <ac:chgData name="Craig" userId="d588c584-9c58-4480-93d4-d317c75b1e10" providerId="ADAL" clId="{FC55E300-6EE3-44A8-987D-52B0E36D327D}" dt="2023-07-27T11:06:22.883" v="319" actId="478"/>
          <ac:spMkLst>
            <pc:docMk/>
            <pc:sldMk cId="24661109" sldId="262"/>
            <ac:spMk id="4" creationId="{9E407D21-10F9-8E05-C135-9511AC9F2E2F}"/>
          </ac:spMkLst>
        </pc:spChg>
        <pc:spChg chg="add mod">
          <ac:chgData name="Craig" userId="d588c584-9c58-4480-93d4-d317c75b1e10" providerId="ADAL" clId="{FC55E300-6EE3-44A8-987D-52B0E36D327D}" dt="2023-07-27T11:10:27.554" v="351" actId="14100"/>
          <ac:spMkLst>
            <pc:docMk/>
            <pc:sldMk cId="24661109" sldId="262"/>
            <ac:spMk id="6" creationId="{59276241-0475-DA83-1E9D-D4BD7E5A3187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4661109" sldId="262"/>
            <ac:spMk id="9" creationId="{B3482616-1E30-DD0B-711E-7BE1D622F80E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4661109" sldId="262"/>
            <ac:spMk id="25" creationId="{87757A16-76B0-F0C6-AAE7-0A4A3942E16B}"/>
          </ac:spMkLst>
        </pc:spChg>
        <pc:spChg chg="mod">
          <ac:chgData name="Craig" userId="d588c584-9c58-4480-93d4-d317c75b1e10" providerId="ADAL" clId="{FC55E300-6EE3-44A8-987D-52B0E36D327D}" dt="2023-07-11T18:54:30.307" v="77" actId="20577"/>
          <ac:spMkLst>
            <pc:docMk/>
            <pc:sldMk cId="24661109" sldId="262"/>
            <ac:spMk id="36" creationId="{55E59B2F-3C83-CBA6-9148-ECFE1628745C}"/>
          </ac:spMkLst>
        </pc:spChg>
        <pc:spChg chg="mod">
          <ac:chgData name="Craig" userId="d588c584-9c58-4480-93d4-d317c75b1e10" providerId="ADAL" clId="{FC55E300-6EE3-44A8-987D-52B0E36D327D}" dt="2023-07-11T18:54:39.257" v="85" actId="20577"/>
          <ac:spMkLst>
            <pc:docMk/>
            <pc:sldMk cId="24661109" sldId="262"/>
            <ac:spMk id="42" creationId="{D8E92050-47F4-07EB-A645-0988AE7C72B5}"/>
          </ac:spMkLst>
        </pc:spChg>
      </pc:sldChg>
      <pc:sldChg chg="addSp delSp modSp mod">
        <pc:chgData name="Craig" userId="d588c584-9c58-4480-93d4-d317c75b1e10" providerId="ADAL" clId="{FC55E300-6EE3-44A8-987D-52B0E36D327D}" dt="2023-07-27T11:10:35.029" v="352" actId="14100"/>
        <pc:sldMkLst>
          <pc:docMk/>
          <pc:sldMk cId="2593572919" sldId="263"/>
        </pc:sldMkLst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593572919" sldId="263"/>
            <ac:spMk id="3" creationId="{96787977-5C09-B334-FD07-217F85302EF9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593572919" sldId="263"/>
            <ac:spMk id="15" creationId="{2777904C-D069-64CE-4D89-374DE3A91C62}"/>
          </ac:spMkLst>
        </pc:spChg>
        <pc:spChg chg="add mod">
          <ac:chgData name="Craig" userId="d588c584-9c58-4480-93d4-d317c75b1e10" providerId="ADAL" clId="{FC55E300-6EE3-44A8-987D-52B0E36D327D}" dt="2023-07-23T22:11:36.029" v="134" actId="20577"/>
          <ac:spMkLst>
            <pc:docMk/>
            <pc:sldMk cId="2593572919" sldId="263"/>
            <ac:spMk id="19" creationId="{D938C704-C3B8-B0B4-BCF7-ECE9E5EFB9A0}"/>
          </ac:spMkLst>
        </pc:spChg>
        <pc:spChg chg="add del mod">
          <ac:chgData name="Craig" userId="d588c584-9c58-4480-93d4-d317c75b1e10" providerId="ADAL" clId="{FC55E300-6EE3-44A8-987D-52B0E36D327D}" dt="2023-07-27T11:06:33.829" v="322" actId="478"/>
          <ac:spMkLst>
            <pc:docMk/>
            <pc:sldMk cId="2593572919" sldId="263"/>
            <ac:spMk id="20" creationId="{C271DE5D-DC2F-3532-FB7A-A41C35B9900C}"/>
          </ac:spMkLst>
        </pc:spChg>
        <pc:spChg chg="add mod">
          <ac:chgData name="Craig" userId="d588c584-9c58-4480-93d4-d317c75b1e10" providerId="ADAL" clId="{FC55E300-6EE3-44A8-987D-52B0E36D327D}" dt="2023-07-27T11:10:35.029" v="352" actId="14100"/>
          <ac:spMkLst>
            <pc:docMk/>
            <pc:sldMk cId="2593572919" sldId="263"/>
            <ac:spMk id="21" creationId="{CE892DCF-4AFC-C13C-737F-060C88EE96C2}"/>
          </ac:spMkLst>
        </pc:spChg>
      </pc:sldChg>
      <pc:sldChg chg="addSp modSp mod">
        <pc:chgData name="Craig" userId="d588c584-9c58-4480-93d4-d317c75b1e10" providerId="ADAL" clId="{FC55E300-6EE3-44A8-987D-52B0E36D327D}" dt="2023-07-27T11:10:49.679" v="353" actId="14100"/>
        <pc:sldMkLst>
          <pc:docMk/>
          <pc:sldMk cId="47547401" sldId="264"/>
        </pc:sldMkLst>
        <pc:spChg chg="add mod">
          <ac:chgData name="Craig" userId="d588c584-9c58-4480-93d4-d317c75b1e10" providerId="ADAL" clId="{FC55E300-6EE3-44A8-987D-52B0E36D327D}" dt="2023-07-23T22:11:53.659" v="137" actId="20577"/>
          <ac:spMkLst>
            <pc:docMk/>
            <pc:sldMk cId="47547401" sldId="264"/>
            <ac:spMk id="2" creationId="{8F8FCA20-9C57-6350-2A95-508AC379DC38}"/>
          </ac:spMkLst>
        </pc:spChg>
        <pc:spChg chg="add mod">
          <ac:chgData name="Craig" userId="d588c584-9c58-4480-93d4-d317c75b1e10" providerId="ADAL" clId="{FC55E300-6EE3-44A8-987D-52B0E36D327D}" dt="2023-07-27T11:10:49.679" v="353" actId="14100"/>
          <ac:spMkLst>
            <pc:docMk/>
            <pc:sldMk cId="47547401" sldId="264"/>
            <ac:spMk id="3" creationId="{EDEC26F4-70EB-5AFE-393C-3D44A30B1A09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47547401" sldId="264"/>
            <ac:spMk id="54" creationId="{E1462198-F8B8-E8E0-7072-C184A6EF47D6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47547401" sldId="264"/>
            <ac:spMk id="62" creationId="{CE08F786-56FB-A473-9BA4-E6C769F28BFD}"/>
          </ac:spMkLst>
        </pc:spChg>
        <pc:spChg chg="mod">
          <ac:chgData name="Craig" userId="d588c584-9c58-4480-93d4-d317c75b1e10" providerId="ADAL" clId="{FC55E300-6EE3-44A8-987D-52B0E36D327D}" dt="2023-07-11T18:56:52.743" v="93" actId="108"/>
          <ac:spMkLst>
            <pc:docMk/>
            <pc:sldMk cId="47547401" sldId="264"/>
            <ac:spMk id="80" creationId="{906ECDBE-00FD-B0BF-ABB1-B34FEC9E1DF6}"/>
          </ac:spMkLst>
        </pc:spChg>
        <pc:spChg chg="mod">
          <ac:chgData name="Craig" userId="d588c584-9c58-4480-93d4-d317c75b1e10" providerId="ADAL" clId="{FC55E300-6EE3-44A8-987D-52B0E36D327D}" dt="2023-07-11T18:57:24.499" v="96" actId="1076"/>
          <ac:spMkLst>
            <pc:docMk/>
            <pc:sldMk cId="47547401" sldId="264"/>
            <ac:spMk id="81" creationId="{8273BA44-9E36-CA75-DAF3-8B838E7BADB3}"/>
          </ac:spMkLst>
        </pc:spChg>
        <pc:spChg chg="mod">
          <ac:chgData name="Craig" userId="d588c584-9c58-4480-93d4-d317c75b1e10" providerId="ADAL" clId="{FC55E300-6EE3-44A8-987D-52B0E36D327D}" dt="2023-07-11T18:56:33.369" v="87" actId="108"/>
          <ac:spMkLst>
            <pc:docMk/>
            <pc:sldMk cId="47547401" sldId="264"/>
            <ac:spMk id="84" creationId="{5B5D2A3F-43CF-6F73-3991-D9B3D010F694}"/>
          </ac:spMkLst>
        </pc:spChg>
        <pc:cxnChg chg="mod">
          <ac:chgData name="Craig" userId="d588c584-9c58-4480-93d4-d317c75b1e10" providerId="ADAL" clId="{FC55E300-6EE3-44A8-987D-52B0E36D327D}" dt="2023-07-11T18:57:07.390" v="95" actId="1076"/>
          <ac:cxnSpMkLst>
            <pc:docMk/>
            <pc:sldMk cId="47547401" sldId="264"/>
            <ac:cxnSpMk id="77" creationId="{E4C01555-70E7-76CA-5654-118C5765E3A6}"/>
          </ac:cxnSpMkLst>
        </pc:cxnChg>
        <pc:cxnChg chg="mod">
          <ac:chgData name="Craig" userId="d588c584-9c58-4480-93d4-d317c75b1e10" providerId="ADAL" clId="{FC55E300-6EE3-44A8-987D-52B0E36D327D}" dt="2023-07-11T18:57:33.519" v="97" actId="108"/>
          <ac:cxnSpMkLst>
            <pc:docMk/>
            <pc:sldMk cId="47547401" sldId="264"/>
            <ac:cxnSpMk id="79" creationId="{C51D8ABA-3191-BA5F-99F4-E4FE4CDE3C45}"/>
          </ac:cxnSpMkLst>
        </pc:cxnChg>
      </pc:sldChg>
      <pc:sldChg chg="addSp modSp mod">
        <pc:chgData name="Craig" userId="d588c584-9c58-4480-93d4-d317c75b1e10" providerId="ADAL" clId="{FC55E300-6EE3-44A8-987D-52B0E36D327D}" dt="2023-07-27T11:10:56.170" v="354" actId="14100"/>
        <pc:sldMkLst>
          <pc:docMk/>
          <pc:sldMk cId="2211045416" sldId="265"/>
        </pc:sldMkLst>
        <pc:spChg chg="add mod">
          <ac:chgData name="Craig" userId="d588c584-9c58-4480-93d4-d317c75b1e10" providerId="ADAL" clId="{FC55E300-6EE3-44A8-987D-52B0E36D327D}" dt="2023-07-23T22:12:10.914" v="141" actId="20577"/>
          <ac:spMkLst>
            <pc:docMk/>
            <pc:sldMk cId="2211045416" sldId="265"/>
            <ac:spMk id="6" creationId="{D84476BE-79D4-C5CC-DF23-6E2E7D6F374B}"/>
          </ac:spMkLst>
        </pc:spChg>
        <pc:spChg chg="add mod">
          <ac:chgData name="Craig" userId="d588c584-9c58-4480-93d4-d317c75b1e10" providerId="ADAL" clId="{FC55E300-6EE3-44A8-987D-52B0E36D327D}" dt="2023-07-27T11:10:56.170" v="354" actId="14100"/>
          <ac:spMkLst>
            <pc:docMk/>
            <pc:sldMk cId="2211045416" sldId="265"/>
            <ac:spMk id="9" creationId="{4679D688-9062-F84D-F639-850B06E892F2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211045416" sldId="265"/>
            <ac:spMk id="51" creationId="{FDBBACF5-BC07-9EE5-E0A2-4D436561ABC0}"/>
          </ac:spMkLst>
        </pc:spChg>
        <pc:spChg chg="mod">
          <ac:chgData name="Craig" userId="d588c584-9c58-4480-93d4-d317c75b1e10" providerId="ADAL" clId="{FC55E300-6EE3-44A8-987D-52B0E36D327D}" dt="2023-07-23T22:21:31.233" v="142"/>
          <ac:spMkLst>
            <pc:docMk/>
            <pc:sldMk cId="2211045416" sldId="265"/>
            <ac:spMk id="58" creationId="{28FF8D00-24CC-CDF5-9740-E9399052590A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211045416" sldId="265"/>
            <ac:spMk id="67" creationId="{E1B6FA2C-43E9-A014-AA4C-F7E0CA9D6C1D}"/>
          </ac:spMkLst>
        </pc:spChg>
        <pc:spChg chg="mod">
          <ac:chgData name="Craig" userId="d588c584-9c58-4480-93d4-d317c75b1e10" providerId="ADAL" clId="{FC55E300-6EE3-44A8-987D-52B0E36D327D}" dt="2023-07-23T22:21:55.025" v="143"/>
          <ac:spMkLst>
            <pc:docMk/>
            <pc:sldMk cId="2211045416" sldId="265"/>
            <ac:spMk id="89" creationId="{2F584839-C4EF-E08B-0C51-361B76F20187}"/>
          </ac:spMkLst>
        </pc:spChg>
      </pc:sldChg>
    </pc:docChg>
  </pc:docChgLst>
  <pc:docChgLst>
    <pc:chgData name="Sherry Hutchinson" userId="da25e8c2-4cfa-4a6f-b6d6-a8ac2a736b83" providerId="ADAL" clId="{70579AD9-A521-44EB-952E-5873134CDDB9}"/>
    <pc:docChg chg="undo custSel modSld">
      <pc:chgData name="Sherry Hutchinson" userId="da25e8c2-4cfa-4a6f-b6d6-a8ac2a736b83" providerId="ADAL" clId="{70579AD9-A521-44EB-952E-5873134CDDB9}" dt="2023-07-09T21:02:57.216" v="3422" actId="1038"/>
      <pc:docMkLst>
        <pc:docMk/>
      </pc:docMkLst>
      <pc:sldChg chg="addSp delSp modSp mod">
        <pc:chgData name="Sherry Hutchinson" userId="da25e8c2-4cfa-4a6f-b6d6-a8ac2a736b83" providerId="ADAL" clId="{70579AD9-A521-44EB-952E-5873134CDDB9}" dt="2023-07-09T21:02:32.474" v="3297" actId="1038"/>
        <pc:sldMkLst>
          <pc:docMk/>
          <pc:sldMk cId="162657991" sldId="256"/>
        </pc:sldMkLst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5" creationId="{EE2587FD-7786-B36D-8FF9-0C339E1B82B4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6" creationId="{7DC470C7-4FF4-D342-99E8-E8F821044953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2" creationId="{87F66CB6-4E6C-859F-482C-E5DC7F7A965E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6" creationId="{EF87472D-AF95-9A97-3335-2A576870F4F7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9" creationId="{B7EA828D-B9F5-483E-9DAA-9B6D79B3EF02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21" creationId="{69413CA9-10F6-8DF5-AEBB-D60AA7105BDF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22" creationId="{9027035E-C213-D913-76AB-7F8408F8148A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30" creationId="{DDDF19F5-BC9F-4FA9-CCC5-A65B6BD18BA3}"/>
          </ac:spMkLst>
        </pc:spChg>
        <pc:spChg chg="del mod">
          <ac:chgData name="Sherry Hutchinson" userId="da25e8c2-4cfa-4a6f-b6d6-a8ac2a736b83" providerId="ADAL" clId="{70579AD9-A521-44EB-952E-5873134CDDB9}" dt="2023-07-09T18:09:27.779" v="228" actId="478"/>
          <ac:spMkLst>
            <pc:docMk/>
            <pc:sldMk cId="162657991" sldId="256"/>
            <ac:spMk id="32" creationId="{31D60924-238B-728E-A597-FB51D6D406A0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33" creationId="{A5A33F7A-C786-FDB6-7656-DBF69CD64173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44" creationId="{6ED0E8A2-16FD-45A7-2EAD-103F52E1B771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46" creationId="{8EE99552-126D-51A7-89E3-1E4546488C94}"/>
          </ac:spMkLst>
        </pc:spChg>
        <pc:spChg chg="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47" creationId="{047F0D2D-ADE3-DA91-A500-37C654E004E0}"/>
          </ac:spMkLst>
        </pc:spChg>
        <pc:spChg chg="add del mod">
          <ac:chgData name="Sherry Hutchinson" userId="da25e8c2-4cfa-4a6f-b6d6-a8ac2a736b83" providerId="ADAL" clId="{70579AD9-A521-44EB-952E-5873134CDDB9}" dt="2023-07-09T16:36:27.808" v="31"/>
          <ac:spMkLst>
            <pc:docMk/>
            <pc:sldMk cId="162657991" sldId="256"/>
            <ac:spMk id="57" creationId="{A7F390A2-4612-E7CB-DA0A-043817753655}"/>
          </ac:spMkLst>
        </pc:spChg>
        <pc:spChg chg="add del mod">
          <ac:chgData name="Sherry Hutchinson" userId="da25e8c2-4cfa-4a6f-b6d6-a8ac2a736b83" providerId="ADAL" clId="{70579AD9-A521-44EB-952E-5873134CDDB9}" dt="2023-07-09T16:36:27.808" v="31"/>
          <ac:spMkLst>
            <pc:docMk/>
            <pc:sldMk cId="162657991" sldId="256"/>
            <ac:spMk id="58" creationId="{7D60F2B2-7C18-B5C5-2DBC-5C6717D627FB}"/>
          </ac:spMkLst>
        </pc:spChg>
        <pc:spChg chg="add mod topLvl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60" creationId="{76461EB9-9BA8-99AF-2166-C38900E77B5C}"/>
          </ac:spMkLst>
        </pc:spChg>
        <pc:spChg chg="add mod topLvl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61" creationId="{297F514E-D453-73E2-D0FC-914C0C0C95A3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67" creationId="{E33243D1-AC67-7518-5D96-0795AFD6C609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68" creationId="{4971B8F3-A718-D50A-1568-3661E634D3E8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69" creationId="{A898E86F-D68C-56CF-3422-9EE79206327C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72" creationId="{8FCC601F-65BF-D901-4C0B-424018739065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73" creationId="{1BB38C52-C998-7157-345C-B1291D168AC9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76" creationId="{68C08771-A5E5-07A3-5B8A-2CDEE64A9126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77" creationId="{8926E402-B69E-525B-461D-F809EF38C26F}"/>
          </ac:spMkLst>
        </pc:spChg>
        <pc:spChg chg="add del mod">
          <ac:chgData name="Sherry Hutchinson" userId="da25e8c2-4cfa-4a6f-b6d6-a8ac2a736b83" providerId="ADAL" clId="{70579AD9-A521-44EB-952E-5873134CDDB9}" dt="2023-07-09T18:04:48.777" v="170" actId="478"/>
          <ac:spMkLst>
            <pc:docMk/>
            <pc:sldMk cId="162657991" sldId="256"/>
            <ac:spMk id="80" creationId="{09EE73B0-8556-F335-2ADD-A8FE29E1EE6D}"/>
          </ac:spMkLst>
        </pc:spChg>
        <pc:spChg chg="add del mod">
          <ac:chgData name="Sherry Hutchinson" userId="da25e8c2-4cfa-4a6f-b6d6-a8ac2a736b83" providerId="ADAL" clId="{70579AD9-A521-44EB-952E-5873134CDDB9}" dt="2023-07-09T18:04:48.777" v="170" actId="478"/>
          <ac:spMkLst>
            <pc:docMk/>
            <pc:sldMk cId="162657991" sldId="256"/>
            <ac:spMk id="82" creationId="{D46838ED-8B45-6C77-9E37-BCA1CB839F39}"/>
          </ac:spMkLst>
        </pc:spChg>
        <pc:spChg chg="add del mod">
          <ac:chgData name="Sherry Hutchinson" userId="da25e8c2-4cfa-4a6f-b6d6-a8ac2a736b83" providerId="ADAL" clId="{70579AD9-A521-44EB-952E-5873134CDDB9}" dt="2023-07-09T18:05:40.515" v="173" actId="478"/>
          <ac:spMkLst>
            <pc:docMk/>
            <pc:sldMk cId="162657991" sldId="256"/>
            <ac:spMk id="84" creationId="{A7E25854-B56A-88EE-3BD2-7B8A9F115007}"/>
          </ac:spMkLst>
        </pc:spChg>
        <pc:spChg chg="add del mod">
          <ac:chgData name="Sherry Hutchinson" userId="da25e8c2-4cfa-4a6f-b6d6-a8ac2a736b83" providerId="ADAL" clId="{70579AD9-A521-44EB-952E-5873134CDDB9}" dt="2023-07-09T18:05:40.515" v="173" actId="478"/>
          <ac:spMkLst>
            <pc:docMk/>
            <pc:sldMk cId="162657991" sldId="256"/>
            <ac:spMk id="86" creationId="{BC9D9AE6-C615-6AAD-7C7B-9A3B3B18B981}"/>
          </ac:spMkLst>
        </pc:spChg>
        <pc:spChg chg="add del mod">
          <ac:chgData name="Sherry Hutchinson" userId="da25e8c2-4cfa-4a6f-b6d6-a8ac2a736b83" providerId="ADAL" clId="{70579AD9-A521-44EB-952E-5873134CDDB9}" dt="2023-07-09T18:05:40.515" v="173" actId="478"/>
          <ac:spMkLst>
            <pc:docMk/>
            <pc:sldMk cId="162657991" sldId="256"/>
            <ac:spMk id="87" creationId="{3ECCCA03-03FA-FA16-6BD3-27B9C1F53B60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88" creationId="{10767390-8581-E456-5A90-AD8D17F90993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0" creationId="{1406A590-44AD-E918-6BE6-0152A38B79CC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1" creationId="{A7624453-1DAE-1E23-15AB-4A805A818ED4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3" creationId="{89F62301-03A5-7CB7-A123-A2C02BD66BB9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4" creationId="{3EC27052-A1E0-4931-3FD8-D5D808AC6AD5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6" creationId="{E1261378-E78D-EED8-E2A3-D6C2DBBE5BE9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8" creationId="{A5C61E5F-E162-31CD-A2F9-D52348947BA9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99" creationId="{6B9C4F51-F5FE-EFE0-8FEB-71220DB1EFAC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02" creationId="{3FB55661-9761-9918-8116-61D2278DA046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04" creationId="{4F490231-39EE-CD6E-CBE1-9C1F737280D2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05" creationId="{27032A28-16A9-FFB3-32D8-AEB5352EC85D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07" creationId="{600551F5-4F2D-DCD3-10F7-551225FF76C7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08" creationId="{C50D1F85-D397-655C-FEB6-3744CB30CD9B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15" creationId="{4B5DF145-B305-593C-1949-DC2D22D84D14}"/>
          </ac:spMkLst>
        </pc:spChg>
        <pc:spChg chg="add mod">
          <ac:chgData name="Sherry Hutchinson" userId="da25e8c2-4cfa-4a6f-b6d6-a8ac2a736b83" providerId="ADAL" clId="{70579AD9-A521-44EB-952E-5873134CDDB9}" dt="2023-07-09T21:02:32.474" v="3297" actId="1038"/>
          <ac:spMkLst>
            <pc:docMk/>
            <pc:sldMk cId="162657991" sldId="256"/>
            <ac:spMk id="116" creationId="{E1FA297E-173F-CE5D-BB85-DFEB798EE05B}"/>
          </ac:spMkLst>
        </pc:spChg>
        <pc:grpChg chg="add del mod">
          <ac:chgData name="Sherry Hutchinson" userId="da25e8c2-4cfa-4a6f-b6d6-a8ac2a736b83" providerId="ADAL" clId="{70579AD9-A521-44EB-952E-5873134CDDB9}" dt="2023-07-09T16:45:04.055" v="129" actId="165"/>
          <ac:grpSpMkLst>
            <pc:docMk/>
            <pc:sldMk cId="162657991" sldId="256"/>
            <ac:grpSpMk id="62" creationId="{9BCA40D2-F3A7-9EE3-6964-3F24548E5E0B}"/>
          </ac:grpSpMkLst>
        </pc:grpChg>
        <pc:cxnChg chg="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9" creationId="{EA32A644-ADF7-B3AD-56F1-67002BDA0FAA}"/>
          </ac:cxnSpMkLst>
        </pc:cxnChg>
        <pc:cxnChg chg="del mod">
          <ac:chgData name="Sherry Hutchinson" userId="da25e8c2-4cfa-4a6f-b6d6-a8ac2a736b83" providerId="ADAL" clId="{70579AD9-A521-44EB-952E-5873134CDDB9}" dt="2023-07-09T16:41:04.206" v="107" actId="478"/>
          <ac:cxnSpMkLst>
            <pc:docMk/>
            <pc:sldMk cId="162657991" sldId="256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23" creationId="{B19D7140-13B2-90C7-E1AD-911648344B69}"/>
          </ac:cxnSpMkLst>
        </pc:cxnChg>
        <pc:cxnChg chg="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25" creationId="{A327A96A-39C5-C698-FC91-0BCEBBCFF434}"/>
          </ac:cxnSpMkLst>
        </pc:cxnChg>
        <pc:cxnChg chg="del mod">
          <ac:chgData name="Sherry Hutchinson" userId="da25e8c2-4cfa-4a6f-b6d6-a8ac2a736b83" providerId="ADAL" clId="{70579AD9-A521-44EB-952E-5873134CDDB9}" dt="2023-07-09T18:09:31.617" v="229" actId="478"/>
          <ac:cxnSpMkLst>
            <pc:docMk/>
            <pc:sldMk cId="162657991" sldId="256"/>
            <ac:cxnSpMk id="31" creationId="{54E0BBCF-8123-24C5-50CE-28B0484A1C5C}"/>
          </ac:cxnSpMkLst>
        </pc:cxnChg>
        <pc:cxnChg chg="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34" creationId="{2BFC792D-7D34-7B08-A7BE-FE329113102D}"/>
          </ac:cxnSpMkLst>
        </pc:cxnChg>
        <pc:cxnChg chg="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45" creationId="{3CDF5CD2-8E8B-01D8-90D5-89720B458DDB}"/>
          </ac:cxnSpMkLst>
        </pc:cxnChg>
        <pc:cxnChg chg="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48" creationId="{8120B1FA-B943-29D0-D7B0-FCEB82E5EC66}"/>
          </ac:cxnSpMkLst>
        </pc:cxnChg>
        <pc:cxnChg chg="add mod topLvl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59" creationId="{7E758357-C91C-04BB-11B5-C3B2C01C7D3A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66" creationId="{0326F598-8F1E-33D0-5674-73A3AF5645A3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70" creationId="{6B138DF7-4FE3-8249-A456-305D07B340AE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71" creationId="{3AB0734C-9192-8C96-414A-4DABD659CBB3}"/>
          </ac:cxnSpMkLst>
        </pc:cxnChg>
        <pc:cxnChg chg="add del mod">
          <ac:chgData name="Sherry Hutchinson" userId="da25e8c2-4cfa-4a6f-b6d6-a8ac2a736b83" providerId="ADAL" clId="{70579AD9-A521-44EB-952E-5873134CDDB9}" dt="2023-07-09T18:04:21.656" v="167" actId="478"/>
          <ac:cxnSpMkLst>
            <pc:docMk/>
            <pc:sldMk cId="162657991" sldId="256"/>
            <ac:cxnSpMk id="74" creationId="{EAEC5602-F1C8-BE11-904A-263A290D8FE2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75" creationId="{1B5FC1DB-D4AA-DB72-C3DB-DC61CA0B9DBD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78" creationId="{591E8E5C-AED2-928D-7FC3-DBF7007875D5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79" creationId="{42A19B8C-B45F-1112-2B7F-3B806646557F}"/>
          </ac:cxnSpMkLst>
        </pc:cxnChg>
        <pc:cxnChg chg="add del mod">
          <ac:chgData name="Sherry Hutchinson" userId="da25e8c2-4cfa-4a6f-b6d6-a8ac2a736b83" providerId="ADAL" clId="{70579AD9-A521-44EB-952E-5873134CDDB9}" dt="2023-07-09T18:04:48.777" v="170" actId="478"/>
          <ac:cxnSpMkLst>
            <pc:docMk/>
            <pc:sldMk cId="162657991" sldId="256"/>
            <ac:cxnSpMk id="81" creationId="{C88C7F26-26D5-C1AC-ECB2-FE5882419B99}"/>
          </ac:cxnSpMkLst>
        </pc:cxnChg>
        <pc:cxnChg chg="add del mod">
          <ac:chgData name="Sherry Hutchinson" userId="da25e8c2-4cfa-4a6f-b6d6-a8ac2a736b83" providerId="ADAL" clId="{70579AD9-A521-44EB-952E-5873134CDDB9}" dt="2023-07-09T18:04:48.777" v="170" actId="478"/>
          <ac:cxnSpMkLst>
            <pc:docMk/>
            <pc:sldMk cId="162657991" sldId="256"/>
            <ac:cxnSpMk id="83" creationId="{1C8B891E-8353-9ADF-7B99-F7C0E0B0C826}"/>
          </ac:cxnSpMkLst>
        </pc:cxnChg>
        <pc:cxnChg chg="add del mod">
          <ac:chgData name="Sherry Hutchinson" userId="da25e8c2-4cfa-4a6f-b6d6-a8ac2a736b83" providerId="ADAL" clId="{70579AD9-A521-44EB-952E-5873134CDDB9}" dt="2023-07-09T18:05:40.515" v="173" actId="478"/>
          <ac:cxnSpMkLst>
            <pc:docMk/>
            <pc:sldMk cId="162657991" sldId="256"/>
            <ac:cxnSpMk id="85" creationId="{E7E2F675-5278-F4F6-39E6-51E2FA47552C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89" creationId="{21E49DC0-38DF-6EAC-4F15-776BF40DB74F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92" creationId="{2706E56B-F711-87BA-0FD3-92850B04BB8E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97" creationId="{E43B11A1-0F61-2609-3B72-376A5CDA72B4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100" creationId="{9F0B65DC-F3A9-C7B7-96F1-70E1A2FD7376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101" creationId="{161473F3-0633-FF0A-AFAB-F576C7579E2A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103" creationId="{9CB7931E-002C-A244-29F9-A70B91302C08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106" creationId="{1B759161-3107-FB19-B061-C71788ABE582}"/>
          </ac:cxnSpMkLst>
        </pc:cxnChg>
        <pc:cxnChg chg="add mod">
          <ac:chgData name="Sherry Hutchinson" userId="da25e8c2-4cfa-4a6f-b6d6-a8ac2a736b83" providerId="ADAL" clId="{70579AD9-A521-44EB-952E-5873134CDDB9}" dt="2023-07-09T21:02:32.474" v="3297" actId="1038"/>
          <ac:cxnSpMkLst>
            <pc:docMk/>
            <pc:sldMk cId="162657991" sldId="256"/>
            <ac:cxnSpMk id="114" creationId="{E38A8045-A98F-7A83-6396-FC1CF350A1CD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2:41.707" v="3338" actId="1037"/>
        <pc:sldMkLst>
          <pc:docMk/>
          <pc:sldMk cId="1285761949" sldId="257"/>
        </pc:sldMkLst>
        <pc:spChg chg="add del mod">
          <ac:chgData name="Sherry Hutchinson" userId="da25e8c2-4cfa-4a6f-b6d6-a8ac2a736b83" providerId="ADAL" clId="{70579AD9-A521-44EB-952E-5873134CDDB9}" dt="2023-07-09T18:36:07.585" v="771" actId="478"/>
          <ac:spMkLst>
            <pc:docMk/>
            <pc:sldMk cId="1285761949" sldId="257"/>
            <ac:spMk id="4" creationId="{B62B6A60-32A0-A2A4-7367-1C7B99D6C692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5" creationId="{EE2587FD-7786-B36D-8FF9-0C339E1B82B4}"/>
          </ac:spMkLst>
        </pc:spChg>
        <pc:spChg chg="add del mod">
          <ac:chgData name="Sherry Hutchinson" userId="da25e8c2-4cfa-4a6f-b6d6-a8ac2a736b83" providerId="ADAL" clId="{70579AD9-A521-44EB-952E-5873134CDDB9}" dt="2023-07-09T18:36:07.585" v="771" actId="478"/>
          <ac:spMkLst>
            <pc:docMk/>
            <pc:sldMk cId="1285761949" sldId="257"/>
            <ac:spMk id="7" creationId="{50BEEDD6-67CC-48ED-889C-C5DAFF1A0176}"/>
          </ac:spMkLst>
        </pc:spChg>
        <pc:spChg chg="add del mod">
          <ac:chgData name="Sherry Hutchinson" userId="da25e8c2-4cfa-4a6f-b6d6-a8ac2a736b83" providerId="ADAL" clId="{70579AD9-A521-44EB-952E-5873134CDDB9}" dt="2023-07-09T18:36:07.585" v="771" actId="478"/>
          <ac:spMkLst>
            <pc:docMk/>
            <pc:sldMk cId="1285761949" sldId="257"/>
            <ac:spMk id="8" creationId="{7C3C2860-287A-82BE-2199-4BB7926F2034}"/>
          </ac:spMkLst>
        </pc:spChg>
        <pc:spChg chg="add del mod">
          <ac:chgData name="Sherry Hutchinson" userId="da25e8c2-4cfa-4a6f-b6d6-a8ac2a736b83" providerId="ADAL" clId="{70579AD9-A521-44EB-952E-5873134CDDB9}" dt="2023-07-09T18:36:07.585" v="771" actId="478"/>
          <ac:spMkLst>
            <pc:docMk/>
            <pc:sldMk cId="1285761949" sldId="257"/>
            <ac:spMk id="10" creationId="{F9A0BC24-61AD-7066-35E5-A78D46E259B7}"/>
          </ac:spMkLst>
        </pc:spChg>
        <pc:spChg chg="add del mod">
          <ac:chgData name="Sherry Hutchinson" userId="da25e8c2-4cfa-4a6f-b6d6-a8ac2a736b83" providerId="ADAL" clId="{70579AD9-A521-44EB-952E-5873134CDDB9}" dt="2023-07-09T18:36:07.585" v="771" actId="478"/>
          <ac:spMkLst>
            <pc:docMk/>
            <pc:sldMk cId="1285761949" sldId="257"/>
            <ac:spMk id="11" creationId="{771DD3A2-1206-1D20-3C20-B56A94EB2FF4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15" creationId="{D786C330-03DA-AB84-AB2D-E86E6AA9E1B6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16" creationId="{7D9D274C-8333-02FC-52D8-43FDE55014DA}"/>
          </ac:spMkLst>
        </pc:spChg>
        <pc:spChg chg="add del mod">
          <ac:chgData name="Sherry Hutchinson" userId="da25e8c2-4cfa-4a6f-b6d6-a8ac2a736b83" providerId="ADAL" clId="{70579AD9-A521-44EB-952E-5873134CDDB9}" dt="2023-07-09T18:33:26.322" v="686" actId="478"/>
          <ac:spMkLst>
            <pc:docMk/>
            <pc:sldMk cId="1285761949" sldId="257"/>
            <ac:spMk id="17" creationId="{A0F89E10-62CE-CBDF-C85C-D2CE65BFE729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19" creationId="{B7EA828D-B9F5-483E-9DAA-9B6D79B3EF02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21" creationId="{69413CA9-10F6-8DF5-AEBB-D60AA7105BDF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22" creationId="{9027035E-C213-D913-76AB-7F8408F8148A}"/>
          </ac:spMkLst>
        </pc:spChg>
        <pc:spChg chg="add del mod">
          <ac:chgData name="Sherry Hutchinson" userId="da25e8c2-4cfa-4a6f-b6d6-a8ac2a736b83" providerId="ADAL" clId="{70579AD9-A521-44EB-952E-5873134CDDB9}" dt="2023-07-09T18:33:26.322" v="686" actId="478"/>
          <ac:spMkLst>
            <pc:docMk/>
            <pc:sldMk cId="1285761949" sldId="257"/>
            <ac:spMk id="24" creationId="{CCE4D023-63DE-4046-D976-681B3458A4A0}"/>
          </ac:spMkLst>
        </pc:spChg>
        <pc:spChg chg="add del mod">
          <ac:chgData name="Sherry Hutchinson" userId="da25e8c2-4cfa-4a6f-b6d6-a8ac2a736b83" providerId="ADAL" clId="{70579AD9-A521-44EB-952E-5873134CDDB9}" dt="2023-07-09T18:33:26.322" v="686" actId="478"/>
          <ac:spMkLst>
            <pc:docMk/>
            <pc:sldMk cId="1285761949" sldId="257"/>
            <ac:spMk id="25" creationId="{3913CF2D-78DA-ED96-2CAD-D7E6BFD7B033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27" creationId="{10865811-1DE5-99AE-C42C-C8EE7AE5DAA8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28" creationId="{2BD1F758-C7CA-9AB2-2F70-3DFDC9151FEF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30" creationId="{DDDF19F5-BC9F-4FA9-CCC5-A65B6BD18BA3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32" creationId="{31D60924-238B-728E-A597-FB51D6D406A0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33" creationId="{A5A33F7A-C786-FDB6-7656-DBF69CD64173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36" creationId="{4C60FBCA-B5E0-7F6D-9954-27DD00627730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38" creationId="{64D16628-2F00-C4AB-9CAC-3A19976CD5A1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39" creationId="{71F2A0BF-D2A7-964B-10CB-CC8E6BAEF39F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41" creationId="{CE60A70B-E562-66BC-B1CB-31038E02CF2F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42" creationId="{3DA24045-FB0A-5F9B-1788-29D1BD990B8F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44" creationId="{6ED0E8A2-16FD-45A7-2EAD-103F52E1B771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46" creationId="{8EE99552-126D-51A7-89E3-1E4546488C94}"/>
          </ac:spMkLst>
        </pc:spChg>
        <pc:spChg chg="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47" creationId="{047F0D2D-ADE3-DA91-A500-37C654E004E0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49" creationId="{EA22AB20-077A-2D66-9D26-1625BB037606}"/>
          </ac:spMkLst>
        </pc:spChg>
        <pc:spChg chg="add mod">
          <ac:chgData name="Sherry Hutchinson" userId="da25e8c2-4cfa-4a6f-b6d6-a8ac2a736b83" providerId="ADAL" clId="{70579AD9-A521-44EB-952E-5873134CDDB9}" dt="2023-07-09T21:02:41.707" v="3338" actId="1037"/>
          <ac:spMkLst>
            <pc:docMk/>
            <pc:sldMk cId="1285761949" sldId="257"/>
            <ac:spMk id="50" creationId="{9C267704-220A-39DE-1551-0CCBAC5F7AF0}"/>
          </ac:spMkLst>
        </pc:spChg>
        <pc:cxnChg chg="add del mod">
          <ac:chgData name="Sherry Hutchinson" userId="da25e8c2-4cfa-4a6f-b6d6-a8ac2a736b83" providerId="ADAL" clId="{70579AD9-A521-44EB-952E-5873134CDDB9}" dt="2023-07-09T18:36:07.585" v="771" actId="478"/>
          <ac:cxnSpMkLst>
            <pc:docMk/>
            <pc:sldMk cId="1285761949" sldId="257"/>
            <ac:cxnSpMk id="3" creationId="{4A9102E7-8DA0-E13C-BECC-B6949A41CC6C}"/>
          </ac:cxnSpMkLst>
        </pc:cxnChg>
        <pc:cxnChg chg="add del mod">
          <ac:chgData name="Sherry Hutchinson" userId="da25e8c2-4cfa-4a6f-b6d6-a8ac2a736b83" providerId="ADAL" clId="{70579AD9-A521-44EB-952E-5873134CDDB9}" dt="2023-07-09T18:36:07.585" v="771" actId="478"/>
          <ac:cxnSpMkLst>
            <pc:docMk/>
            <pc:sldMk cId="1285761949" sldId="257"/>
            <ac:cxnSpMk id="6" creationId="{D28FC4EA-0F73-B98B-4615-3E98247DF906}"/>
          </ac:cxnSpMkLst>
        </pc:cxnChg>
        <pc:cxnChg chg="add del mod">
          <ac:chgData name="Sherry Hutchinson" userId="da25e8c2-4cfa-4a6f-b6d6-a8ac2a736b83" providerId="ADAL" clId="{70579AD9-A521-44EB-952E-5873134CDDB9}" dt="2023-07-09T18:36:07.585" v="771" actId="478"/>
          <ac:cxnSpMkLst>
            <pc:docMk/>
            <pc:sldMk cId="1285761949" sldId="257"/>
            <ac:cxnSpMk id="9" creationId="{EEC6531C-14FF-EC7A-056F-CDDA31D081C4}"/>
          </ac:cxnSpMkLst>
        </pc:cxnChg>
        <pc:cxnChg chg="add 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14" creationId="{0869F11D-4739-AD9F-F5C7-92100A727AF3}"/>
          </ac:cxnSpMkLst>
        </pc:cxnChg>
        <pc:cxnChg chg="add del mod">
          <ac:chgData name="Sherry Hutchinson" userId="da25e8c2-4cfa-4a6f-b6d6-a8ac2a736b83" providerId="ADAL" clId="{70579AD9-A521-44EB-952E-5873134CDDB9}" dt="2023-07-09T18:33:26.322" v="686" actId="478"/>
          <ac:cxnSpMkLst>
            <pc:docMk/>
            <pc:sldMk cId="1285761949" sldId="257"/>
            <ac:cxnSpMk id="18" creationId="{FAFB56B5-5B12-8AA4-2A32-DB42B050E78A}"/>
          </ac:cxnSpMkLst>
        </pc:cxnChg>
        <pc:cxnChg chg="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23" creationId="{B19D7140-13B2-90C7-E1AD-911648344B69}"/>
          </ac:cxnSpMkLst>
        </pc:cxnChg>
        <pc:cxnChg chg="add del mod">
          <ac:chgData name="Sherry Hutchinson" userId="da25e8c2-4cfa-4a6f-b6d6-a8ac2a736b83" providerId="ADAL" clId="{70579AD9-A521-44EB-952E-5873134CDDB9}" dt="2023-07-09T18:33:39.838" v="687" actId="478"/>
          <ac:cxnSpMkLst>
            <pc:docMk/>
            <pc:sldMk cId="1285761949" sldId="257"/>
            <ac:cxnSpMk id="26" creationId="{A08DA43B-FE75-061E-D047-2BA68FA17EA5}"/>
          </ac:cxnSpMkLst>
        </pc:cxnChg>
        <pc:cxnChg chg="add 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29" creationId="{81DB0A19-4084-4715-43A0-32706C0EB71F}"/>
          </ac:cxnSpMkLst>
        </pc:cxnChg>
        <pc:cxnChg chg="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31" creationId="{54E0BBCF-8123-24C5-50CE-28B0484A1C5C}"/>
          </ac:cxnSpMkLst>
        </pc:cxnChg>
        <pc:cxnChg chg="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34" creationId="{2BFC792D-7D34-7B08-A7BE-FE329113102D}"/>
          </ac:cxnSpMkLst>
        </pc:cxnChg>
        <pc:cxnChg chg="add 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35" creationId="{206AE71C-03F3-B374-2F64-45956A6C0F07}"/>
          </ac:cxnSpMkLst>
        </pc:cxnChg>
        <pc:cxnChg chg="add 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37" creationId="{6EB9D6B4-BBD6-4AFA-EF4B-F8F1B7F800A4}"/>
          </ac:cxnSpMkLst>
        </pc:cxnChg>
        <pc:cxnChg chg="add 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40" creationId="{2DF87118-2CBE-BB12-99A5-815C25ABD500}"/>
          </ac:cxnSpMkLst>
        </pc:cxnChg>
        <pc:cxnChg chg="add 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43" creationId="{37E8ECAF-A08E-194D-F055-0AF3185EC2AF}"/>
          </ac:cxnSpMkLst>
        </pc:cxnChg>
        <pc:cxnChg chg="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45" creationId="{3CDF5CD2-8E8B-01D8-90D5-89720B458DDB}"/>
          </ac:cxnSpMkLst>
        </pc:cxnChg>
        <pc:cxnChg chg="mod">
          <ac:chgData name="Sherry Hutchinson" userId="da25e8c2-4cfa-4a6f-b6d6-a8ac2a736b83" providerId="ADAL" clId="{70579AD9-A521-44EB-952E-5873134CDDB9}" dt="2023-07-09T21:02:41.707" v="3338" actId="1037"/>
          <ac:cxnSpMkLst>
            <pc:docMk/>
            <pc:sldMk cId="1285761949" sldId="257"/>
            <ac:cxnSpMk id="48" creationId="{8120B1FA-B943-29D0-D7B0-FCEB82E5EC66}"/>
          </ac:cxnSpMkLst>
        </pc:cxnChg>
      </pc:sldChg>
      <pc:sldChg chg="addSp modSp mod">
        <pc:chgData name="Sherry Hutchinson" userId="da25e8c2-4cfa-4a6f-b6d6-a8ac2a736b83" providerId="ADAL" clId="{70579AD9-A521-44EB-952E-5873134CDDB9}" dt="2023-07-09T21:02:49.930" v="3381" actId="1038"/>
        <pc:sldMkLst>
          <pc:docMk/>
          <pc:sldMk cId="985054504" sldId="258"/>
        </pc:sldMkLst>
        <pc:spChg chg="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5" creationId="{EE2587FD-7786-B36D-8FF9-0C339E1B82B4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6" creationId="{A1411C30-60E2-5BDC-C832-88A602371D59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7" creationId="{E7EE99E2-03BC-6272-9B8D-DF1DDFD31447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0" creationId="{3AE2E5CE-9F01-897F-3493-23DD133E470A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2" creationId="{125B8F95-D845-A001-856B-8018FEAAB3CF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3" creationId="{075F78B4-5C22-4837-5FDC-4E18C6314A2A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5" creationId="{1CCF0785-FAE9-ADA6-044A-879DD7681DDC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6" creationId="{AD5E27F9-120B-68FF-0AA4-D4DC36293D6B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8" creationId="{BD003571-515F-8944-EF01-B641B9A0229B}"/>
          </ac:spMkLst>
        </pc:spChg>
        <pc:spChg chg="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19" creationId="{B7EA828D-B9F5-483E-9DAA-9B6D79B3EF02}"/>
          </ac:spMkLst>
        </pc:spChg>
        <pc:spChg chg="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21" creationId="{69413CA9-10F6-8DF5-AEBB-D60AA7105BDF}"/>
          </ac:spMkLst>
        </pc:spChg>
        <pc:spChg chg="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22" creationId="{9027035E-C213-D913-76AB-7F8408F8148A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25" creationId="{88B2E8F3-5BCA-089B-D76B-451BA41D3F14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26" creationId="{CE2EB2AE-22B6-9077-547C-5482D780080E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28" creationId="{7379706C-28C8-2715-1F28-C29D6EBB591D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29" creationId="{ECCC83E6-AE73-4EF7-DEDB-2C7C3BFDABCD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31" creationId="{385A5995-AF15-105D-21FE-7F17C73894D9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33" creationId="{D56B44D7-330B-8299-D884-4C5982E68646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34" creationId="{AC92470A-D1C0-1498-D169-328B8CD451EF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36" creationId="{1BB779F6-1634-E24B-10CF-C0269C95017F}"/>
          </ac:spMkLst>
        </pc:spChg>
        <pc:spChg chg="add mod">
          <ac:chgData name="Sherry Hutchinson" userId="da25e8c2-4cfa-4a6f-b6d6-a8ac2a736b83" providerId="ADAL" clId="{70579AD9-A521-44EB-952E-5873134CDDB9}" dt="2023-07-09T21:02:49.930" v="3381" actId="1038"/>
          <ac:spMkLst>
            <pc:docMk/>
            <pc:sldMk cId="985054504" sldId="258"/>
            <ac:spMk id="37" creationId="{A615924E-FEFC-B662-67DE-F74F35B04E8E}"/>
          </ac:spMkLst>
        </pc:sp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8" creationId="{472007E8-6CF0-3E24-ADD6-09F2C66CF2B4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9" creationId="{B16410FC-1EAC-E460-8C3D-CB1FC30E04B0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11" creationId="{43F21E04-1307-EDF6-4110-FB9D3F7BEF52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14" creationId="{358005D6-664D-3C0D-EE5F-67388F02898C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17" creationId="{9075786F-A472-A64B-2EBF-D897D5877610}"/>
          </ac:cxnSpMkLst>
        </pc:cxnChg>
        <pc:cxnChg chg="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23" creationId="{B19D7140-13B2-90C7-E1AD-911648344B69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24" creationId="{288A2880-228B-56DD-528E-15B585334263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27" creationId="{2865E122-FA4A-D9BE-BAE0-89D064104383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30" creationId="{52344827-1609-BABB-5FDC-E4389A8ED1C0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32" creationId="{8A435A16-1297-B541-A909-9A2DB3BACC2B}"/>
          </ac:cxnSpMkLst>
        </pc:cxnChg>
        <pc:cxnChg chg="add mod">
          <ac:chgData name="Sherry Hutchinson" userId="da25e8c2-4cfa-4a6f-b6d6-a8ac2a736b83" providerId="ADAL" clId="{70579AD9-A521-44EB-952E-5873134CDDB9}" dt="2023-07-09T21:02:49.930" v="3381" actId="1038"/>
          <ac:cxnSpMkLst>
            <pc:docMk/>
            <pc:sldMk cId="985054504" sldId="258"/>
            <ac:cxnSpMk id="35" creationId="{3A8AED67-8434-0071-8050-F58B1A101807}"/>
          </ac:cxnSpMkLst>
        </pc:cxnChg>
      </pc:sldChg>
      <pc:sldChg chg="addSp modSp mod">
        <pc:chgData name="Sherry Hutchinson" userId="da25e8c2-4cfa-4a6f-b6d6-a8ac2a736b83" providerId="ADAL" clId="{70579AD9-A521-44EB-952E-5873134CDDB9}" dt="2023-07-09T21:02:57.216" v="3422" actId="1038"/>
        <pc:sldMkLst>
          <pc:docMk/>
          <pc:sldMk cId="2536820367" sldId="259"/>
        </pc:sldMkLst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5" creationId="{EE2587FD-7786-B36D-8FF9-0C339E1B82B4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6" creationId="{7DC470C7-4FF4-D342-99E8-E8F821044953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12" creationId="{87F66CB6-4E6C-859F-482C-E5DC7F7A965E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16" creationId="{EF87472D-AF95-9A97-3335-2A576870F4F7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18" creationId="{8F4EC9D0-9E23-18A9-FB1F-D40F8119600C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19" creationId="{B7EA828D-B9F5-483E-9DAA-9B6D79B3EF02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21" creationId="{69413CA9-10F6-8DF5-AEBB-D60AA7105BDF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22" creationId="{9027035E-C213-D913-76AB-7F8408F8148A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24" creationId="{0B771CF8-8AFB-D704-C83F-F6FAD08EBBF2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29" creationId="{5ECFE6E3-CBC6-10F7-D54C-3CA3E0D123A8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30" creationId="{DDDF19F5-BC9F-4FA9-CCC5-A65B6BD18BA3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32" creationId="{31D60924-238B-728E-A597-FB51D6D406A0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33" creationId="{A5A33F7A-C786-FDB6-7656-DBF69CD64173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35" creationId="{F613E8A1-AE98-97E9-9C33-D1A71E681341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37" creationId="{D2F78C71-E1C4-022D-420D-0D14BAB0096D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38" creationId="{C24EBE17-2960-DCA3-5B50-216DA8CC84B7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40" creationId="{45851F7E-F8AB-1B23-B665-0C0E41B27987}"/>
          </ac:spMkLst>
        </pc:spChg>
        <pc:spChg chg="add 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41" creationId="{E3DEC511-9FD5-45DD-E65C-0BC34732714D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44" creationId="{6ED0E8A2-16FD-45A7-2EAD-103F52E1B771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46" creationId="{8EE99552-126D-51A7-89E3-1E4546488C94}"/>
          </ac:spMkLst>
        </pc:spChg>
        <pc:spChg chg="mod">
          <ac:chgData name="Sherry Hutchinson" userId="da25e8c2-4cfa-4a6f-b6d6-a8ac2a736b83" providerId="ADAL" clId="{70579AD9-A521-44EB-952E-5873134CDDB9}" dt="2023-07-09T21:02:57.216" v="3422" actId="1038"/>
          <ac:spMkLst>
            <pc:docMk/>
            <pc:sldMk cId="2536820367" sldId="259"/>
            <ac:spMk id="47" creationId="{047F0D2D-ADE3-DA91-A500-37C654E004E0}"/>
          </ac:spMkLst>
        </pc:sp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9" creationId="{EA32A644-ADF7-B3AD-56F1-67002BDA0FAA}"/>
          </ac:cxnSpMkLst>
        </pc:cxnChg>
        <pc:cxnChg chg="add 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17" creationId="{A5317E44-7AE0-8490-2D73-24AAB02EE670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23" creationId="{B19D7140-13B2-90C7-E1AD-911648344B69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25" creationId="{A327A96A-39C5-C698-FC91-0BCEBBCFF434}"/>
          </ac:cxnSpMkLst>
        </pc:cxnChg>
        <pc:cxnChg chg="add 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28" creationId="{C4065078-9BC4-ACFE-5EB1-7C43181F3759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31" creationId="{54E0BBCF-8123-24C5-50CE-28B0484A1C5C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34" creationId="{2BFC792D-7D34-7B08-A7BE-FE329113102D}"/>
          </ac:cxnSpMkLst>
        </pc:cxnChg>
        <pc:cxnChg chg="add 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36" creationId="{F4241FD3-CF8C-D302-1135-A7835E2A0753}"/>
          </ac:cxnSpMkLst>
        </pc:cxnChg>
        <pc:cxnChg chg="add 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39" creationId="{F0FBD3CA-BBEE-B44F-FA53-11F08A6ECD7E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45" creationId="{3CDF5CD2-8E8B-01D8-90D5-89720B458DDB}"/>
          </ac:cxnSpMkLst>
        </pc:cxnChg>
        <pc:cxnChg chg="mod">
          <ac:chgData name="Sherry Hutchinson" userId="da25e8c2-4cfa-4a6f-b6d6-a8ac2a736b83" providerId="ADAL" clId="{70579AD9-A521-44EB-952E-5873134CDDB9}" dt="2023-07-09T21:02:57.216" v="3422" actId="1038"/>
          <ac:cxnSpMkLst>
            <pc:docMk/>
            <pc:sldMk cId="2536820367" sldId="259"/>
            <ac:cxnSpMk id="48" creationId="{8120B1FA-B943-29D0-D7B0-FCEB82E5EC66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2:21.248" v="3278" actId="1038"/>
        <pc:sldMkLst>
          <pc:docMk/>
          <pc:sldMk cId="1001350528" sldId="260"/>
        </pc:sldMkLst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5" creationId="{EE2587FD-7786-B36D-8FF9-0C339E1B82B4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6" creationId="{7DC470C7-4FF4-D342-99E8-E8F821044953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12" creationId="{87F66CB6-4E6C-859F-482C-E5DC7F7A965E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16" creationId="{EF87472D-AF95-9A97-3335-2A576870F4F7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19" creationId="{B7EA828D-B9F5-483E-9DAA-9B6D79B3EF02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21" creationId="{69413CA9-10F6-8DF5-AEBB-D60AA7105BDF}"/>
          </ac:spMkLst>
        </pc:spChg>
        <pc:spChg chg="mod or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22" creationId="{9027035E-C213-D913-76AB-7F8408F8148A}"/>
          </ac:spMkLst>
        </pc:spChg>
        <pc:spChg chg="add 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26" creationId="{6DB4E0D4-B156-9889-F2C1-CFEEC4C63BE0}"/>
          </ac:spMkLst>
        </pc:spChg>
        <pc:spChg chg="add 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27" creationId="{FB22B6D4-CCB3-579A-C094-E6B0BE114EF3}"/>
          </ac:spMkLst>
        </pc:spChg>
        <pc:spChg chg="add del mod">
          <ac:chgData name="Sherry Hutchinson" userId="da25e8c2-4cfa-4a6f-b6d6-a8ac2a736b83" providerId="ADAL" clId="{70579AD9-A521-44EB-952E-5873134CDDB9}" dt="2023-07-09T19:06:52.874" v="1444"/>
          <ac:spMkLst>
            <pc:docMk/>
            <pc:sldMk cId="1001350528" sldId="260"/>
            <ac:spMk id="29" creationId="{E753183A-2DF3-40AA-C14A-D3F1201E0022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32" creationId="{31D60924-238B-728E-A597-FB51D6D406A0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33" creationId="{A5A33F7A-C786-FDB6-7656-DBF69CD64173}"/>
          </ac:spMkLst>
        </pc:spChg>
        <pc:spChg chg="add 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34" creationId="{9153D536-BCF8-7D4F-D6B9-B15516B48858}"/>
          </ac:spMkLst>
        </pc:spChg>
        <pc:spChg chg="add 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35" creationId="{399F9E72-2B3F-3F4A-BAA8-E8CB1385D0FC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44" creationId="{6ED0E8A2-16FD-45A7-2EAD-103F52E1B771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46" creationId="{8EE99552-126D-51A7-89E3-1E4546488C94}"/>
          </ac:spMkLst>
        </pc:spChg>
        <pc:spChg chg="mod">
          <ac:chgData name="Sherry Hutchinson" userId="da25e8c2-4cfa-4a6f-b6d6-a8ac2a736b83" providerId="ADAL" clId="{70579AD9-A521-44EB-952E-5873134CDDB9}" dt="2023-07-09T21:02:21.248" v="3278" actId="1038"/>
          <ac:spMkLst>
            <pc:docMk/>
            <pc:sldMk cId="1001350528" sldId="260"/>
            <ac:spMk id="47" creationId="{047F0D2D-ADE3-DA91-A500-37C654E004E0}"/>
          </ac:spMkLst>
        </pc:sp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9" creationId="{EA32A644-ADF7-B3AD-56F1-67002BDA0FAA}"/>
          </ac:cxnSpMkLst>
        </pc:cxn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23" creationId="{B19D7140-13B2-90C7-E1AD-911648344B69}"/>
          </ac:cxnSpMkLst>
        </pc:cxnChg>
        <pc:cxnChg chg="add 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24" creationId="{B5123BEC-9EE8-8D6D-4529-91A7ECF83355}"/>
          </ac:cxnSpMkLst>
        </pc:cxn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25" creationId="{A327A96A-39C5-C698-FC91-0BCEBBCFF434}"/>
          </ac:cxnSpMkLst>
        </pc:cxnChg>
        <pc:cxnChg chg="add del mod">
          <ac:chgData name="Sherry Hutchinson" userId="da25e8c2-4cfa-4a6f-b6d6-a8ac2a736b83" providerId="ADAL" clId="{70579AD9-A521-44EB-952E-5873134CDDB9}" dt="2023-07-09T19:06:52.874" v="1444"/>
          <ac:cxnSpMkLst>
            <pc:docMk/>
            <pc:sldMk cId="1001350528" sldId="260"/>
            <ac:cxnSpMk id="28" creationId="{D00A560B-A521-53A6-8AA9-C2078E926D58}"/>
          </ac:cxnSpMkLst>
        </pc:cxnChg>
        <pc:cxnChg chg="add 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30" creationId="{866714FB-B66D-37D6-BE5E-71D9FAA5AD9B}"/>
          </ac:cxnSpMkLst>
        </pc:cxn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31" creationId="{54E0BBCF-8123-24C5-50CE-28B0484A1C5C}"/>
          </ac:cxnSpMkLst>
        </pc:cxn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45" creationId="{3CDF5CD2-8E8B-01D8-90D5-89720B458DDB}"/>
          </ac:cxnSpMkLst>
        </pc:cxnChg>
        <pc:cxnChg chg="mod">
          <ac:chgData name="Sherry Hutchinson" userId="da25e8c2-4cfa-4a6f-b6d6-a8ac2a736b83" providerId="ADAL" clId="{70579AD9-A521-44EB-952E-5873134CDDB9}" dt="2023-07-09T21:02:21.248" v="3278" actId="1038"/>
          <ac:cxnSpMkLst>
            <pc:docMk/>
            <pc:sldMk cId="1001350528" sldId="260"/>
            <ac:cxnSpMk id="48" creationId="{8120B1FA-B943-29D0-D7B0-FCEB82E5EC66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2:11.141" v="3222" actId="1038"/>
        <pc:sldMkLst>
          <pc:docMk/>
          <pc:sldMk cId="2962312190" sldId="261"/>
        </pc:sldMkLst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5" creationId="{EE2587FD-7786-B36D-8FF9-0C339E1B82B4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6" creationId="{7DC470C7-4FF4-D342-99E8-E8F821044953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7" creationId="{B74E9DDB-9BFD-9677-7758-16D24AD90C0C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8" creationId="{F77943D8-07E6-F292-0E66-CBF49A5EFC1B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10" creationId="{A4BCC7FC-2E2F-5EF7-91C2-6EE8FC996D5D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2" creationId="{87F66CB6-4E6C-859F-482C-E5DC7F7A965E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13" creationId="{E20B49F2-8F08-060D-172E-F610EF5EA162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14" creationId="{6D46CAAE-D979-563F-6F09-1935DFB4A40F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6" creationId="{EF87472D-AF95-9A97-3335-2A576870F4F7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19" creationId="{B7EA828D-B9F5-483E-9DAA-9B6D79B3EF02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21" creationId="{69413CA9-10F6-8DF5-AEBB-D60AA7105BDF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22" creationId="{9027035E-C213-D913-76AB-7F8408F8148A}"/>
          </ac:spMkLst>
        </pc:spChg>
        <pc:spChg chg="del mod">
          <ac:chgData name="Sherry Hutchinson" userId="da25e8c2-4cfa-4a6f-b6d6-a8ac2a736b83" providerId="ADAL" clId="{70579AD9-A521-44EB-952E-5873134CDDB9}" dt="2023-07-09T19:46:35.304" v="1954" actId="478"/>
          <ac:spMkLst>
            <pc:docMk/>
            <pc:sldMk cId="2962312190" sldId="261"/>
            <ac:spMk id="24" creationId="{8342D52C-EB4D-FB2B-6C91-8246CE16E4FE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0" creationId="{066E8B6B-BAC3-503F-2616-819A7B91AE92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2" creationId="{31D60924-238B-728E-A597-FB51D6D406A0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3" creationId="{A5A33F7A-C786-FDB6-7656-DBF69CD64173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4" creationId="{D90A1DF4-A5A3-EF8C-B980-F218BA892DE0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6" creationId="{BEA5CB09-F4D6-1999-80D8-A3EA7BD7992B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7" creationId="{8C2B35C2-2CE8-B093-FEEA-FE81268E3597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39" creationId="{F697738D-2852-C82A-0D4C-290446B990BF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40" creationId="{B8A300DF-CCA7-D051-1034-2F4F67A18BB6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41" creationId="{6B6873F1-9576-717B-C4A0-3A341FBA713B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43" creationId="{C348594B-A530-0A31-4F4B-FEBCCBCF7527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44" creationId="{6ED0E8A2-16FD-45A7-2EAD-103F52E1B771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49" creationId="{2C263D87-786A-6ACF-3C7A-5F8EA7062FC3}"/>
          </ac:spMkLst>
        </pc:spChg>
        <pc:spChg chg="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51" creationId="{EFD281FA-6659-C669-8958-649C0D1040A5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64" creationId="{4EDE5319-B3EF-74F1-0132-EBA6467FDC67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65" creationId="{2006F54F-823B-BF83-7B08-86E375028EA4}"/>
          </ac:spMkLst>
        </pc:spChg>
        <pc:spChg chg="add del mod">
          <ac:chgData name="Sherry Hutchinson" userId="da25e8c2-4cfa-4a6f-b6d6-a8ac2a736b83" providerId="ADAL" clId="{70579AD9-A521-44EB-952E-5873134CDDB9}" dt="2023-07-09T19:32:35.445" v="1812" actId="478"/>
          <ac:spMkLst>
            <pc:docMk/>
            <pc:sldMk cId="2962312190" sldId="261"/>
            <ac:spMk id="67" creationId="{142AA516-2034-6341-C7FD-778757546AC6}"/>
          </ac:spMkLst>
        </pc:spChg>
        <pc:spChg chg="add del mod">
          <ac:chgData name="Sherry Hutchinson" userId="da25e8c2-4cfa-4a6f-b6d6-a8ac2a736b83" providerId="ADAL" clId="{70579AD9-A521-44EB-952E-5873134CDDB9}" dt="2023-07-09T19:32:35.445" v="1812" actId="478"/>
          <ac:spMkLst>
            <pc:docMk/>
            <pc:sldMk cId="2962312190" sldId="261"/>
            <ac:spMk id="69" creationId="{70A9DCA6-A8BE-4995-90F7-EF477ABD8391}"/>
          </ac:spMkLst>
        </pc:spChg>
        <pc:spChg chg="add del mod">
          <ac:chgData name="Sherry Hutchinson" userId="da25e8c2-4cfa-4a6f-b6d6-a8ac2a736b83" providerId="ADAL" clId="{70579AD9-A521-44EB-952E-5873134CDDB9}" dt="2023-07-09T19:32:35.445" v="1812" actId="478"/>
          <ac:spMkLst>
            <pc:docMk/>
            <pc:sldMk cId="2962312190" sldId="261"/>
            <ac:spMk id="70" creationId="{AFB8DBE3-191F-8422-EB22-B3FEE1026E59}"/>
          </ac:spMkLst>
        </pc:spChg>
        <pc:spChg chg="add del mod">
          <ac:chgData name="Sherry Hutchinson" userId="da25e8c2-4cfa-4a6f-b6d6-a8ac2a736b83" providerId="ADAL" clId="{70579AD9-A521-44EB-952E-5873134CDDB9}" dt="2023-07-09T19:32:35.445" v="1812" actId="478"/>
          <ac:spMkLst>
            <pc:docMk/>
            <pc:sldMk cId="2962312190" sldId="261"/>
            <ac:spMk id="72" creationId="{7385324E-D8FB-FA21-553C-01903D0C3B8E}"/>
          </ac:spMkLst>
        </pc:spChg>
        <pc:spChg chg="add del mod">
          <ac:chgData name="Sherry Hutchinson" userId="da25e8c2-4cfa-4a6f-b6d6-a8ac2a736b83" providerId="ADAL" clId="{70579AD9-A521-44EB-952E-5873134CDDB9}" dt="2023-07-09T19:32:35.445" v="1812" actId="478"/>
          <ac:spMkLst>
            <pc:docMk/>
            <pc:sldMk cId="2962312190" sldId="261"/>
            <ac:spMk id="73" creationId="{F2F48B35-1EF0-DC27-21E3-F58B54A568AE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74" creationId="{B915C397-D34E-CB54-9ABB-A8A897D6ABC9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75" creationId="{43312A6B-22C2-BB4A-4EF8-9978448CD463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78" creationId="{4C9090F2-2CBF-2848-E142-4719BFAFEE56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0" creationId="{88A74595-322C-17FE-2BA0-931500314D67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1" creationId="{9CDE1B19-F451-06EA-F5A8-F3BE95364030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3" creationId="{AE5A708E-A237-33AC-14C0-A1ABBC77DC23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4" creationId="{91C8740C-A74E-CD1B-2386-71ABA6AFE895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6" creationId="{8100C1DF-1DF2-E432-6F1C-703C82B5A3A3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8" creationId="{9EA38032-10CB-409F-1F3A-BB73B6AF0B78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89" creationId="{AEDFDA35-50E5-36CF-DAA1-D17AC596F0D5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91" creationId="{54F3F5EB-2E16-6DDA-CA80-80F876F23F73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92" creationId="{6DB0A5E7-8C0B-15B6-36E3-BCD1AF5930FC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94" creationId="{A0B829EA-4F4E-23EC-88B5-8E69510DE8D3}"/>
          </ac:spMkLst>
        </pc:spChg>
        <pc:spChg chg="add del mod">
          <ac:chgData name="Sherry Hutchinson" userId="da25e8c2-4cfa-4a6f-b6d6-a8ac2a736b83" providerId="ADAL" clId="{70579AD9-A521-44EB-952E-5873134CDDB9}" dt="2023-07-09T20:09:24.930" v="2274" actId="478"/>
          <ac:spMkLst>
            <pc:docMk/>
            <pc:sldMk cId="2962312190" sldId="261"/>
            <ac:spMk id="95" creationId="{DDC6D09A-4ADA-8EA7-43EC-00F782B2B261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96" creationId="{F13738EC-3793-09D7-BBDF-2F5AE551B241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98" creationId="{ACBC534E-C1CB-51F2-5761-C5FEA608B2EA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99" creationId="{B1F4A3DF-9610-4A0E-2797-3A67395288AB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01" creationId="{70C7A87C-FF42-7891-7F4A-1D18F3319790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04" creationId="{F7721222-8524-D2B3-E4C0-BC9432442520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05" creationId="{CEC01645-D6EC-6BA5-66A4-CFCDDEBA913E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06" creationId="{87BAC0B7-BE9B-84F9-A6E8-91AF9A3E0724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07" creationId="{00620076-0E0D-0016-8557-4281810614F6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10" creationId="{906CE280-783E-A2B9-4D8E-2FC8A4A82A7E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12" creationId="{16CC2ACF-BE35-B439-3E06-15033B03E77B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13" creationId="{4C4ADB03-972E-8FCC-76F5-FE8B9AA61069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15" creationId="{0C55CC25-9DBC-5DD3-08EB-E4041C8B1ABF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16" creationId="{8E69D99E-A10C-FA97-AED3-1E40422D28E7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18" creationId="{C511D52A-B224-A69D-2B47-8ECB5A80BFF3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20" creationId="{418AFEC1-B275-A413-35FE-208A62AD2767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21" creationId="{53DB3850-ACAE-4334-67BF-58B62A581E66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23" creationId="{E861D594-4D24-0AA8-4ECE-6AD548120272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24" creationId="{838C66D9-8824-3AD5-394D-DF4DA351F83A}"/>
          </ac:spMkLst>
        </pc:spChg>
        <pc:spChg chg="add mod">
          <ac:chgData name="Sherry Hutchinson" userId="da25e8c2-4cfa-4a6f-b6d6-a8ac2a736b83" providerId="ADAL" clId="{70579AD9-A521-44EB-952E-5873134CDDB9}" dt="2023-07-09T21:02:11.141" v="3222" actId="1038"/>
          <ac:spMkLst>
            <pc:docMk/>
            <pc:sldMk cId="2962312190" sldId="261"/>
            <ac:spMk id="125" creationId="{716E4E9F-58D1-ADBD-90E6-E6F89B2438FF}"/>
          </ac:spMkLst>
        </pc:spChg>
        <pc:cxnChg chg="del mod">
          <ac:chgData name="Sherry Hutchinson" userId="da25e8c2-4cfa-4a6f-b6d6-a8ac2a736b83" providerId="ADAL" clId="{70579AD9-A521-44EB-952E-5873134CDDB9}" dt="2023-07-09T19:46:35.304" v="1954" actId="478"/>
          <ac:cxnSpMkLst>
            <pc:docMk/>
            <pc:sldMk cId="2962312190" sldId="261"/>
            <ac:cxnSpMk id="4" creationId="{8C3D36E1-D13E-1C53-8312-F2363D424D21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9" creationId="{EA32A644-ADF7-B3AD-56F1-67002BDA0FAA}"/>
          </ac:cxnSpMkLst>
        </pc:cxnChg>
        <pc:cxnChg chg="del mod">
          <ac:chgData name="Sherry Hutchinson" userId="da25e8c2-4cfa-4a6f-b6d6-a8ac2a736b83" providerId="ADAL" clId="{70579AD9-A521-44EB-952E-5873134CDDB9}" dt="2023-07-09T19:46:35.304" v="1954" actId="478"/>
          <ac:cxnSpMkLst>
            <pc:docMk/>
            <pc:sldMk cId="2962312190" sldId="261"/>
            <ac:cxnSpMk id="11" creationId="{D3BC44CD-F838-EA19-EDCB-A3DE3A4A8110}"/>
          </ac:cxnSpMkLst>
        </pc:cxnChg>
        <pc:cxnChg chg="del mod">
          <ac:chgData name="Sherry Hutchinson" userId="da25e8c2-4cfa-4a6f-b6d6-a8ac2a736b83" providerId="ADAL" clId="{70579AD9-A521-44EB-952E-5873134CDDB9}" dt="2023-07-09T19:46:35.304" v="1954" actId="478"/>
          <ac:cxnSpMkLst>
            <pc:docMk/>
            <pc:sldMk cId="2962312190" sldId="261"/>
            <ac:cxnSpMk id="15" creationId="{DC442DB1-BB72-E5A3-9A35-328CD0B042BD}"/>
          </ac:cxnSpMkLst>
        </pc:cxnChg>
        <pc:cxnChg chg="del mod">
          <ac:chgData name="Sherry Hutchinson" userId="da25e8c2-4cfa-4a6f-b6d6-a8ac2a736b83" providerId="ADAL" clId="{70579AD9-A521-44EB-952E-5873134CDDB9}" dt="2023-07-09T19:46:35.304" v="1954" actId="478"/>
          <ac:cxnSpMkLst>
            <pc:docMk/>
            <pc:sldMk cId="2962312190" sldId="261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23" creationId="{B19D7140-13B2-90C7-E1AD-911648344B69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25" creationId="{A327A96A-39C5-C698-FC91-0BCEBBCFF434}"/>
          </ac:cxnSpMkLst>
        </pc:cxnChg>
        <pc:cxnChg chg="del mod">
          <ac:chgData name="Sherry Hutchinson" userId="da25e8c2-4cfa-4a6f-b6d6-a8ac2a736b83" providerId="ADAL" clId="{70579AD9-A521-44EB-952E-5873134CDDB9}" dt="2023-07-09T19:46:35.304" v="1954" actId="478"/>
          <ac:cxnSpMkLst>
            <pc:docMk/>
            <pc:sldMk cId="2962312190" sldId="261"/>
            <ac:cxnSpMk id="26" creationId="{95C1D25E-E672-B5DF-14CE-2241102BA817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29" creationId="{ED8F1B60-8A3F-7E24-5982-ADB968A0B23A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31" creationId="{54E0BBCF-8123-24C5-50CE-28B0484A1C5C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35" creationId="{EA9DD346-C537-7536-2646-54F77321DE81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38" creationId="{622B485C-39D7-706C-B18A-4B90F8ABCEC3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42" creationId="{69D5851D-7D84-4BEC-1223-1B824AA35BA4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48" creationId="{8120B1FA-B943-29D0-D7B0-FCEB82E5EC66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50" creationId="{E750C4CB-D64D-EB34-273B-3B3B130F1519}"/>
          </ac:cxnSpMkLst>
        </pc:cxnChg>
        <pc:cxnChg chg="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52" creationId="{A003AC44-C9F9-3684-4396-5488F2357645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63" creationId="{8241C0BE-DC91-751A-531E-D27A027F9DBF}"/>
          </ac:cxnSpMkLst>
        </pc:cxnChg>
        <pc:cxnChg chg="add del mod">
          <ac:chgData name="Sherry Hutchinson" userId="da25e8c2-4cfa-4a6f-b6d6-a8ac2a736b83" providerId="ADAL" clId="{70579AD9-A521-44EB-952E-5873134CDDB9}" dt="2023-07-09T19:32:35.445" v="1812" actId="478"/>
          <ac:cxnSpMkLst>
            <pc:docMk/>
            <pc:sldMk cId="2962312190" sldId="261"/>
            <ac:cxnSpMk id="66" creationId="{0236225E-66CA-19DF-7B12-C7AF0497C0E9}"/>
          </ac:cxnSpMkLst>
        </pc:cxnChg>
        <pc:cxnChg chg="add del mod">
          <ac:chgData name="Sherry Hutchinson" userId="da25e8c2-4cfa-4a6f-b6d6-a8ac2a736b83" providerId="ADAL" clId="{70579AD9-A521-44EB-952E-5873134CDDB9}" dt="2023-07-09T19:32:35.445" v="1812" actId="478"/>
          <ac:cxnSpMkLst>
            <pc:docMk/>
            <pc:sldMk cId="2962312190" sldId="261"/>
            <ac:cxnSpMk id="68" creationId="{8D547B6E-1C63-0784-742A-2D5DAFFCF263}"/>
          </ac:cxnSpMkLst>
        </pc:cxnChg>
        <pc:cxnChg chg="add del mod">
          <ac:chgData name="Sherry Hutchinson" userId="da25e8c2-4cfa-4a6f-b6d6-a8ac2a736b83" providerId="ADAL" clId="{70579AD9-A521-44EB-952E-5873134CDDB9}" dt="2023-07-09T19:32:35.445" v="1812" actId="478"/>
          <ac:cxnSpMkLst>
            <pc:docMk/>
            <pc:sldMk cId="2962312190" sldId="261"/>
            <ac:cxnSpMk id="71" creationId="{DC04FAF8-3F4B-4CFB-5985-37FF22884E29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76" creationId="{FA46B5DA-1C0A-1507-6D83-CD2022B0648E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77" creationId="{FAF202DA-3853-5812-CA21-044F4D2E310B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79" creationId="{48B72D99-BBE7-A5F2-6FD9-90372FAC42F7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82" creationId="{7D314D96-3D4C-FEF8-04BC-917168CD2E2A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87" creationId="{A60EB0D2-693A-A805-C2EE-2EA3C410E72E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90" creationId="{D92F2700-4F28-4B00-59EC-F3AE7CC1D233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93" creationId="{69A49EBC-7D43-3374-F39C-A19464DCEB96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97" creationId="{19D28DF2-180B-6D57-A416-E41C05AB7032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00" creationId="{1E1081AE-11F8-7A2F-8D52-CFEDF189E03A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02" creationId="{71A494D3-417E-391A-D042-4AD968653450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03" creationId="{AA2783FE-AF51-1DDF-A099-67B6B34F53E8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08" creationId="{7CBF821E-407B-7162-39EF-58D403605A24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09" creationId="{149DB441-C6FF-D618-B5DA-3D8B98CEE864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11" creationId="{7E51D1CE-53E2-0BAC-5029-FE4BF186C8BC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14" creationId="{927EF341-1DB8-2948-ADE2-CED8A3E28304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17" creationId="{CA5130FD-207D-9E0F-B907-2E35499EF8D3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19" creationId="{58B31A0B-9045-E94B-809B-064B63D2E95A}"/>
          </ac:cxnSpMkLst>
        </pc:cxnChg>
        <pc:cxnChg chg="add mod">
          <ac:chgData name="Sherry Hutchinson" userId="da25e8c2-4cfa-4a6f-b6d6-a8ac2a736b83" providerId="ADAL" clId="{70579AD9-A521-44EB-952E-5873134CDDB9}" dt="2023-07-09T21:02:11.141" v="3222" actId="1038"/>
          <ac:cxnSpMkLst>
            <pc:docMk/>
            <pc:sldMk cId="2962312190" sldId="261"/>
            <ac:cxnSpMk id="122" creationId="{CBF31E32-6AA4-DFE8-90E2-EA3663BE6681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2:00.172" v="3200" actId="1038"/>
        <pc:sldMkLst>
          <pc:docMk/>
          <pc:sldMk cId="24661109" sldId="262"/>
        </pc:sldMkLst>
        <pc:spChg chg="del mod">
          <ac:chgData name="Sherry Hutchinson" userId="da25e8c2-4cfa-4a6f-b6d6-a8ac2a736b83" providerId="ADAL" clId="{70579AD9-A521-44EB-952E-5873134CDDB9}" dt="2023-07-09T20:23:48.626" v="2411" actId="478"/>
          <ac:spMkLst>
            <pc:docMk/>
            <pc:sldMk cId="24661109" sldId="262"/>
            <ac:spMk id="2" creationId="{C8743B67-A212-F10E-9D07-39369A106C31}"/>
          </ac:spMkLst>
        </pc:spChg>
        <pc:spChg chg="del mod">
          <ac:chgData name="Sherry Hutchinson" userId="da25e8c2-4cfa-4a6f-b6d6-a8ac2a736b83" providerId="ADAL" clId="{70579AD9-A521-44EB-952E-5873134CDDB9}" dt="2023-07-09T20:23:48.626" v="2411" actId="478"/>
          <ac:spMkLst>
            <pc:docMk/>
            <pc:sldMk cId="24661109" sldId="262"/>
            <ac:spMk id="4" creationId="{F5162822-D35C-9E28-59A5-315811512466}"/>
          </ac:spMkLst>
        </pc:spChg>
        <pc:spChg chg="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5" creationId="{EE2587FD-7786-B36D-8FF9-0C339E1B82B4}"/>
          </ac:spMkLst>
        </pc:spChg>
        <pc:spChg chg="del mod">
          <ac:chgData name="Sherry Hutchinson" userId="da25e8c2-4cfa-4a6f-b6d6-a8ac2a736b83" providerId="ADAL" clId="{70579AD9-A521-44EB-952E-5873134CDDB9}" dt="2023-07-09T20:23:48.626" v="2411" actId="478"/>
          <ac:spMkLst>
            <pc:docMk/>
            <pc:sldMk cId="24661109" sldId="262"/>
            <ac:spMk id="6" creationId="{05E6FBB9-114F-8BB7-671E-A5222EE2E4B3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8" creationId="{232354EC-E368-F142-1F7B-DE6A9A089AB6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9" creationId="{B3482616-1E30-DD0B-711E-7BE1D622F80E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11" creationId="{B23EF734-2799-72DC-C0C5-2C33D0EFF3AB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12" creationId="{D631172A-9D04-D0B3-1E67-FA7C22C76A3F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13" creationId="{610AC049-3B87-889C-3853-00BEDCF6CDEB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15" creationId="{005F4B0A-8CC3-A126-DBE0-398EC7CE5BF5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18" creationId="{E063459B-7483-7724-4A1A-EA1A98E6C5B0}"/>
          </ac:spMkLst>
        </pc:spChg>
        <pc:spChg chg="del mod">
          <ac:chgData name="Sherry Hutchinson" userId="da25e8c2-4cfa-4a6f-b6d6-a8ac2a736b83" providerId="ADAL" clId="{70579AD9-A521-44EB-952E-5873134CDDB9}" dt="2023-07-09T20:23:48.626" v="2411" actId="478"/>
          <ac:spMkLst>
            <pc:docMk/>
            <pc:sldMk cId="24661109" sldId="262"/>
            <ac:spMk id="19" creationId="{B7EA828D-B9F5-483E-9DAA-9B6D79B3EF02}"/>
          </ac:spMkLst>
        </pc:spChg>
        <pc:spChg chg="del mod">
          <ac:chgData name="Sherry Hutchinson" userId="da25e8c2-4cfa-4a6f-b6d6-a8ac2a736b83" providerId="ADAL" clId="{70579AD9-A521-44EB-952E-5873134CDDB9}" dt="2023-07-09T20:23:48.626" v="2411" actId="478"/>
          <ac:spMkLst>
            <pc:docMk/>
            <pc:sldMk cId="24661109" sldId="262"/>
            <ac:spMk id="21" creationId="{69413CA9-10F6-8DF5-AEBB-D60AA7105BDF}"/>
          </ac:spMkLst>
        </pc:spChg>
        <pc:spChg chg="del mod">
          <ac:chgData name="Sherry Hutchinson" userId="da25e8c2-4cfa-4a6f-b6d6-a8ac2a736b83" providerId="ADAL" clId="{70579AD9-A521-44EB-952E-5873134CDDB9}" dt="2023-07-09T20:23:48.626" v="2411" actId="478"/>
          <ac:spMkLst>
            <pc:docMk/>
            <pc:sldMk cId="24661109" sldId="262"/>
            <ac:spMk id="22" creationId="{9027035E-C213-D913-76AB-7F8408F8148A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24" creationId="{D5574D0B-A138-CF59-E408-8D7379EB08EC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25" creationId="{87757A16-76B0-F0C6-AAE7-0A4A3942E16B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27" creationId="{C44E87E5-88B7-7A95-462C-EA52102387E9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28" creationId="{81734FE5-2638-980D-B973-7BBBD5A2075B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1" creationId="{8AC71F4D-F218-79D0-A594-0DE96D540763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2" creationId="{CEECA03B-9A4A-96CE-D93C-57A376D23B6A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4" creationId="{12D592D0-353E-39A0-D901-FE3DFFF18592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5" creationId="{1F55F188-9BBB-ECD5-33EA-CD8B5122AF36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6" creationId="{55E59B2F-3C83-CBA6-9148-ECFE1628745C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7" creationId="{48FB9DB0-3B62-CDDA-76D9-598F9B94A5AA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39" creationId="{806F8C1E-DF32-C540-C728-C12BF999D4DD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42" creationId="{D8E92050-47F4-07EB-A645-0988AE7C72B5}"/>
          </ac:spMkLst>
        </pc:spChg>
        <pc:spChg chg="add mod">
          <ac:chgData name="Sherry Hutchinson" userId="da25e8c2-4cfa-4a6f-b6d6-a8ac2a736b83" providerId="ADAL" clId="{70579AD9-A521-44EB-952E-5873134CDDB9}" dt="2023-07-09T21:02:00.172" v="3200" actId="1038"/>
          <ac:spMkLst>
            <pc:docMk/>
            <pc:sldMk cId="24661109" sldId="262"/>
            <ac:spMk id="43" creationId="{623922C1-FA6A-C4A0-7AA6-E4D730931E92}"/>
          </ac:spMkLst>
        </pc:spChg>
        <pc:cxnChg chg="del mod">
          <ac:chgData name="Sherry Hutchinson" userId="da25e8c2-4cfa-4a6f-b6d6-a8ac2a736b83" providerId="ADAL" clId="{70579AD9-A521-44EB-952E-5873134CDDB9}" dt="2023-07-09T20:23:48.626" v="2411" actId="478"/>
          <ac:cxnSpMkLst>
            <pc:docMk/>
            <pc:sldMk cId="24661109" sldId="262"/>
            <ac:cxnSpMk id="3" creationId="{A32EAAEA-C093-4FCE-F2CC-E2F404500EF8}"/>
          </ac:cxnSpMkLst>
        </pc:cxnChg>
        <pc:cxnChg chg="del mod">
          <ac:chgData name="Sherry Hutchinson" userId="da25e8c2-4cfa-4a6f-b6d6-a8ac2a736b83" providerId="ADAL" clId="{70579AD9-A521-44EB-952E-5873134CDDB9}" dt="2023-07-09T20:23:48.626" v="2411" actId="478"/>
          <ac:cxnSpMkLst>
            <pc:docMk/>
            <pc:sldMk cId="24661109" sldId="262"/>
            <ac:cxnSpMk id="7" creationId="{E66D9628-0046-464C-EA99-BFED26C9964C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10" creationId="{03F606B4-2CFF-D123-4F6A-89399555D405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14" creationId="{50CA136D-4BC9-7C12-C163-E00EA43CBD4A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16" creationId="{7CD8CCBA-7C66-E596-C9B4-330A47E4A5BD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17" creationId="{4E252079-14BD-A672-CD06-73247FDB535B}"/>
          </ac:cxnSpMkLst>
        </pc:cxnChg>
        <pc:cxnChg chg="del mod">
          <ac:chgData name="Sherry Hutchinson" userId="da25e8c2-4cfa-4a6f-b6d6-a8ac2a736b83" providerId="ADAL" clId="{70579AD9-A521-44EB-952E-5873134CDDB9}" dt="2023-07-09T20:23:48.626" v="2411" actId="478"/>
          <ac:cxnSpMkLst>
            <pc:docMk/>
            <pc:sldMk cId="24661109" sldId="262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23" creationId="{B19D7140-13B2-90C7-E1AD-911648344B69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26" creationId="{2E48F76C-8EA4-BAE2-6DDD-2DD445569A41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29" creationId="{B7066324-5D12-3914-0AE3-24AED75DDF44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30" creationId="{7D8BEBF3-7F68-0EA3-B301-1C6F8099EDFB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33" creationId="{DBECC9C3-21FA-CB36-FBE8-CDA5E06E15E3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38" creationId="{550611E6-B548-FCB1-BEDB-4CBB56C08F84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40" creationId="{207C0CC6-4B87-F525-F921-F3E024D33508}"/>
          </ac:cxnSpMkLst>
        </pc:cxnChg>
        <pc:cxnChg chg="add mod">
          <ac:chgData name="Sherry Hutchinson" userId="da25e8c2-4cfa-4a6f-b6d6-a8ac2a736b83" providerId="ADAL" clId="{70579AD9-A521-44EB-952E-5873134CDDB9}" dt="2023-07-09T21:02:00.172" v="3200" actId="1038"/>
          <ac:cxnSpMkLst>
            <pc:docMk/>
            <pc:sldMk cId="24661109" sldId="262"/>
            <ac:cxnSpMk id="41" creationId="{10D947CF-3447-C6D1-7E33-BBA29C4BD42D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1:50.225" v="3156" actId="1038"/>
        <pc:sldMkLst>
          <pc:docMk/>
          <pc:sldMk cId="2593572919" sldId="263"/>
        </pc:sldMkLst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2" creationId="{8916E81C-232A-EAFF-D780-C5139479CEAE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3" creationId="{96787977-5C09-B334-FD07-217F85302EF9}"/>
          </ac:spMkLst>
        </pc:spChg>
        <pc:spChg chg="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5" creationId="{EE2587FD-7786-B36D-8FF9-0C339E1B82B4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6" creationId="{984EE4B4-0514-DB2E-017E-9B8C68ED5EB2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7" creationId="{7F64FAD7-CB3A-1A0B-60AA-4B9BD3898E14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8" creationId="{0508913D-D366-ABCF-80B4-3F2FC7D90802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10" creationId="{381C68BF-0984-3831-B6E3-EBE44E210CA2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13" creationId="{2915DA16-F32C-861F-0D8A-8F72C157A92F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14" creationId="{DF79E916-ED01-0D58-888C-2204CDA5C809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15" creationId="{2777904C-D069-64CE-4D89-374DE3A91C62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17" creationId="{2BC1F5E7-29B2-9F68-4911-93100FF86C54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18" creationId="{0C1DE371-C825-96F3-3F3C-99ECE922B8E4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19" creationId="{B7EA828D-B9F5-483E-9DAA-9B6D79B3EF02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21" creationId="{69413CA9-10F6-8DF5-AEBB-D60AA7105BDF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22" creationId="{9027035E-C213-D913-76AB-7F8408F8148A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26" creationId="{6DA42466-B8F6-9F16-1D38-29411DD716AE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27" creationId="{7AB53A6B-14D7-01EC-D4F9-2D50702CD416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29" creationId="{70C38928-FD3B-09B3-0FC1-76A17952E29E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30" creationId="{DDDF19F5-BC9F-4FA9-CCC5-A65B6BD18BA3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32" creationId="{31D60924-238B-728E-A597-FB51D6D406A0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33" creationId="{A5A33F7A-C786-FDB6-7656-DBF69CD64173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35" creationId="{D63E7F10-149B-4A1A-0006-CCB962077C11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36" creationId="{DF471945-5BA5-F6DF-47AF-AEA0CE99DE34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37" creationId="{9BD0BEEE-8C42-F0D2-EC3B-595D0D22BBF6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39" creationId="{BD93B78F-0324-868D-639A-4D250753BB6B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42" creationId="{BFD8CD18-90B4-719A-8E0B-64350C7A6326}"/>
          </ac:spMkLst>
        </pc:spChg>
        <pc:spChg chg="add mod">
          <ac:chgData name="Sherry Hutchinson" userId="da25e8c2-4cfa-4a6f-b6d6-a8ac2a736b83" providerId="ADAL" clId="{70579AD9-A521-44EB-952E-5873134CDDB9}" dt="2023-07-09T21:01:50.225" v="3156" actId="1038"/>
          <ac:spMkLst>
            <pc:docMk/>
            <pc:sldMk cId="2593572919" sldId="263"/>
            <ac:spMk id="43" creationId="{CB713C29-E318-1EDC-A5BC-E3F643B07797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44" creationId="{6ED0E8A2-16FD-45A7-2EAD-103F52E1B771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46" creationId="{8EE99552-126D-51A7-89E3-1E4546488C94}"/>
          </ac:spMkLst>
        </pc:spChg>
        <pc:spChg chg="del mod">
          <ac:chgData name="Sherry Hutchinson" userId="da25e8c2-4cfa-4a6f-b6d6-a8ac2a736b83" providerId="ADAL" clId="{70579AD9-A521-44EB-952E-5873134CDDB9}" dt="2023-07-09T20:43:19.740" v="2851" actId="478"/>
          <ac:spMkLst>
            <pc:docMk/>
            <pc:sldMk cId="2593572919" sldId="263"/>
            <ac:spMk id="47" creationId="{047F0D2D-ADE3-DA91-A500-37C654E004E0}"/>
          </ac:spMkLst>
        </pc:sp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4" creationId="{9F55C2C8-AC13-A136-E80D-73151810EE79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9" creationId="{CD18F91A-763F-5ED3-DF43-D8C9D956596F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11" creationId="{A1FF155A-B469-94FD-781C-68B73CD7C29D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12" creationId="{5E4BDB4C-41BA-A1C0-36D5-A6294817F73B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16" creationId="{6712DBF5-EB41-7F9D-BECA-7BA27CBEA6F3}"/>
          </ac:cxnSpMkLst>
        </pc:cxnChg>
        <pc:cxnChg chg="del mod">
          <ac:chgData name="Sherry Hutchinson" userId="da25e8c2-4cfa-4a6f-b6d6-a8ac2a736b83" providerId="ADAL" clId="{70579AD9-A521-44EB-952E-5873134CDDB9}" dt="2023-07-09T20:43:19.740" v="2851" actId="478"/>
          <ac:cxnSpMkLst>
            <pc:docMk/>
            <pc:sldMk cId="2593572919" sldId="263"/>
            <ac:cxnSpMk id="20" creationId="{35A77E48-FCCC-3D0F-3244-74D467909D7E}"/>
          </ac:cxnSpMkLst>
        </pc:cxnChg>
        <pc:cxnChg chg="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23" creationId="{B19D7140-13B2-90C7-E1AD-911648344B69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24" creationId="{564B2B20-304F-92F5-3A5D-CB4AC0480F92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25" creationId="{317FD0B6-2D8C-1B07-F675-91655F08F038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28" creationId="{AA711C6C-0A33-08B6-B171-AA377118345D}"/>
          </ac:cxnSpMkLst>
        </pc:cxnChg>
        <pc:cxnChg chg="del mod">
          <ac:chgData name="Sherry Hutchinson" userId="da25e8c2-4cfa-4a6f-b6d6-a8ac2a736b83" providerId="ADAL" clId="{70579AD9-A521-44EB-952E-5873134CDDB9}" dt="2023-07-09T20:43:19.740" v="2851" actId="478"/>
          <ac:cxnSpMkLst>
            <pc:docMk/>
            <pc:sldMk cId="2593572919" sldId="263"/>
            <ac:cxnSpMk id="31" creationId="{54E0BBCF-8123-24C5-50CE-28B0484A1C5C}"/>
          </ac:cxnSpMkLst>
        </pc:cxnChg>
        <pc:cxnChg chg="del mod">
          <ac:chgData name="Sherry Hutchinson" userId="da25e8c2-4cfa-4a6f-b6d6-a8ac2a736b83" providerId="ADAL" clId="{70579AD9-A521-44EB-952E-5873134CDDB9}" dt="2023-07-09T20:43:19.740" v="2851" actId="478"/>
          <ac:cxnSpMkLst>
            <pc:docMk/>
            <pc:sldMk cId="2593572919" sldId="263"/>
            <ac:cxnSpMk id="34" creationId="{2BFC792D-7D34-7B08-A7BE-FE329113102D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38" creationId="{F30D7325-30A9-9685-E93A-805C3CCD5868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40" creationId="{4DE7840A-7714-0771-D8B0-3335C9319370}"/>
          </ac:cxnSpMkLst>
        </pc:cxnChg>
        <pc:cxnChg chg="add mod">
          <ac:chgData name="Sherry Hutchinson" userId="da25e8c2-4cfa-4a6f-b6d6-a8ac2a736b83" providerId="ADAL" clId="{70579AD9-A521-44EB-952E-5873134CDDB9}" dt="2023-07-09T21:01:50.225" v="3156" actId="1038"/>
          <ac:cxnSpMkLst>
            <pc:docMk/>
            <pc:sldMk cId="2593572919" sldId="263"/>
            <ac:cxnSpMk id="41" creationId="{DC9F9B6C-05B2-A40C-18FA-58310BCCA15B}"/>
          </ac:cxnSpMkLst>
        </pc:cxnChg>
        <pc:cxnChg chg="del mod">
          <ac:chgData name="Sherry Hutchinson" userId="da25e8c2-4cfa-4a6f-b6d6-a8ac2a736b83" providerId="ADAL" clId="{70579AD9-A521-44EB-952E-5873134CDDB9}" dt="2023-07-09T20:43:19.740" v="2851" actId="478"/>
          <ac:cxnSpMkLst>
            <pc:docMk/>
            <pc:sldMk cId="2593572919" sldId="263"/>
            <ac:cxnSpMk id="45" creationId="{3CDF5CD2-8E8B-01D8-90D5-89720B458DDB}"/>
          </ac:cxnSpMkLst>
        </pc:cxnChg>
        <pc:cxnChg chg="del mod">
          <ac:chgData name="Sherry Hutchinson" userId="da25e8c2-4cfa-4a6f-b6d6-a8ac2a736b83" providerId="ADAL" clId="{70579AD9-A521-44EB-952E-5873134CDDB9}" dt="2023-07-09T20:43:19.740" v="2851" actId="478"/>
          <ac:cxnSpMkLst>
            <pc:docMk/>
            <pc:sldMk cId="2593572919" sldId="263"/>
            <ac:cxnSpMk id="48" creationId="{8120B1FA-B943-29D0-D7B0-FCEB82E5EC66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1:39.490" v="3110" actId="1038"/>
        <pc:sldMkLst>
          <pc:docMk/>
          <pc:sldMk cId="47547401" sldId="264"/>
        </pc:sldMkLst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2" creationId="{D0356022-8F41-C870-8DDB-6F69FC3DDF77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4" creationId="{2DE17750-57C3-8D5A-4BC8-DB6BAEA502E1}"/>
          </ac:spMkLst>
        </pc:spChg>
        <pc:spChg chg="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5" creationId="{EE2587FD-7786-B36D-8FF9-0C339E1B82B4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6" creationId="{7DC470C7-4FF4-D342-99E8-E8F821044953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7" creationId="{DD4B4957-10AB-B950-F8F7-9291EB5A69C2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8" creationId="{61D0B8F8-730A-32FC-DFF2-81D7C307ADA9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10" creationId="{95A83072-74DD-E8E5-69F3-2AE49F8D19C3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12" creationId="{87F66CB6-4E6C-859F-482C-E5DC7F7A965E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14" creationId="{49452D4D-FEB8-5A0A-12DA-D36E2A84C576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16" creationId="{EF87472D-AF95-9A97-3335-2A576870F4F7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17" creationId="{8015C8DA-F7CC-970D-9AB2-7893DB9AA5EB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18" creationId="{EB6A91C8-8CBC-E6D5-F604-12FC37E38D61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19" creationId="{B7EA828D-B9F5-483E-9DAA-9B6D79B3EF02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21" creationId="{69413CA9-10F6-8DF5-AEBB-D60AA7105BDF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22" creationId="{9027035E-C213-D913-76AB-7F8408F8148A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26" creationId="{D9FC20D0-04A1-34C9-CCD3-3E60CB16979D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27" creationId="{FFC2A3E4-A021-9B6F-969C-B78E5671128B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29" creationId="{A9B90E23-487E-22E7-A24F-C864F86CE279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30" creationId="{DDDF19F5-BC9F-4FA9-CCC5-A65B6BD18BA3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32" creationId="{31D60924-238B-728E-A597-FB51D6D406A0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33" creationId="{A5A33F7A-C786-FDB6-7656-DBF69CD64173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36" creationId="{0CE7C762-83F2-76B8-6E5F-79E062E9C62A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37" creationId="{7E3BDC5B-6834-1959-4870-1FC3463494F3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39" creationId="{634B1E58-74C8-EAD1-2852-90DEC6BA1621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40" creationId="{954815C5-A18E-3242-8EA5-774D24D5E0F6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42" creationId="{48BA172F-5850-B74F-D7A0-4F4846C5F8E1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44" creationId="{6ED0E8A2-16FD-45A7-2EAD-103F52E1B771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46" creationId="{8EE99552-126D-51A7-89E3-1E4546488C94}"/>
          </ac:spMkLst>
        </pc:spChg>
        <pc:spChg chg="del mod">
          <ac:chgData name="Sherry Hutchinson" userId="da25e8c2-4cfa-4a6f-b6d6-a8ac2a736b83" providerId="ADAL" clId="{70579AD9-A521-44EB-952E-5873134CDDB9}" dt="2023-07-09T20:41:26.684" v="2800" actId="478"/>
          <ac:spMkLst>
            <pc:docMk/>
            <pc:sldMk cId="47547401" sldId="264"/>
            <ac:spMk id="47" creationId="{047F0D2D-ADE3-DA91-A500-37C654E004E0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49" creationId="{3375FE9A-1E67-87FE-ABDD-2E6418B7F411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50" creationId="{1E0115A3-D42F-428B-6242-BF6720EC55BE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52" creationId="{69D3119D-E616-874D-A736-5109D7C3F69E}"/>
          </ac:spMkLst>
        </pc:spChg>
        <pc:spChg chg="add del mod">
          <ac:chgData name="Sherry Hutchinson" userId="da25e8c2-4cfa-4a6f-b6d6-a8ac2a736b83" providerId="ADAL" clId="{70579AD9-A521-44EB-952E-5873134CDDB9}" dt="2023-07-09T20:31:56.634" v="2541"/>
          <ac:spMkLst>
            <pc:docMk/>
            <pc:sldMk cId="47547401" sldId="264"/>
            <ac:spMk id="53" creationId="{3CC62704-1020-474B-519E-201CC81D1BEB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54" creationId="{E1462198-F8B8-E8E0-7072-C184A6EF47D6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56" creationId="{79542C5C-A0FE-7FEB-7A04-F46DC7762D20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57" creationId="{7BE7DB1B-360B-A744-B9AD-1D4525DDBD42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58" creationId="{7D8477E5-4CB4-6C36-06CA-708E987BCC04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59" creationId="{39D92A48-5392-88E0-6287-BC151CD9E269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62" creationId="{CE08F786-56FB-A473-9BA4-E6C769F28BFD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64" creationId="{0D6F18F1-D861-0D1C-3FC8-3EF3D6267757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65" creationId="{EDDEE835-4085-E84A-2BC5-826F5168E100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67" creationId="{27D391F5-B44C-66CF-3358-FA45C521C962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68" creationId="{C37B58CA-8074-87A9-A82F-E2A1953EF3C9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70" creationId="{CFD3F218-136B-4CD7-889B-38FF540096E3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72" creationId="{2EBDE31D-12D9-1294-EF34-CA578AAFD2DD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73" creationId="{19AA2833-798E-32B9-EC81-698882C7C03C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75" creationId="{B7494CA8-BE8B-C73A-EF5C-2B3D649FE4B8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76" creationId="{4D11C825-2114-97B8-86E4-3BFBAA9DE036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78" creationId="{63FEEC07-7D58-D23A-8D39-CCC7B94C1C19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80" creationId="{906ECDBE-00FD-B0BF-ABB1-B34FEC9E1DF6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81" creationId="{8273BA44-9E36-CA75-DAF3-8B838E7BADB3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83" creationId="{D2638978-65AE-16DE-68DA-F5FCEC44CEF5}"/>
          </ac:spMkLst>
        </pc:spChg>
        <pc:spChg chg="add mod">
          <ac:chgData name="Sherry Hutchinson" userId="da25e8c2-4cfa-4a6f-b6d6-a8ac2a736b83" providerId="ADAL" clId="{70579AD9-A521-44EB-952E-5873134CDDB9}" dt="2023-07-09T21:01:39.490" v="3110" actId="1038"/>
          <ac:spMkLst>
            <pc:docMk/>
            <pc:sldMk cId="47547401" sldId="264"/>
            <ac:spMk id="84" creationId="{5B5D2A3F-43CF-6F73-3991-D9B3D010F694}"/>
          </ac:spMkLst>
        </pc:sp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3" creationId="{B3173A04-EAC8-83B7-27CF-7203417522E3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9" creationId="{EA32A644-ADF7-B3AD-56F1-67002BDA0FAA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11" creationId="{9EAB9FD3-C681-8A33-87B4-17D3640E56DB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13" creationId="{8D0F50BB-9373-11B6-C301-F59D51C8146F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15" creationId="{1D964070-965D-3CCF-A48B-0789629545EA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20" creationId="{35A77E48-FCCC-3D0F-3244-74D467909D7E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23" creationId="{B19D7140-13B2-90C7-E1AD-911648344B69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24" creationId="{2957F04C-09B4-CCCF-4D73-D3D7624C0075}"/>
          </ac:cxnSpMkLst>
        </pc:cxnChg>
        <pc:cxnChg chg="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25" creationId="{A327A96A-39C5-C698-FC91-0BCEBBCFF434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28" creationId="{FD272B4E-6928-3461-78A3-FB910F05331D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31" creationId="{54E0BBCF-8123-24C5-50CE-28B0484A1C5C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34" creationId="{2BFC792D-7D34-7B08-A7BE-FE329113102D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35" creationId="{72CB4352-44CB-7076-A306-5B0A7249E6F9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38" creationId="{EEC42CC0-D1EB-5857-9C6B-CEA1AB877236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41" creationId="{9CD9A3E7-4482-BDDE-65A8-FFE7B14D7205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43" creationId="{008F19A6-E355-ADC5-25D1-4DA5702658B6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45" creationId="{3CDF5CD2-8E8B-01D8-90D5-89720B458DDB}"/>
          </ac:cxnSpMkLst>
        </pc:cxnChg>
        <pc:cxnChg chg="del mod">
          <ac:chgData name="Sherry Hutchinson" userId="da25e8c2-4cfa-4a6f-b6d6-a8ac2a736b83" providerId="ADAL" clId="{70579AD9-A521-44EB-952E-5873134CDDB9}" dt="2023-07-09T20:41:26.684" v="2800" actId="478"/>
          <ac:cxnSpMkLst>
            <pc:docMk/>
            <pc:sldMk cId="47547401" sldId="264"/>
            <ac:cxnSpMk id="48" creationId="{8120B1FA-B943-29D0-D7B0-FCEB82E5EC66}"/>
          </ac:cxnSpMkLst>
        </pc:cxnChg>
        <pc:cxnChg chg="add del mod">
          <ac:chgData name="Sherry Hutchinson" userId="da25e8c2-4cfa-4a6f-b6d6-a8ac2a736b83" providerId="ADAL" clId="{70579AD9-A521-44EB-952E-5873134CDDB9}" dt="2023-07-09T20:31:56.634" v="2541"/>
          <ac:cxnSpMkLst>
            <pc:docMk/>
            <pc:sldMk cId="47547401" sldId="264"/>
            <ac:cxnSpMk id="51" creationId="{AEA49D5C-3184-0CCF-BB92-DC3192C36B02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55" creationId="{D0E01F58-DB43-1379-1967-F1848B6D2731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60" creationId="{F16BC9A9-378E-D3DA-3316-904892728C2C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61" creationId="{08D3627E-2E87-9238-B8CB-9A42A5D9C474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63" creationId="{C20B4CA9-38AF-821B-4DB0-554839B89E45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66" creationId="{2A6C174A-9E2C-3A0E-E44A-E57A78FF765D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69" creationId="{F48654A1-BF9E-99AD-22D5-A0D919A91CAC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71" creationId="{F1E4E0CC-9137-258A-2A6A-2C825E242B29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74" creationId="{3DCACE3B-257E-8891-6658-D237996CB62D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77" creationId="{E4C01555-70E7-76CA-5654-118C5765E3A6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79" creationId="{C51D8ABA-3191-BA5F-99F4-E4FE4CDE3C45}"/>
          </ac:cxnSpMkLst>
        </pc:cxnChg>
        <pc:cxnChg chg="add mod">
          <ac:chgData name="Sherry Hutchinson" userId="da25e8c2-4cfa-4a6f-b6d6-a8ac2a736b83" providerId="ADAL" clId="{70579AD9-A521-44EB-952E-5873134CDDB9}" dt="2023-07-09T21:01:39.490" v="3110" actId="1038"/>
          <ac:cxnSpMkLst>
            <pc:docMk/>
            <pc:sldMk cId="47547401" sldId="264"/>
            <ac:cxnSpMk id="82" creationId="{574C75BE-09E8-ACCE-B889-1D176BA0CDD1}"/>
          </ac:cxnSpMkLst>
        </pc:cxnChg>
      </pc:sldChg>
      <pc:sldChg chg="addSp delSp modSp mod">
        <pc:chgData name="Sherry Hutchinson" userId="da25e8c2-4cfa-4a6f-b6d6-a8ac2a736b83" providerId="ADAL" clId="{70579AD9-A521-44EB-952E-5873134CDDB9}" dt="2023-07-09T21:01:25.287" v="3061" actId="478"/>
        <pc:sldMkLst>
          <pc:docMk/>
          <pc:sldMk cId="2211045416" sldId="265"/>
        </pc:sldMkLst>
        <pc:spChg chg="add mod">
          <ac:chgData name="Sherry Hutchinson" userId="da25e8c2-4cfa-4a6f-b6d6-a8ac2a736b83" providerId="ADAL" clId="{70579AD9-A521-44EB-952E-5873134CDDB9}" dt="2023-07-09T20:58:48.677" v="3055" actId="208"/>
          <ac:spMkLst>
            <pc:docMk/>
            <pc:sldMk cId="2211045416" sldId="265"/>
            <ac:spMk id="2" creationId="{D107C53F-CC0A-1A69-EA67-5DF5ADA51F03}"/>
          </ac:spMkLst>
        </pc:spChg>
        <pc:spChg chg="add mod">
          <ac:chgData name="Sherry Hutchinson" userId="da25e8c2-4cfa-4a6f-b6d6-a8ac2a736b83" providerId="ADAL" clId="{70579AD9-A521-44EB-952E-5873134CDDB9}" dt="2023-07-09T20:58:00.439" v="3053" actId="2085"/>
          <ac:spMkLst>
            <pc:docMk/>
            <pc:sldMk cId="2211045416" sldId="265"/>
            <ac:spMk id="4" creationId="{268F6E88-E53D-ACF0-C30B-8E425240CB27}"/>
          </ac:spMkLst>
        </pc:spChg>
        <pc:spChg chg="mod">
          <ac:chgData name="Sherry Hutchinson" userId="da25e8c2-4cfa-4a6f-b6d6-a8ac2a736b83" providerId="ADAL" clId="{70579AD9-A521-44EB-952E-5873134CDDB9}" dt="2023-07-09T20:45:02.806" v="2886" actId="1037"/>
          <ac:spMkLst>
            <pc:docMk/>
            <pc:sldMk cId="2211045416" sldId="265"/>
            <ac:spMk id="5" creationId="{EE2587FD-7786-B36D-8FF9-0C339E1B82B4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6" creationId="{7DC470C7-4FF4-D342-99E8-E8F821044953}"/>
          </ac:spMkLst>
        </pc:spChg>
        <pc:spChg chg="add mod">
          <ac:chgData name="Sherry Hutchinson" userId="da25e8c2-4cfa-4a6f-b6d6-a8ac2a736b83" providerId="ADAL" clId="{70579AD9-A521-44EB-952E-5873134CDDB9}" dt="2023-07-09T20:58:48.677" v="3055" actId="208"/>
          <ac:spMkLst>
            <pc:docMk/>
            <pc:sldMk cId="2211045416" sldId="265"/>
            <ac:spMk id="7" creationId="{DF291371-2E71-E378-6953-A4B52C8E3310}"/>
          </ac:spMkLst>
        </pc:spChg>
        <pc:spChg chg="add mod">
          <ac:chgData name="Sherry Hutchinson" userId="da25e8c2-4cfa-4a6f-b6d6-a8ac2a736b83" providerId="ADAL" clId="{70579AD9-A521-44EB-952E-5873134CDDB9}" dt="2023-07-09T20:58:00.439" v="3053" actId="2085"/>
          <ac:spMkLst>
            <pc:docMk/>
            <pc:sldMk cId="2211045416" sldId="265"/>
            <ac:spMk id="11" creationId="{C1BB4954-C159-824A-F66B-7CE304CB943C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12" creationId="{87F66CB6-4E6C-859F-482C-E5DC7F7A965E}"/>
          </ac:spMkLst>
        </pc:spChg>
        <pc:spChg chg="add mod">
          <ac:chgData name="Sherry Hutchinson" userId="da25e8c2-4cfa-4a6f-b6d6-a8ac2a736b83" providerId="ADAL" clId="{70579AD9-A521-44EB-952E-5873134CDDB9}" dt="2023-07-09T20:57:44.782" v="3052" actId="207"/>
          <ac:spMkLst>
            <pc:docMk/>
            <pc:sldMk cId="2211045416" sldId="265"/>
            <ac:spMk id="13" creationId="{059CB0A5-2AEB-0CD2-8EEF-68BF20D8C13C}"/>
          </ac:spMkLst>
        </pc:spChg>
        <pc:spChg chg="add mod">
          <ac:chgData name="Sherry Hutchinson" userId="da25e8c2-4cfa-4a6f-b6d6-a8ac2a736b83" providerId="ADAL" clId="{70579AD9-A521-44EB-952E-5873134CDDB9}" dt="2023-07-09T20:57:44.782" v="3052" actId="207"/>
          <ac:spMkLst>
            <pc:docMk/>
            <pc:sldMk cId="2211045416" sldId="265"/>
            <ac:spMk id="14" creationId="{8FD5A5ED-4646-9231-DA8D-9EF9F314A8D7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16" creationId="{EF87472D-AF95-9A97-3335-2A576870F4F7}"/>
          </ac:spMkLst>
        </pc:spChg>
        <pc:spChg chg="add mod">
          <ac:chgData name="Sherry Hutchinson" userId="da25e8c2-4cfa-4a6f-b6d6-a8ac2a736b83" providerId="ADAL" clId="{70579AD9-A521-44EB-952E-5873134CDDB9}" dt="2023-07-09T20:58:00.439" v="3053" actId="2085"/>
          <ac:spMkLst>
            <pc:docMk/>
            <pc:sldMk cId="2211045416" sldId="265"/>
            <ac:spMk id="18" creationId="{73224180-6556-5A33-0DD6-E704D652B92B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19" creationId="{B7EA828D-B9F5-483E-9DAA-9B6D79B3EF02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21" creationId="{69413CA9-10F6-8DF5-AEBB-D60AA7105BDF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22" creationId="{9027035E-C213-D913-76AB-7F8408F8148A}"/>
          </ac:spMkLst>
        </pc:spChg>
        <pc:spChg chg="add mod">
          <ac:chgData name="Sherry Hutchinson" userId="da25e8c2-4cfa-4a6f-b6d6-a8ac2a736b83" providerId="ADAL" clId="{70579AD9-A521-44EB-952E-5873134CDDB9}" dt="2023-07-09T20:57:44.782" v="3052" actId="207"/>
          <ac:spMkLst>
            <pc:docMk/>
            <pc:sldMk cId="2211045416" sldId="265"/>
            <ac:spMk id="24" creationId="{5AE9F5F9-3266-7CC3-1305-FBB3C5C2216D}"/>
          </ac:spMkLst>
        </pc:spChg>
        <pc:spChg chg="add mod">
          <ac:chgData name="Sherry Hutchinson" userId="da25e8c2-4cfa-4a6f-b6d6-a8ac2a736b83" providerId="ADAL" clId="{70579AD9-A521-44EB-952E-5873134CDDB9}" dt="2023-07-09T20:58:00.439" v="3053" actId="2085"/>
          <ac:spMkLst>
            <pc:docMk/>
            <pc:sldMk cId="2211045416" sldId="265"/>
            <ac:spMk id="27" creationId="{D7EA0514-AAA5-2C3C-CFE6-7CDF1EDE4C1C}"/>
          </ac:spMkLst>
        </pc:spChg>
        <pc:spChg chg="add mod">
          <ac:chgData name="Sherry Hutchinson" userId="da25e8c2-4cfa-4a6f-b6d6-a8ac2a736b83" providerId="ADAL" clId="{70579AD9-A521-44EB-952E-5873134CDDB9}" dt="2023-07-09T20:57:44.782" v="3052" actId="207"/>
          <ac:spMkLst>
            <pc:docMk/>
            <pc:sldMk cId="2211045416" sldId="265"/>
            <ac:spMk id="28" creationId="{53A4ABF7-BB18-BE69-14FC-89C9C668E2D5}"/>
          </ac:spMkLst>
        </pc:spChg>
        <pc:spChg chg="add del mod">
          <ac:chgData name="Sherry Hutchinson" userId="da25e8c2-4cfa-4a6f-b6d6-a8ac2a736b83" providerId="ADAL" clId="{70579AD9-A521-44EB-952E-5873134CDDB9}" dt="2023-07-09T20:46:18.172" v="2895" actId="478"/>
          <ac:spMkLst>
            <pc:docMk/>
            <pc:sldMk cId="2211045416" sldId="265"/>
            <ac:spMk id="30" creationId="{1D4127C1-46A7-3148-28F3-C455BF6408DB}"/>
          </ac:spMkLst>
        </pc:spChg>
        <pc:spChg chg="add del mod">
          <ac:chgData name="Sherry Hutchinson" userId="da25e8c2-4cfa-4a6f-b6d6-a8ac2a736b83" providerId="ADAL" clId="{70579AD9-A521-44EB-952E-5873134CDDB9}" dt="2023-07-09T20:46:06.790" v="2894" actId="478"/>
          <ac:spMkLst>
            <pc:docMk/>
            <pc:sldMk cId="2211045416" sldId="265"/>
            <ac:spMk id="31" creationId="{1499659F-D553-DCF5-63F0-FEAA7271F8D9}"/>
          </ac:spMkLst>
        </pc:spChg>
        <pc:spChg chg="add del mod">
          <ac:chgData name="Sherry Hutchinson" userId="da25e8c2-4cfa-4a6f-b6d6-a8ac2a736b83" providerId="ADAL" clId="{70579AD9-A521-44EB-952E-5873134CDDB9}" dt="2023-07-09T20:45:58.794" v="2892" actId="478"/>
          <ac:spMkLst>
            <pc:docMk/>
            <pc:sldMk cId="2211045416" sldId="265"/>
            <ac:spMk id="32" creationId="{44D758EC-C9EB-F3EA-ED07-6121C2A6B8E4}"/>
          </ac:spMkLst>
        </pc:spChg>
        <pc:spChg chg="add del mod">
          <ac:chgData name="Sherry Hutchinson" userId="da25e8c2-4cfa-4a6f-b6d6-a8ac2a736b83" providerId="ADAL" clId="{70579AD9-A521-44EB-952E-5873134CDDB9}" dt="2023-07-09T20:46:02.142" v="2893" actId="478"/>
          <ac:spMkLst>
            <pc:docMk/>
            <pc:sldMk cId="2211045416" sldId="265"/>
            <ac:spMk id="35" creationId="{7FF692E0-6619-2178-A17D-7DE97A7CB941}"/>
          </ac:spMkLst>
        </pc:spChg>
        <pc:spChg chg="add del mod">
          <ac:chgData name="Sherry Hutchinson" userId="da25e8c2-4cfa-4a6f-b6d6-a8ac2a736b83" providerId="ADAL" clId="{70579AD9-A521-44EB-952E-5873134CDDB9}" dt="2023-07-09T20:45:58.794" v="2892" actId="478"/>
          <ac:spMkLst>
            <pc:docMk/>
            <pc:sldMk cId="2211045416" sldId="265"/>
            <ac:spMk id="36" creationId="{37D8016C-1D2A-C4E7-E4E7-F50E15DA14F1}"/>
          </ac:spMkLst>
        </pc:spChg>
        <pc:spChg chg="add del mod">
          <ac:chgData name="Sherry Hutchinson" userId="da25e8c2-4cfa-4a6f-b6d6-a8ac2a736b83" providerId="ADAL" clId="{70579AD9-A521-44EB-952E-5873134CDDB9}" dt="2023-07-09T20:47:04.573" v="2898" actId="478"/>
          <ac:spMkLst>
            <pc:docMk/>
            <pc:sldMk cId="2211045416" sldId="265"/>
            <ac:spMk id="38" creationId="{BD7B23AD-0AC2-7981-BF1D-4BCBBB8B1412}"/>
          </ac:spMkLst>
        </pc:spChg>
        <pc:spChg chg="add del mod">
          <ac:chgData name="Sherry Hutchinson" userId="da25e8c2-4cfa-4a6f-b6d6-a8ac2a736b83" providerId="ADAL" clId="{70579AD9-A521-44EB-952E-5873134CDDB9}" dt="2023-07-09T20:45:58.794" v="2892" actId="478"/>
          <ac:spMkLst>
            <pc:docMk/>
            <pc:sldMk cId="2211045416" sldId="265"/>
            <ac:spMk id="41" creationId="{618A100F-68FB-1DA3-2E04-237A5A22A03E}"/>
          </ac:spMkLst>
        </pc:spChg>
        <pc:spChg chg="add del mod">
          <ac:chgData name="Sherry Hutchinson" userId="da25e8c2-4cfa-4a6f-b6d6-a8ac2a736b83" providerId="ADAL" clId="{70579AD9-A521-44EB-952E-5873134CDDB9}" dt="2023-07-09T20:45:58.794" v="2892" actId="478"/>
          <ac:spMkLst>
            <pc:docMk/>
            <pc:sldMk cId="2211045416" sldId="265"/>
            <ac:spMk id="42" creationId="{1751610E-FFAE-3C9C-F425-B1251E79B26C}"/>
          </ac:spMkLst>
        </pc:spChg>
        <pc:spChg chg="add del mod">
          <ac:chgData name="Sherry Hutchinson" userId="da25e8c2-4cfa-4a6f-b6d6-a8ac2a736b83" providerId="ADAL" clId="{70579AD9-A521-44EB-952E-5873134CDDB9}" dt="2023-07-09T20:46:54.734" v="2897" actId="478"/>
          <ac:spMkLst>
            <pc:docMk/>
            <pc:sldMk cId="2211045416" sldId="265"/>
            <ac:spMk id="43" creationId="{825446A2-196D-52A4-6679-B3C6C0792E28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44" creationId="{6ED0E8A2-16FD-45A7-2EAD-103F52E1B771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46" creationId="{8EE99552-126D-51A7-89E3-1E4546488C94}"/>
          </ac:spMkLst>
        </pc:spChg>
        <pc:spChg chg="del mod">
          <ac:chgData name="Sherry Hutchinson" userId="da25e8c2-4cfa-4a6f-b6d6-a8ac2a736b83" providerId="ADAL" clId="{70579AD9-A521-44EB-952E-5873134CDDB9}" dt="2023-07-09T21:01:25.287" v="3061" actId="478"/>
          <ac:spMkLst>
            <pc:docMk/>
            <pc:sldMk cId="2211045416" sldId="265"/>
            <ac:spMk id="47" creationId="{047F0D2D-ADE3-DA91-A500-37C654E004E0}"/>
          </ac:spMkLst>
        </pc:spChg>
        <pc:spChg chg="add del mod">
          <ac:chgData name="Sherry Hutchinson" userId="da25e8c2-4cfa-4a6f-b6d6-a8ac2a736b83" providerId="ADAL" clId="{70579AD9-A521-44EB-952E-5873134CDDB9}" dt="2023-07-09T20:46:45.837" v="2896" actId="478"/>
          <ac:spMkLst>
            <pc:docMk/>
            <pc:sldMk cId="2211045416" sldId="265"/>
            <ac:spMk id="48" creationId="{922FCBD9-55E7-1D7C-60F3-EC334E85C7E6}"/>
          </ac:spMkLst>
        </pc:spChg>
        <pc:spChg chg="add mod">
          <ac:chgData name="Sherry Hutchinson" userId="da25e8c2-4cfa-4a6f-b6d6-a8ac2a736b83" providerId="ADAL" clId="{70579AD9-A521-44EB-952E-5873134CDDB9}" dt="2023-07-09T20:50:01.943" v="2951" actId="1036"/>
          <ac:spMkLst>
            <pc:docMk/>
            <pc:sldMk cId="2211045416" sldId="265"/>
            <ac:spMk id="51" creationId="{FDBBACF5-BC07-9EE5-E0A2-4D436561ABC0}"/>
          </ac:spMkLst>
        </pc:spChg>
        <pc:spChg chg="add mod">
          <ac:chgData name="Sherry Hutchinson" userId="da25e8c2-4cfa-4a6f-b6d6-a8ac2a736b83" providerId="ADAL" clId="{70579AD9-A521-44EB-952E-5873134CDDB9}" dt="2023-07-09T20:50:01.943" v="2951" actId="1036"/>
          <ac:spMkLst>
            <pc:docMk/>
            <pc:sldMk cId="2211045416" sldId="265"/>
            <ac:spMk id="53" creationId="{D2995232-6368-58D3-862C-DCCFC3C738AC}"/>
          </ac:spMkLst>
        </pc:spChg>
        <pc:spChg chg="add mod">
          <ac:chgData name="Sherry Hutchinson" userId="da25e8c2-4cfa-4a6f-b6d6-a8ac2a736b83" providerId="ADAL" clId="{70579AD9-A521-44EB-952E-5873134CDDB9}" dt="2023-07-09T20:50:01.943" v="2951" actId="1036"/>
          <ac:spMkLst>
            <pc:docMk/>
            <pc:sldMk cId="2211045416" sldId="265"/>
            <ac:spMk id="54" creationId="{9554DEAA-C486-E73C-9400-6D34702CDAD8}"/>
          </ac:spMkLst>
        </pc:spChg>
        <pc:spChg chg="add mod">
          <ac:chgData name="Sherry Hutchinson" userId="da25e8c2-4cfa-4a6f-b6d6-a8ac2a736b83" providerId="ADAL" clId="{70579AD9-A521-44EB-952E-5873134CDDB9}" dt="2023-07-09T20:50:01.943" v="2951" actId="1036"/>
          <ac:spMkLst>
            <pc:docMk/>
            <pc:sldMk cId="2211045416" sldId="265"/>
            <ac:spMk id="56" creationId="{FD10C9C9-7D10-52B4-8EBD-EB1CBAAD3E03}"/>
          </ac:spMkLst>
        </pc:spChg>
        <pc:spChg chg="add mod">
          <ac:chgData name="Sherry Hutchinson" userId="da25e8c2-4cfa-4a6f-b6d6-a8ac2a736b83" providerId="ADAL" clId="{70579AD9-A521-44EB-952E-5873134CDDB9}" dt="2023-07-09T20:50:01.943" v="2951" actId="1036"/>
          <ac:spMkLst>
            <pc:docMk/>
            <pc:sldMk cId="2211045416" sldId="265"/>
            <ac:spMk id="57" creationId="{BC5ABEEA-8FD7-5B6B-6879-0676313F4EE7}"/>
          </ac:spMkLst>
        </pc:spChg>
        <pc:spChg chg="add mod">
          <ac:chgData name="Sherry Hutchinson" userId="da25e8c2-4cfa-4a6f-b6d6-a8ac2a736b83" providerId="ADAL" clId="{70579AD9-A521-44EB-952E-5873134CDDB9}" dt="2023-07-09T20:58:48.677" v="3055" actId="208"/>
          <ac:spMkLst>
            <pc:docMk/>
            <pc:sldMk cId="2211045416" sldId="265"/>
            <ac:spMk id="58" creationId="{28FF8D00-24CC-CDF5-9740-E9399052590A}"/>
          </ac:spMkLst>
        </pc:spChg>
        <pc:spChg chg="add mod">
          <ac:chgData name="Sherry Hutchinson" userId="da25e8c2-4cfa-4a6f-b6d6-a8ac2a736b83" providerId="ADAL" clId="{70579AD9-A521-44EB-952E-5873134CDDB9}" dt="2023-07-09T20:58:00.439" v="3053" actId="2085"/>
          <ac:spMkLst>
            <pc:docMk/>
            <pc:sldMk cId="2211045416" sldId="265"/>
            <ac:spMk id="60" creationId="{3EA71C80-F311-F402-EE2D-A834121789E1}"/>
          </ac:spMkLst>
        </pc:spChg>
        <pc:spChg chg="add mod">
          <ac:chgData name="Sherry Hutchinson" userId="da25e8c2-4cfa-4a6f-b6d6-a8ac2a736b83" providerId="ADAL" clId="{70579AD9-A521-44EB-952E-5873134CDDB9}" dt="2023-07-09T20:57:44.782" v="3052" actId="207"/>
          <ac:spMkLst>
            <pc:docMk/>
            <pc:sldMk cId="2211045416" sldId="265"/>
            <ac:spMk id="61" creationId="{E239B4EE-CB4C-74FC-6818-8E38002FB8BE}"/>
          </ac:spMkLst>
        </pc:spChg>
        <pc:spChg chg="add mod">
          <ac:chgData name="Sherry Hutchinson" userId="da25e8c2-4cfa-4a6f-b6d6-a8ac2a736b83" providerId="ADAL" clId="{70579AD9-A521-44EB-952E-5873134CDDB9}" dt="2023-07-09T20:58:00.439" v="3053" actId="2085"/>
          <ac:spMkLst>
            <pc:docMk/>
            <pc:sldMk cId="2211045416" sldId="265"/>
            <ac:spMk id="63" creationId="{F7CCEB5E-5DB0-B4C4-1939-B19746D8E63D}"/>
          </ac:spMkLst>
        </pc:spChg>
        <pc:spChg chg="add mod">
          <ac:chgData name="Sherry Hutchinson" userId="da25e8c2-4cfa-4a6f-b6d6-a8ac2a736b83" providerId="ADAL" clId="{70579AD9-A521-44EB-952E-5873134CDDB9}" dt="2023-07-09T20:58:48.677" v="3055" actId="208"/>
          <ac:spMkLst>
            <pc:docMk/>
            <pc:sldMk cId="2211045416" sldId="265"/>
            <ac:spMk id="64" creationId="{EDF8AABA-2518-00FA-AABA-7F12821E07F5}"/>
          </ac:spMkLst>
        </pc:spChg>
        <pc:spChg chg="add del mod">
          <ac:chgData name="Sherry Hutchinson" userId="da25e8c2-4cfa-4a6f-b6d6-a8ac2a736b83" providerId="ADAL" clId="{70579AD9-A521-44EB-952E-5873134CDDB9}" dt="2023-07-09T20:50:46.892" v="2952" actId="478"/>
          <ac:spMkLst>
            <pc:docMk/>
            <pc:sldMk cId="2211045416" sldId="265"/>
            <ac:spMk id="66" creationId="{110295E8-4F66-DB9D-8BC5-4F6754FC6BD6}"/>
          </ac:spMkLst>
        </pc:spChg>
        <pc:spChg chg="add mod">
          <ac:chgData name="Sherry Hutchinson" userId="da25e8c2-4cfa-4a6f-b6d6-a8ac2a736b83" providerId="ADAL" clId="{70579AD9-A521-44EB-952E-5873134CDDB9}" dt="2023-07-09T20:58:48.677" v="3055" actId="208"/>
          <ac:spMkLst>
            <pc:docMk/>
            <pc:sldMk cId="2211045416" sldId="265"/>
            <ac:spMk id="67" creationId="{E1B6FA2C-43E9-A014-AA4C-F7E0CA9D6C1D}"/>
          </ac:spMkLst>
        </pc:spChg>
        <pc:spChg chg="add mod">
          <ac:chgData name="Sherry Hutchinson" userId="da25e8c2-4cfa-4a6f-b6d6-a8ac2a736b83" providerId="ADAL" clId="{70579AD9-A521-44EB-952E-5873134CDDB9}" dt="2023-07-09T20:56:40.999" v="3049" actId="1037"/>
          <ac:spMkLst>
            <pc:docMk/>
            <pc:sldMk cId="2211045416" sldId="265"/>
            <ac:spMk id="69" creationId="{1FCB335A-6F76-7F9D-6402-E872728EA17F}"/>
          </ac:spMkLst>
        </pc:spChg>
        <pc:spChg chg="add mod">
          <ac:chgData name="Sherry Hutchinson" userId="da25e8c2-4cfa-4a6f-b6d6-a8ac2a736b83" providerId="ADAL" clId="{70579AD9-A521-44EB-952E-5873134CDDB9}" dt="2023-07-09T20:55:45.296" v="3042" actId="555"/>
          <ac:spMkLst>
            <pc:docMk/>
            <pc:sldMk cId="2211045416" sldId="265"/>
            <ac:spMk id="70" creationId="{6FEE1AC6-F49C-31CF-BD57-06EBF620317E}"/>
          </ac:spMkLst>
        </pc:spChg>
        <pc:spChg chg="add del mod">
          <ac:chgData name="Sherry Hutchinson" userId="da25e8c2-4cfa-4a6f-b6d6-a8ac2a736b83" providerId="ADAL" clId="{70579AD9-A521-44EB-952E-5873134CDDB9}" dt="2023-07-09T20:50:46.892" v="2952" actId="478"/>
          <ac:spMkLst>
            <pc:docMk/>
            <pc:sldMk cId="2211045416" sldId="265"/>
            <ac:spMk id="72" creationId="{D6AED94C-A707-EB88-D7F4-551FDB52EFD1}"/>
          </ac:spMkLst>
        </pc:spChg>
        <pc:spChg chg="add mod">
          <ac:chgData name="Sherry Hutchinson" userId="da25e8c2-4cfa-4a6f-b6d6-a8ac2a736b83" providerId="ADAL" clId="{70579AD9-A521-44EB-952E-5873134CDDB9}" dt="2023-07-09T20:55:07.589" v="3041" actId="1037"/>
          <ac:spMkLst>
            <pc:docMk/>
            <pc:sldMk cId="2211045416" sldId="265"/>
            <ac:spMk id="75" creationId="{45269AC6-3327-BA09-1880-F64C237D4542}"/>
          </ac:spMkLst>
        </pc:spChg>
        <pc:spChg chg="add mod">
          <ac:chgData name="Sherry Hutchinson" userId="da25e8c2-4cfa-4a6f-b6d6-a8ac2a736b83" providerId="ADAL" clId="{70579AD9-A521-44EB-952E-5873134CDDB9}" dt="2023-07-09T20:59:41.920" v="3058" actId="207"/>
          <ac:spMkLst>
            <pc:docMk/>
            <pc:sldMk cId="2211045416" sldId="265"/>
            <ac:spMk id="76" creationId="{BC111614-939E-3E8D-ACC6-CF11829EE4B4}"/>
          </ac:spMkLst>
        </pc:spChg>
        <pc:spChg chg="add del mod">
          <ac:chgData name="Sherry Hutchinson" userId="da25e8c2-4cfa-4a6f-b6d6-a8ac2a736b83" providerId="ADAL" clId="{70579AD9-A521-44EB-952E-5873134CDDB9}" dt="2023-07-09T20:50:46.892" v="2952" actId="478"/>
          <ac:spMkLst>
            <pc:docMk/>
            <pc:sldMk cId="2211045416" sldId="265"/>
            <ac:spMk id="77" creationId="{2165B855-BC2A-478A-32AA-3B6D1DDEC7D2}"/>
          </ac:spMkLst>
        </pc:spChg>
        <pc:spChg chg="add del mod">
          <ac:chgData name="Sherry Hutchinson" userId="da25e8c2-4cfa-4a6f-b6d6-a8ac2a736b83" providerId="ADAL" clId="{70579AD9-A521-44EB-952E-5873134CDDB9}" dt="2023-07-09T20:50:46.892" v="2952" actId="478"/>
          <ac:spMkLst>
            <pc:docMk/>
            <pc:sldMk cId="2211045416" sldId="265"/>
            <ac:spMk id="78" creationId="{7F5E05ED-E836-64C8-D057-2D31F4D0E6BF}"/>
          </ac:spMkLst>
        </pc:spChg>
        <pc:spChg chg="add del mod">
          <ac:chgData name="Sherry Hutchinson" userId="da25e8c2-4cfa-4a6f-b6d6-a8ac2a736b83" providerId="ADAL" clId="{70579AD9-A521-44EB-952E-5873134CDDB9}" dt="2023-07-09T20:50:54.979" v="2954" actId="478"/>
          <ac:spMkLst>
            <pc:docMk/>
            <pc:sldMk cId="2211045416" sldId="265"/>
            <ac:spMk id="81" creationId="{67D2198B-1D1C-9F9E-0EA6-22EBDD50FB86}"/>
          </ac:spMkLst>
        </pc:spChg>
        <pc:spChg chg="add del mod">
          <ac:chgData name="Sherry Hutchinson" userId="da25e8c2-4cfa-4a6f-b6d6-a8ac2a736b83" providerId="ADAL" clId="{70579AD9-A521-44EB-952E-5873134CDDB9}" dt="2023-07-09T20:50:52.548" v="2953" actId="478"/>
          <ac:spMkLst>
            <pc:docMk/>
            <pc:sldMk cId="2211045416" sldId="265"/>
            <ac:spMk id="83" creationId="{94D3D4A6-11F8-2F58-1FE3-BD04958484BF}"/>
          </ac:spMkLst>
        </pc:spChg>
        <pc:spChg chg="add del mod">
          <ac:chgData name="Sherry Hutchinson" userId="da25e8c2-4cfa-4a6f-b6d6-a8ac2a736b83" providerId="ADAL" clId="{70579AD9-A521-44EB-952E-5873134CDDB9}" dt="2023-07-09T20:50:57.385" v="2955" actId="478"/>
          <ac:spMkLst>
            <pc:docMk/>
            <pc:sldMk cId="2211045416" sldId="265"/>
            <ac:spMk id="84" creationId="{7C2C820F-732A-6A4B-3348-C6A7F99450A2}"/>
          </ac:spMkLst>
        </pc:spChg>
        <pc:spChg chg="add del mod">
          <ac:chgData name="Sherry Hutchinson" userId="da25e8c2-4cfa-4a6f-b6d6-a8ac2a736b83" providerId="ADAL" clId="{70579AD9-A521-44EB-952E-5873134CDDB9}" dt="2023-07-09T20:51:00.679" v="2956" actId="478"/>
          <ac:spMkLst>
            <pc:docMk/>
            <pc:sldMk cId="2211045416" sldId="265"/>
            <ac:spMk id="86" creationId="{9D4623E6-57F2-E994-A56A-B037FE245D0A}"/>
          </ac:spMkLst>
        </pc:spChg>
        <pc:spChg chg="add del mod">
          <ac:chgData name="Sherry Hutchinson" userId="da25e8c2-4cfa-4a6f-b6d6-a8ac2a736b83" providerId="ADAL" clId="{70579AD9-A521-44EB-952E-5873134CDDB9}" dt="2023-07-09T20:50:52.548" v="2953" actId="478"/>
          <ac:spMkLst>
            <pc:docMk/>
            <pc:sldMk cId="2211045416" sldId="265"/>
            <ac:spMk id="87" creationId="{C045690B-2760-5BB4-1BB6-CA0A1540C0CB}"/>
          </ac:spMkLst>
        </pc:spChg>
        <pc:spChg chg="add mod">
          <ac:chgData name="Sherry Hutchinson" userId="da25e8c2-4cfa-4a6f-b6d6-a8ac2a736b83" providerId="ADAL" clId="{70579AD9-A521-44EB-952E-5873134CDDB9}" dt="2023-07-09T20:52:11.686" v="2980"/>
          <ac:spMkLst>
            <pc:docMk/>
            <pc:sldMk cId="2211045416" sldId="265"/>
            <ac:spMk id="89" creationId="{2F584839-C4EF-E08B-0C51-361B76F20187}"/>
          </ac:spMkLst>
        </pc:spChg>
        <pc:spChg chg="add mod">
          <ac:chgData name="Sherry Hutchinson" userId="da25e8c2-4cfa-4a6f-b6d6-a8ac2a736b83" providerId="ADAL" clId="{70579AD9-A521-44EB-952E-5873134CDDB9}" dt="2023-07-09T20:56:23.929" v="3045" actId="1038"/>
          <ac:spMkLst>
            <pc:docMk/>
            <pc:sldMk cId="2211045416" sldId="265"/>
            <ac:spMk id="91" creationId="{EC55D7FB-BB7B-F44C-667F-0A7EF50F5DF8}"/>
          </ac:spMkLst>
        </pc:spChg>
        <pc:spChg chg="add mod">
          <ac:chgData name="Sherry Hutchinson" userId="da25e8c2-4cfa-4a6f-b6d6-a8ac2a736b83" providerId="ADAL" clId="{70579AD9-A521-44EB-952E-5873134CDDB9}" dt="2023-07-09T20:56:23.929" v="3045" actId="1038"/>
          <ac:spMkLst>
            <pc:docMk/>
            <pc:sldMk cId="2211045416" sldId="265"/>
            <ac:spMk id="92" creationId="{A03FC1D0-317F-8086-253B-9C011EEB6699}"/>
          </ac:spMkLst>
        </pc:spChg>
        <pc:spChg chg="add mod">
          <ac:chgData name="Sherry Hutchinson" userId="da25e8c2-4cfa-4a6f-b6d6-a8ac2a736b83" providerId="ADAL" clId="{70579AD9-A521-44EB-952E-5873134CDDB9}" dt="2023-07-09T20:55:45.296" v="3042" actId="555"/>
          <ac:spMkLst>
            <pc:docMk/>
            <pc:sldMk cId="2211045416" sldId="265"/>
            <ac:spMk id="94" creationId="{395CC255-8289-3109-D268-A68AF33C7422}"/>
          </ac:spMkLst>
        </pc:spChg>
        <pc:spChg chg="add del mod">
          <ac:chgData name="Sherry Hutchinson" userId="da25e8c2-4cfa-4a6f-b6d6-a8ac2a736b83" providerId="ADAL" clId="{70579AD9-A521-44EB-952E-5873134CDDB9}" dt="2023-07-09T20:50:46.892" v="2952" actId="478"/>
          <ac:spMkLst>
            <pc:docMk/>
            <pc:sldMk cId="2211045416" sldId="265"/>
            <ac:spMk id="95" creationId="{AFCABCE4-E44C-A11C-FCA3-D57DBDA5FE73}"/>
          </ac:spMkLst>
        </pc:spChg>
        <pc:spChg chg="add mod">
          <ac:chgData name="Sherry Hutchinson" userId="da25e8c2-4cfa-4a6f-b6d6-a8ac2a736b83" providerId="ADAL" clId="{70579AD9-A521-44EB-952E-5873134CDDB9}" dt="2023-07-09T20:54:23.285" v="3028" actId="20577"/>
          <ac:spMkLst>
            <pc:docMk/>
            <pc:sldMk cId="2211045416" sldId="265"/>
            <ac:spMk id="96" creationId="{9CA8D7B9-6961-861C-7AD9-8515B9664CF9}"/>
          </ac:spMkLst>
        </pc:spChg>
        <pc:cxnChg chg="add mod">
          <ac:chgData name="Sherry Hutchinson" userId="da25e8c2-4cfa-4a6f-b6d6-a8ac2a736b83" providerId="ADAL" clId="{70579AD9-A521-44EB-952E-5873134CDDB9}" dt="2023-07-09T20:59:32.141" v="3057" actId="1582"/>
          <ac:cxnSpMkLst>
            <pc:docMk/>
            <pc:sldMk cId="2211045416" sldId="265"/>
            <ac:cxnSpMk id="3" creationId="{CB197F64-354D-2493-BBEE-02478F9DC056}"/>
          </ac:cxnSpMkLst>
        </pc:cxnChg>
        <pc:cxnChg chg="add mod">
          <ac:chgData name="Sherry Hutchinson" userId="da25e8c2-4cfa-4a6f-b6d6-a8ac2a736b83" providerId="ADAL" clId="{70579AD9-A521-44EB-952E-5873134CDDB9}" dt="2023-07-09T20:59:32.141" v="3057" actId="1582"/>
          <ac:cxnSpMkLst>
            <pc:docMk/>
            <pc:sldMk cId="2211045416" sldId="265"/>
            <ac:cxnSpMk id="8" creationId="{196F66CD-7CF1-227C-CDE0-B6B3BD522C86}"/>
          </ac:cxnSpMkLst>
        </pc:cxnChg>
        <pc:cxnChg chg="del mod">
          <ac:chgData name="Sherry Hutchinson" userId="da25e8c2-4cfa-4a6f-b6d6-a8ac2a736b83" providerId="ADAL" clId="{70579AD9-A521-44EB-952E-5873134CDDB9}" dt="2023-07-09T21:01:25.287" v="3061" actId="478"/>
          <ac:cxnSpMkLst>
            <pc:docMk/>
            <pc:sldMk cId="2211045416" sldId="265"/>
            <ac:cxnSpMk id="9" creationId="{EA32A644-ADF7-B3AD-56F1-67002BDA0FAA}"/>
          </ac:cxnSpMkLst>
        </pc:cxnChg>
        <pc:cxnChg chg="add mod">
          <ac:chgData name="Sherry Hutchinson" userId="da25e8c2-4cfa-4a6f-b6d6-a8ac2a736b83" providerId="ADAL" clId="{70579AD9-A521-44EB-952E-5873134CDDB9}" dt="2023-07-09T21:00:25.736" v="3059" actId="208"/>
          <ac:cxnSpMkLst>
            <pc:docMk/>
            <pc:sldMk cId="2211045416" sldId="265"/>
            <ac:cxnSpMk id="10" creationId="{4DB65CFB-C474-3AD7-DE7C-29E908D8C6D2}"/>
          </ac:cxnSpMkLst>
        </pc:cxnChg>
        <pc:cxnChg chg="add mod">
          <ac:chgData name="Sherry Hutchinson" userId="da25e8c2-4cfa-4a6f-b6d6-a8ac2a736b83" providerId="ADAL" clId="{70579AD9-A521-44EB-952E-5873134CDDB9}" dt="2023-07-09T21:00:25.736" v="3059" actId="208"/>
          <ac:cxnSpMkLst>
            <pc:docMk/>
            <pc:sldMk cId="2211045416" sldId="265"/>
            <ac:cxnSpMk id="15" creationId="{59BD8A38-B2F8-696C-06E2-146D81C77B77}"/>
          </ac:cxnSpMkLst>
        </pc:cxnChg>
        <pc:cxnChg chg="add mod">
          <ac:chgData name="Sherry Hutchinson" userId="da25e8c2-4cfa-4a6f-b6d6-a8ac2a736b83" providerId="ADAL" clId="{70579AD9-A521-44EB-952E-5873134CDDB9}" dt="2023-07-09T21:00:43.258" v="3060" actId="208"/>
          <ac:cxnSpMkLst>
            <pc:docMk/>
            <pc:sldMk cId="2211045416" sldId="265"/>
            <ac:cxnSpMk id="17" creationId="{AD2E331D-4D06-E363-A718-8A98B98802D3}"/>
          </ac:cxnSpMkLst>
        </pc:cxnChg>
        <pc:cxnChg chg="del mod">
          <ac:chgData name="Sherry Hutchinson" userId="da25e8c2-4cfa-4a6f-b6d6-a8ac2a736b83" providerId="ADAL" clId="{70579AD9-A521-44EB-952E-5873134CDDB9}" dt="2023-07-09T21:01:25.287" v="3061" actId="478"/>
          <ac:cxnSpMkLst>
            <pc:docMk/>
            <pc:sldMk cId="2211045416" sldId="265"/>
            <ac:cxnSpMk id="20" creationId="{35A77E48-FCCC-3D0F-3244-74D467909D7E}"/>
          </ac:cxnSpMkLst>
        </pc:cxnChg>
        <pc:cxnChg chg="del mod">
          <ac:chgData name="Sherry Hutchinson" userId="da25e8c2-4cfa-4a6f-b6d6-a8ac2a736b83" providerId="ADAL" clId="{70579AD9-A521-44EB-952E-5873134CDDB9}" dt="2023-07-09T21:01:25.287" v="3061" actId="478"/>
          <ac:cxnSpMkLst>
            <pc:docMk/>
            <pc:sldMk cId="2211045416" sldId="265"/>
            <ac:cxnSpMk id="23" creationId="{B19D7140-13B2-90C7-E1AD-911648344B69}"/>
          </ac:cxnSpMkLst>
        </pc:cxnChg>
        <pc:cxnChg chg="mod">
          <ac:chgData name="Sherry Hutchinson" userId="da25e8c2-4cfa-4a6f-b6d6-a8ac2a736b83" providerId="ADAL" clId="{70579AD9-A521-44EB-952E-5873134CDDB9}" dt="2023-07-09T20:45:02.806" v="2886" actId="1037"/>
          <ac:cxnSpMkLst>
            <pc:docMk/>
            <pc:sldMk cId="2211045416" sldId="265"/>
            <ac:cxnSpMk id="25" creationId="{A327A96A-39C5-C698-FC91-0BCEBBCFF434}"/>
          </ac:cxnSpMkLst>
        </pc:cxnChg>
        <pc:cxnChg chg="add mod">
          <ac:chgData name="Sherry Hutchinson" userId="da25e8c2-4cfa-4a6f-b6d6-a8ac2a736b83" providerId="ADAL" clId="{70579AD9-A521-44EB-952E-5873134CDDB9}" dt="2023-07-09T21:00:25.736" v="3059" actId="208"/>
          <ac:cxnSpMkLst>
            <pc:docMk/>
            <pc:sldMk cId="2211045416" sldId="265"/>
            <ac:cxnSpMk id="26" creationId="{3D2645FD-7328-0F77-E06D-FA14AA6DF437}"/>
          </ac:cxnSpMkLst>
        </pc:cxnChg>
        <pc:cxnChg chg="add del mod">
          <ac:chgData name="Sherry Hutchinson" userId="da25e8c2-4cfa-4a6f-b6d6-a8ac2a736b83" providerId="ADAL" clId="{70579AD9-A521-44EB-952E-5873134CDDB9}" dt="2023-07-09T20:46:06.790" v="2894" actId="478"/>
          <ac:cxnSpMkLst>
            <pc:docMk/>
            <pc:sldMk cId="2211045416" sldId="265"/>
            <ac:cxnSpMk id="29" creationId="{41D55514-D4DE-8C6C-49BB-08761A8F6736}"/>
          </ac:cxnSpMkLst>
        </pc:cxnChg>
        <pc:cxnChg chg="add del mod">
          <ac:chgData name="Sherry Hutchinson" userId="da25e8c2-4cfa-4a6f-b6d6-a8ac2a736b83" providerId="ADAL" clId="{70579AD9-A521-44EB-952E-5873134CDDB9}" dt="2023-07-09T20:45:58.794" v="2892" actId="478"/>
          <ac:cxnSpMkLst>
            <pc:docMk/>
            <pc:sldMk cId="2211045416" sldId="265"/>
            <ac:cxnSpMk id="33" creationId="{13A24AE2-23BA-09D2-A2E9-23AEECDC1653}"/>
          </ac:cxnSpMkLst>
        </pc:cxnChg>
        <pc:cxnChg chg="del mod">
          <ac:chgData name="Sherry Hutchinson" userId="da25e8c2-4cfa-4a6f-b6d6-a8ac2a736b83" providerId="ADAL" clId="{70579AD9-A521-44EB-952E-5873134CDDB9}" dt="2023-07-09T21:01:25.287" v="3061" actId="478"/>
          <ac:cxnSpMkLst>
            <pc:docMk/>
            <pc:sldMk cId="2211045416" sldId="265"/>
            <ac:cxnSpMk id="34" creationId="{2BFC792D-7D34-7B08-A7BE-FE329113102D}"/>
          </ac:cxnSpMkLst>
        </pc:cxnChg>
        <pc:cxnChg chg="add del mod">
          <ac:chgData name="Sherry Hutchinson" userId="da25e8c2-4cfa-4a6f-b6d6-a8ac2a736b83" providerId="ADAL" clId="{70579AD9-A521-44EB-952E-5873134CDDB9}" dt="2023-07-09T20:46:06.790" v="2894" actId="478"/>
          <ac:cxnSpMkLst>
            <pc:docMk/>
            <pc:sldMk cId="2211045416" sldId="265"/>
            <ac:cxnSpMk id="37" creationId="{2D1F46D1-834F-10E7-0A8F-5A2C92A7801F}"/>
          </ac:cxnSpMkLst>
        </pc:cxnChg>
        <pc:cxnChg chg="add del mod">
          <ac:chgData name="Sherry Hutchinson" userId="da25e8c2-4cfa-4a6f-b6d6-a8ac2a736b83" providerId="ADAL" clId="{70579AD9-A521-44EB-952E-5873134CDDB9}" dt="2023-07-09T20:47:08.696" v="2899" actId="478"/>
          <ac:cxnSpMkLst>
            <pc:docMk/>
            <pc:sldMk cId="2211045416" sldId="265"/>
            <ac:cxnSpMk id="39" creationId="{B4438F39-187B-F7DE-A82D-DBE0D505E337}"/>
          </ac:cxnSpMkLst>
        </pc:cxnChg>
        <pc:cxnChg chg="add del mod">
          <ac:chgData name="Sherry Hutchinson" userId="da25e8c2-4cfa-4a6f-b6d6-a8ac2a736b83" providerId="ADAL" clId="{70579AD9-A521-44EB-952E-5873134CDDB9}" dt="2023-07-09T20:45:58.794" v="2892" actId="478"/>
          <ac:cxnSpMkLst>
            <pc:docMk/>
            <pc:sldMk cId="2211045416" sldId="265"/>
            <ac:cxnSpMk id="40" creationId="{A51E0456-C749-83A6-ACFD-F9760BCB4CEB}"/>
          </ac:cxnSpMkLst>
        </pc:cxnChg>
        <pc:cxnChg chg="del mod">
          <ac:chgData name="Sherry Hutchinson" userId="da25e8c2-4cfa-4a6f-b6d6-a8ac2a736b83" providerId="ADAL" clId="{70579AD9-A521-44EB-952E-5873134CDDB9}" dt="2023-07-09T21:01:25.287" v="3061" actId="478"/>
          <ac:cxnSpMkLst>
            <pc:docMk/>
            <pc:sldMk cId="2211045416" sldId="265"/>
            <ac:cxnSpMk id="45" creationId="{3CDF5CD2-8E8B-01D8-90D5-89720B458DDB}"/>
          </ac:cxnSpMkLst>
        </pc:cxnChg>
        <pc:cxnChg chg="add mod">
          <ac:chgData name="Sherry Hutchinson" userId="da25e8c2-4cfa-4a6f-b6d6-a8ac2a736b83" providerId="ADAL" clId="{70579AD9-A521-44EB-952E-5873134CDDB9}" dt="2023-07-09T20:47:23.139" v="2904" actId="1038"/>
          <ac:cxnSpMkLst>
            <pc:docMk/>
            <pc:sldMk cId="2211045416" sldId="265"/>
            <ac:cxnSpMk id="49" creationId="{81A3E30B-8E74-9148-60D7-84CB3109ABAE}"/>
          </ac:cxnSpMkLst>
        </pc:cxnChg>
        <pc:cxnChg chg="add del mod">
          <ac:chgData name="Sherry Hutchinson" userId="da25e8c2-4cfa-4a6f-b6d6-a8ac2a736b83" providerId="ADAL" clId="{70579AD9-A521-44EB-952E-5873134CDDB9}" dt="2023-07-09T20:46:54.734" v="2897" actId="478"/>
          <ac:cxnSpMkLst>
            <pc:docMk/>
            <pc:sldMk cId="2211045416" sldId="265"/>
            <ac:cxnSpMk id="50" creationId="{74FB1605-84D6-0F90-0FE2-CC4D6DD88A43}"/>
          </ac:cxnSpMkLst>
        </pc:cxnChg>
        <pc:cxnChg chg="add mod">
          <ac:chgData name="Sherry Hutchinson" userId="da25e8c2-4cfa-4a6f-b6d6-a8ac2a736b83" providerId="ADAL" clId="{70579AD9-A521-44EB-952E-5873134CDDB9}" dt="2023-07-09T20:50:01.943" v="2951" actId="1036"/>
          <ac:cxnSpMkLst>
            <pc:docMk/>
            <pc:sldMk cId="2211045416" sldId="265"/>
            <ac:cxnSpMk id="52" creationId="{E5105A9F-9FD9-117E-692D-2B85B220ABB8}"/>
          </ac:cxnSpMkLst>
        </pc:cxnChg>
        <pc:cxnChg chg="add mod">
          <ac:chgData name="Sherry Hutchinson" userId="da25e8c2-4cfa-4a6f-b6d6-a8ac2a736b83" providerId="ADAL" clId="{70579AD9-A521-44EB-952E-5873134CDDB9}" dt="2023-07-09T20:50:01.943" v="2951" actId="1036"/>
          <ac:cxnSpMkLst>
            <pc:docMk/>
            <pc:sldMk cId="2211045416" sldId="265"/>
            <ac:cxnSpMk id="55" creationId="{AB96B638-000D-869A-8BD8-2F1103C0B58F}"/>
          </ac:cxnSpMkLst>
        </pc:cxnChg>
        <pc:cxnChg chg="add mod">
          <ac:chgData name="Sherry Hutchinson" userId="da25e8c2-4cfa-4a6f-b6d6-a8ac2a736b83" providerId="ADAL" clId="{70579AD9-A521-44EB-952E-5873134CDDB9}" dt="2023-07-09T20:57:39.374" v="3051" actId="1582"/>
          <ac:cxnSpMkLst>
            <pc:docMk/>
            <pc:sldMk cId="2211045416" sldId="265"/>
            <ac:cxnSpMk id="59" creationId="{90E49AED-58D2-85E0-2773-91944FDDDE50}"/>
          </ac:cxnSpMkLst>
        </pc:cxnChg>
        <pc:cxnChg chg="add mod">
          <ac:chgData name="Sherry Hutchinson" userId="da25e8c2-4cfa-4a6f-b6d6-a8ac2a736b83" providerId="ADAL" clId="{70579AD9-A521-44EB-952E-5873134CDDB9}" dt="2023-07-09T20:59:32.141" v="3057" actId="1582"/>
          <ac:cxnSpMkLst>
            <pc:docMk/>
            <pc:sldMk cId="2211045416" sldId="265"/>
            <ac:cxnSpMk id="62" creationId="{79EFB9B2-BFBC-5EF9-828D-C1D5E747727A}"/>
          </ac:cxnSpMkLst>
        </pc:cxnChg>
        <pc:cxnChg chg="add del mod">
          <ac:chgData name="Sherry Hutchinson" userId="da25e8c2-4cfa-4a6f-b6d6-a8ac2a736b83" providerId="ADAL" clId="{70579AD9-A521-44EB-952E-5873134CDDB9}" dt="2023-07-09T20:50:46.892" v="2952" actId="478"/>
          <ac:cxnSpMkLst>
            <pc:docMk/>
            <pc:sldMk cId="2211045416" sldId="265"/>
            <ac:cxnSpMk id="65" creationId="{5EFEC669-CD33-B1CF-017A-0D09B5922336}"/>
          </ac:cxnSpMkLst>
        </pc:cxnChg>
        <pc:cxnChg chg="add mod">
          <ac:chgData name="Sherry Hutchinson" userId="da25e8c2-4cfa-4a6f-b6d6-a8ac2a736b83" providerId="ADAL" clId="{70579AD9-A521-44EB-952E-5873134CDDB9}" dt="2023-07-09T20:55:45.296" v="3042" actId="555"/>
          <ac:cxnSpMkLst>
            <pc:docMk/>
            <pc:sldMk cId="2211045416" sldId="265"/>
            <ac:cxnSpMk id="68" creationId="{430D3C2A-D126-646E-B17E-4FD757CBCBC7}"/>
          </ac:cxnSpMkLst>
        </pc:cxnChg>
        <pc:cxnChg chg="add mod">
          <ac:chgData name="Sherry Hutchinson" userId="da25e8c2-4cfa-4a6f-b6d6-a8ac2a736b83" providerId="ADAL" clId="{70579AD9-A521-44EB-952E-5873134CDDB9}" dt="2023-07-09T20:59:32.141" v="3057" actId="1582"/>
          <ac:cxnSpMkLst>
            <pc:docMk/>
            <pc:sldMk cId="2211045416" sldId="265"/>
            <ac:cxnSpMk id="71" creationId="{A393EDF9-C2D3-ECF7-2C71-B58597561764}"/>
          </ac:cxnSpMkLst>
        </pc:cxnChg>
        <pc:cxnChg chg="add del mod">
          <ac:chgData name="Sherry Hutchinson" userId="da25e8c2-4cfa-4a6f-b6d6-a8ac2a736b83" providerId="ADAL" clId="{70579AD9-A521-44EB-952E-5873134CDDB9}" dt="2023-07-09T20:51:17.371" v="2958" actId="478"/>
          <ac:cxnSpMkLst>
            <pc:docMk/>
            <pc:sldMk cId="2211045416" sldId="265"/>
            <ac:cxnSpMk id="73" creationId="{932B3401-6881-04D6-5ECF-67A0C29E90CB}"/>
          </ac:cxnSpMkLst>
        </pc:cxnChg>
        <pc:cxnChg chg="add mod">
          <ac:chgData name="Sherry Hutchinson" userId="da25e8c2-4cfa-4a6f-b6d6-a8ac2a736b83" providerId="ADAL" clId="{70579AD9-A521-44EB-952E-5873134CDDB9}" dt="2023-07-09T20:59:32.141" v="3057" actId="1582"/>
          <ac:cxnSpMkLst>
            <pc:docMk/>
            <pc:sldMk cId="2211045416" sldId="265"/>
            <ac:cxnSpMk id="74" creationId="{C265FC4B-0293-C904-831F-70BC90D25D5A}"/>
          </ac:cxnSpMkLst>
        </pc:cxnChg>
        <pc:cxnChg chg="add del mod">
          <ac:chgData name="Sherry Hutchinson" userId="da25e8c2-4cfa-4a6f-b6d6-a8ac2a736b83" providerId="ADAL" clId="{70579AD9-A521-44EB-952E-5873134CDDB9}" dt="2023-07-09T20:50:52.548" v="2953" actId="478"/>
          <ac:cxnSpMkLst>
            <pc:docMk/>
            <pc:sldMk cId="2211045416" sldId="265"/>
            <ac:cxnSpMk id="79" creationId="{D7265CB0-947C-7341-B66B-9E447CAED0CC}"/>
          </ac:cxnSpMkLst>
        </pc:cxnChg>
        <pc:cxnChg chg="add del mod">
          <ac:chgData name="Sherry Hutchinson" userId="da25e8c2-4cfa-4a6f-b6d6-a8ac2a736b83" providerId="ADAL" clId="{70579AD9-A521-44EB-952E-5873134CDDB9}" dt="2023-07-09T20:50:46.892" v="2952" actId="478"/>
          <ac:cxnSpMkLst>
            <pc:docMk/>
            <pc:sldMk cId="2211045416" sldId="265"/>
            <ac:cxnSpMk id="80" creationId="{E9473F96-821C-8D53-5804-FC3F4946FCA5}"/>
          </ac:cxnSpMkLst>
        </pc:cxnChg>
        <pc:cxnChg chg="add del mod">
          <ac:chgData name="Sherry Hutchinson" userId="da25e8c2-4cfa-4a6f-b6d6-a8ac2a736b83" providerId="ADAL" clId="{70579AD9-A521-44EB-952E-5873134CDDB9}" dt="2023-07-09T20:50:52.548" v="2953" actId="478"/>
          <ac:cxnSpMkLst>
            <pc:docMk/>
            <pc:sldMk cId="2211045416" sldId="265"/>
            <ac:cxnSpMk id="82" creationId="{C4FCC2D6-31E8-3250-69ED-847DB7125741}"/>
          </ac:cxnSpMkLst>
        </pc:cxnChg>
        <pc:cxnChg chg="add del mod">
          <ac:chgData name="Sherry Hutchinson" userId="da25e8c2-4cfa-4a6f-b6d6-a8ac2a736b83" providerId="ADAL" clId="{70579AD9-A521-44EB-952E-5873134CDDB9}" dt="2023-07-09T20:50:52.548" v="2953" actId="478"/>
          <ac:cxnSpMkLst>
            <pc:docMk/>
            <pc:sldMk cId="2211045416" sldId="265"/>
            <ac:cxnSpMk id="85" creationId="{ACC62D25-5EFD-B138-117D-D27AFF76C6FE}"/>
          </ac:cxnSpMkLst>
        </pc:cxnChg>
        <pc:cxnChg chg="add mod">
          <ac:chgData name="Sherry Hutchinson" userId="da25e8c2-4cfa-4a6f-b6d6-a8ac2a736b83" providerId="ADAL" clId="{70579AD9-A521-44EB-952E-5873134CDDB9}" dt="2023-07-09T20:44:30.902" v="2861" actId="1036"/>
          <ac:cxnSpMkLst>
            <pc:docMk/>
            <pc:sldMk cId="2211045416" sldId="265"/>
            <ac:cxnSpMk id="88" creationId="{584E92DA-793C-ADAF-6653-A31DBC2675A2}"/>
          </ac:cxnSpMkLst>
        </pc:cxnChg>
        <pc:cxnChg chg="add mod">
          <ac:chgData name="Sherry Hutchinson" userId="da25e8c2-4cfa-4a6f-b6d6-a8ac2a736b83" providerId="ADAL" clId="{70579AD9-A521-44EB-952E-5873134CDDB9}" dt="2023-07-09T20:56:23.929" v="3045" actId="1038"/>
          <ac:cxnSpMkLst>
            <pc:docMk/>
            <pc:sldMk cId="2211045416" sldId="265"/>
            <ac:cxnSpMk id="90" creationId="{65760952-F183-A6EF-C5A4-BAF573F6D54B}"/>
          </ac:cxnSpMkLst>
        </pc:cxnChg>
        <pc:cxnChg chg="add mod">
          <ac:chgData name="Sherry Hutchinson" userId="da25e8c2-4cfa-4a6f-b6d6-a8ac2a736b83" providerId="ADAL" clId="{70579AD9-A521-44EB-952E-5873134CDDB9}" dt="2023-07-09T20:44:30.902" v="2861" actId="1036"/>
          <ac:cxnSpMkLst>
            <pc:docMk/>
            <pc:sldMk cId="2211045416" sldId="265"/>
            <ac:cxnSpMk id="93" creationId="{72715810-9256-D029-4C03-06F8BB2718B9}"/>
          </ac:cxnSpMkLst>
        </pc:cxnChg>
      </pc:sldChg>
    </pc:docChg>
  </pc:docChgLst>
  <pc:docChgLst>
    <pc:chgData name="Sanyukta Mathur" userId="94f543ed-2f36-47fa-aa05-e49fb6964863" providerId="ADAL" clId="{FC63E179-9B02-418D-8240-7420614BA435}"/>
    <pc:docChg chg="modSld">
      <pc:chgData name="Sanyukta Mathur" userId="94f543ed-2f36-47fa-aa05-e49fb6964863" providerId="ADAL" clId="{FC63E179-9B02-418D-8240-7420614BA435}" dt="2023-07-27T02:30:00.242" v="0" actId="767"/>
      <pc:docMkLst>
        <pc:docMk/>
      </pc:docMkLst>
      <pc:sldChg chg="addSp modSp">
        <pc:chgData name="Sanyukta Mathur" userId="94f543ed-2f36-47fa-aa05-e49fb6964863" providerId="ADAL" clId="{FC63E179-9B02-418D-8240-7420614BA435}" dt="2023-07-27T02:30:00.242" v="0" actId="767"/>
        <pc:sldMkLst>
          <pc:docMk/>
          <pc:sldMk cId="1285761949" sldId="257"/>
        </pc:sldMkLst>
        <pc:spChg chg="add mod">
          <ac:chgData name="Sanyukta Mathur" userId="94f543ed-2f36-47fa-aa05-e49fb6964863" providerId="ADAL" clId="{FC63E179-9B02-418D-8240-7420614BA435}" dt="2023-07-27T02:30:00.242" v="0" actId="767"/>
          <ac:spMkLst>
            <pc:docMk/>
            <pc:sldMk cId="1285761949" sldId="257"/>
            <ac:spMk id="3" creationId="{AB8DAF73-4040-9815-FD1A-CF6AFFC0190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93F574-6ECA-1E6F-3552-68E2537619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433413-4BA7-2262-C1A2-2CE6DACF91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CAC472-A683-15F9-2A38-43041CCB6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47F281-4EE2-18D6-DCCE-3BF726109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59CD94-5658-4996-8105-BC311DB91A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269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0D8A6E-07EB-4BA1-5CC9-A251CF739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6DF000-5412-1379-9D09-010E8043F9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1863D6-D71E-63D1-624B-B8CAAD337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AB1A1D-441B-64A0-954A-6D26B2AB3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A420D-CBE5-BEAD-E6C3-9CFEB254A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02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0517F8-ADFD-363B-5F5A-A9E1E92D042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951AD4-5067-E206-37E7-C107A70D8E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FD5C0B-DFB6-E85E-1106-F17C08BDD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2B2BBB-9141-C74A-C0C4-744BBB594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A66CB6-A60A-8DFB-9C9E-051E015F3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548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A6AD8-FDE4-2AE0-39E2-69EBF55C7B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9C0531-35DB-0F4E-6AAE-0AAB9C21E9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59DEF3-6699-4E7D-58E2-371EDAD13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80592D-9E5C-8908-CAC4-6CB3B5294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94A60-F59B-9298-7CA1-7B4130AFB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824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F3F9A9-66F6-32D6-2D42-513C353AC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397920-73E2-CC30-8CC0-206459CCCE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8C96D8-412D-A951-90D3-7BAEA39F3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C19790-C3D8-9E6A-8E09-28C0335FC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4B72CE-A136-8C9E-03CD-F72BB7B92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453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4F2FCA-CE23-345C-1B64-D03092BDD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4B6592-6C7D-0981-4205-9957B4387A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193CE0-4F95-A12C-435E-8DE9B50BA6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BDB286-BB7B-159D-A7B9-D0BA15EC4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51489-3F36-B193-954C-58F36856A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B42FBE-AA00-373B-7BDC-831A65CB5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218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A6D48-EE95-3BED-9C77-E5192ECEFC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34C7E5-AA96-6DF7-B472-D87349195E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FB816F-EF30-7758-DC36-965E0F7E2F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839BAD-6412-D9D1-E414-68D8C57B27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796408-B467-54DA-FC36-E65D444EFCD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749A32-FA6B-176F-EF40-896675190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FB36B-A4B5-5E03-822C-04C7CB7E7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3C32C2-35B4-D533-94B3-2D077DB9D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613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C68D2-1B7A-F87A-D494-929D76155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7218A5-3DBC-9889-32A5-C4F68E838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32E023-7EB8-8E96-51E6-EDA99BB19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6AA71E-0C1A-F1D5-87F8-2711B7F41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045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34370F-043C-3CE8-0EDA-F207F6089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173C3C-F4F9-92DD-FA8E-080518B89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5335CC9-4BD1-767D-FA57-2486F90CF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070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102F85-F44E-5469-D4C9-0319D556E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7A501D-6B55-A5B0-5AD8-44267A3DDB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EA657E-62CE-E8D1-A621-005E251BE4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929C99-ABE8-CE39-497D-214108E36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3CE764-A85B-600A-FDA4-25FB86F18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3CDC6C-55B2-1C7E-1529-3FA23F5E9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45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E0F92-63A7-625C-6CA0-2690891C8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88FEFD-121B-68B8-FE4A-54E6197B58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6133D2-B6C5-8CD2-3B86-F511B75F0C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D6EB5C-6321-CB59-4BE4-328E10244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84A1C4-8EAD-EB47-5AF2-629493AAA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C8A669-F849-F81D-1D5B-1DA4F45DD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048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FCA425-909C-5E9F-7865-56DC7508C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53B6C0-9EAF-6E11-9E2D-262446B579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D40D1F-20DE-B4CF-C131-A332A2482B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BAD685-8EC5-4C5E-9E4B-D9E094AA6D5F}" type="datetimeFigureOut">
              <a:rPr lang="en-US" smtClean="0"/>
              <a:t>7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AC20D-B6CC-0751-F584-360FC53DDB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D19210-700E-F363-7DD8-D787B14A2F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09B00-A7E7-4D35-925B-F97EC5D2B9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62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5151518" y="58730"/>
            <a:ext cx="193686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Tested for HIV in last 12 months</a:t>
            </a:r>
          </a:p>
          <a:p>
            <a:pPr algn="ctr"/>
            <a:r>
              <a:rPr lang="en-US" sz="1000" b="1"/>
              <a:t>73%</a:t>
            </a:r>
          </a:p>
          <a:p>
            <a:pPr algn="ctr"/>
            <a:r>
              <a:rPr lang="en-US" sz="1000" b="1"/>
              <a:t>(n=276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470C7-4FF4-D342-99E8-E8F821044953}"/>
              </a:ext>
            </a:extLst>
          </p:cNvPr>
          <p:cNvSpPr/>
          <p:nvPr/>
        </p:nvSpPr>
        <p:spPr>
          <a:xfrm>
            <a:off x="5205551" y="902696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A32A644-ADF7-B3AD-56F1-67002BDA0FAA}"/>
              </a:ext>
            </a:extLst>
          </p:cNvPr>
          <p:cNvCxnSpPr>
            <a:cxnSpLocks/>
          </p:cNvCxnSpPr>
          <p:nvPr/>
        </p:nvCxnSpPr>
        <p:spPr>
          <a:xfrm>
            <a:off x="5329376" y="1193641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7F66CB6-4E6C-859F-482C-E5DC7F7A965E}"/>
              </a:ext>
            </a:extLst>
          </p:cNvPr>
          <p:cNvSpPr txBox="1"/>
          <p:nvPr/>
        </p:nvSpPr>
        <p:spPr>
          <a:xfrm>
            <a:off x="5329376" y="121935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EF87472D-AF95-9A97-3335-2A576870F4F7}"/>
              </a:ext>
            </a:extLst>
          </p:cNvPr>
          <p:cNvSpPr/>
          <p:nvPr/>
        </p:nvSpPr>
        <p:spPr>
          <a:xfrm>
            <a:off x="4917446" y="148283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50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7EA828D-B9F5-483E-9DAA-9B6D79B3EF02}"/>
              </a:ext>
            </a:extLst>
          </p:cNvPr>
          <p:cNvSpPr/>
          <p:nvPr/>
        </p:nvSpPr>
        <p:spPr>
          <a:xfrm>
            <a:off x="3948251" y="2204291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9413CA9-10F6-8DF5-AEBB-D60AA7105BDF}"/>
              </a:ext>
            </a:extLst>
          </p:cNvPr>
          <p:cNvSpPr txBox="1"/>
          <p:nvPr/>
        </p:nvSpPr>
        <p:spPr>
          <a:xfrm>
            <a:off x="4034956" y="2509759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9027035E-C213-D913-76AB-7F8408F8148A}"/>
              </a:ext>
            </a:extLst>
          </p:cNvPr>
          <p:cNvSpPr/>
          <p:nvPr/>
        </p:nvSpPr>
        <p:spPr>
          <a:xfrm>
            <a:off x="3622046" y="280453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81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5329376" y="1915100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327A96A-39C5-C698-FC91-0BCEBBCFF434}"/>
              </a:ext>
            </a:extLst>
          </p:cNvPr>
          <p:cNvCxnSpPr>
            <a:cxnSpLocks/>
          </p:cNvCxnSpPr>
          <p:nvPr/>
        </p:nvCxnSpPr>
        <p:spPr>
          <a:xfrm>
            <a:off x="6114320" y="638906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DDDF19F5-BC9F-4FA9-CCC5-A65B6BD18BA3}"/>
              </a:ext>
            </a:extLst>
          </p:cNvPr>
          <p:cNvSpPr/>
          <p:nvPr/>
        </p:nvSpPr>
        <p:spPr>
          <a:xfrm>
            <a:off x="2655101" y="3537833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A5A33F7A-C786-FDB6-7656-DBF69CD64173}"/>
              </a:ext>
            </a:extLst>
          </p:cNvPr>
          <p:cNvSpPr/>
          <p:nvPr/>
        </p:nvSpPr>
        <p:spPr>
          <a:xfrm>
            <a:off x="2374271" y="4128294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80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2BFC792D-7D34-7B08-A7BE-FE329113102D}"/>
              </a:ext>
            </a:extLst>
          </p:cNvPr>
          <p:cNvCxnSpPr>
            <a:cxnSpLocks/>
          </p:cNvCxnSpPr>
          <p:nvPr/>
        </p:nvCxnSpPr>
        <p:spPr>
          <a:xfrm>
            <a:off x="4033976" y="3248637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6ED0E8A2-16FD-45A7-2EAD-103F52E1B771}"/>
              </a:ext>
            </a:extLst>
          </p:cNvPr>
          <p:cNvSpPr/>
          <p:nvPr/>
        </p:nvSpPr>
        <p:spPr>
          <a:xfrm>
            <a:off x="1857254" y="4841809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CDF5CD2-8E8B-01D8-90D5-89720B458DDB}"/>
              </a:ext>
            </a:extLst>
          </p:cNvPr>
          <p:cNvCxnSpPr>
            <a:cxnSpLocks/>
          </p:cNvCxnSpPr>
          <p:nvPr/>
        </p:nvCxnSpPr>
        <p:spPr>
          <a:xfrm>
            <a:off x="2047754" y="5132754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EE99552-126D-51A7-89E3-1E4546488C94}"/>
              </a:ext>
            </a:extLst>
          </p:cNvPr>
          <p:cNvSpPr txBox="1"/>
          <p:nvPr/>
        </p:nvSpPr>
        <p:spPr>
          <a:xfrm>
            <a:off x="2047754" y="5158472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047F0D2D-ADE3-DA91-A500-37C654E004E0}"/>
              </a:ext>
            </a:extLst>
          </p:cNvPr>
          <p:cNvSpPr/>
          <p:nvPr/>
        </p:nvSpPr>
        <p:spPr>
          <a:xfrm>
            <a:off x="1635825" y="5442264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5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120B1FA-B943-29D0-D7B0-FCEB82E5EC66}"/>
              </a:ext>
            </a:extLst>
          </p:cNvPr>
          <p:cNvCxnSpPr>
            <a:cxnSpLocks/>
          </p:cNvCxnSpPr>
          <p:nvPr/>
        </p:nvCxnSpPr>
        <p:spPr>
          <a:xfrm>
            <a:off x="2771654" y="4572393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7E758357-C91C-04BB-11B5-C3B2C01C7D3A}"/>
              </a:ext>
            </a:extLst>
          </p:cNvPr>
          <p:cNvCxnSpPr>
            <a:cxnSpLocks/>
          </p:cNvCxnSpPr>
          <p:nvPr/>
        </p:nvCxnSpPr>
        <p:spPr>
          <a:xfrm>
            <a:off x="6805751" y="1193641"/>
            <a:ext cx="0" cy="27432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76461EB9-9BA8-99AF-2166-C38900E77B5C}"/>
              </a:ext>
            </a:extLst>
          </p:cNvPr>
          <p:cNvSpPr txBox="1"/>
          <p:nvPr/>
        </p:nvSpPr>
        <p:spPr>
          <a:xfrm>
            <a:off x="6805751" y="1219359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297F514E-D453-73E2-D0FC-914C0C0C95A3}"/>
              </a:ext>
            </a:extLst>
          </p:cNvPr>
          <p:cNvSpPr/>
          <p:nvPr/>
        </p:nvSpPr>
        <p:spPr>
          <a:xfrm>
            <a:off x="6393821" y="148283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5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6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326F598-8F1E-33D0-5674-73A3AF5645A3}"/>
              </a:ext>
            </a:extLst>
          </p:cNvPr>
          <p:cNvCxnSpPr>
            <a:cxnSpLocks/>
          </p:cNvCxnSpPr>
          <p:nvPr/>
        </p:nvCxnSpPr>
        <p:spPr>
          <a:xfrm>
            <a:off x="4033976" y="2494965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E33243D1-AC67-7518-5D96-0795AFD6C609}"/>
              </a:ext>
            </a:extLst>
          </p:cNvPr>
          <p:cNvSpPr txBox="1"/>
          <p:nvPr/>
        </p:nvSpPr>
        <p:spPr>
          <a:xfrm>
            <a:off x="6442772" y="2522123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4971B8F3-A718-D50A-1568-3661E634D3E8}"/>
              </a:ext>
            </a:extLst>
          </p:cNvPr>
          <p:cNvSpPr/>
          <p:nvPr/>
        </p:nvSpPr>
        <p:spPr>
          <a:xfrm>
            <a:off x="6029862" y="2816902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9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A898E86F-D68C-56CF-3422-9EE79206327C}"/>
              </a:ext>
            </a:extLst>
          </p:cNvPr>
          <p:cNvSpPr/>
          <p:nvPr/>
        </p:nvSpPr>
        <p:spPr>
          <a:xfrm>
            <a:off x="6289392" y="3537833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6B138DF7-4FE3-8249-A456-305D07B340AE}"/>
              </a:ext>
            </a:extLst>
          </p:cNvPr>
          <p:cNvCxnSpPr>
            <a:cxnSpLocks/>
          </p:cNvCxnSpPr>
          <p:nvPr/>
        </p:nvCxnSpPr>
        <p:spPr>
          <a:xfrm>
            <a:off x="6441792" y="326100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3AB0734C-9192-8C96-414A-4DABD659CBB3}"/>
              </a:ext>
            </a:extLst>
          </p:cNvPr>
          <p:cNvCxnSpPr>
            <a:cxnSpLocks/>
          </p:cNvCxnSpPr>
          <p:nvPr/>
        </p:nvCxnSpPr>
        <p:spPr>
          <a:xfrm>
            <a:off x="6441792" y="250732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8FCC601F-65BF-D901-4C0B-424018739065}"/>
              </a:ext>
            </a:extLst>
          </p:cNvPr>
          <p:cNvSpPr txBox="1"/>
          <p:nvPr/>
        </p:nvSpPr>
        <p:spPr>
          <a:xfrm>
            <a:off x="6438859" y="3853161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1BB38C52-C998-7157-345C-B1291D168AC9}"/>
              </a:ext>
            </a:extLst>
          </p:cNvPr>
          <p:cNvSpPr/>
          <p:nvPr/>
        </p:nvSpPr>
        <p:spPr>
          <a:xfrm>
            <a:off x="6025949" y="414794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6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1B5FC1DB-D4AA-DB72-C3DB-DC61CA0B9DBD}"/>
              </a:ext>
            </a:extLst>
          </p:cNvPr>
          <p:cNvCxnSpPr>
            <a:cxnSpLocks/>
          </p:cNvCxnSpPr>
          <p:nvPr/>
        </p:nvCxnSpPr>
        <p:spPr>
          <a:xfrm>
            <a:off x="6437879" y="3841206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68C08771-A5E5-07A3-5B8A-2CDEE64A9126}"/>
              </a:ext>
            </a:extLst>
          </p:cNvPr>
          <p:cNvSpPr txBox="1"/>
          <p:nvPr/>
        </p:nvSpPr>
        <p:spPr>
          <a:xfrm>
            <a:off x="7875125" y="3865525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8926E402-B69E-525B-461D-F809EF38C26F}"/>
              </a:ext>
            </a:extLst>
          </p:cNvPr>
          <p:cNvSpPr/>
          <p:nvPr/>
        </p:nvSpPr>
        <p:spPr>
          <a:xfrm>
            <a:off x="7462215" y="4160304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6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53</a:t>
            </a:r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591E8E5C-AED2-928D-7FC3-DBF7007875D5}"/>
              </a:ext>
            </a:extLst>
          </p:cNvPr>
          <p:cNvCxnSpPr>
            <a:cxnSpLocks/>
          </p:cNvCxnSpPr>
          <p:nvPr/>
        </p:nvCxnSpPr>
        <p:spPr>
          <a:xfrm>
            <a:off x="7874145" y="4604403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42A19B8C-B45F-1112-2B7F-3B806646557F}"/>
              </a:ext>
            </a:extLst>
          </p:cNvPr>
          <p:cNvCxnSpPr>
            <a:cxnSpLocks/>
          </p:cNvCxnSpPr>
          <p:nvPr/>
        </p:nvCxnSpPr>
        <p:spPr>
          <a:xfrm>
            <a:off x="7874145" y="3841206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tangle 87">
            <a:extLst>
              <a:ext uri="{FF2B5EF4-FFF2-40B4-BE49-F238E27FC236}">
                <a16:creationId xmlns:a16="http://schemas.microsoft.com/office/drawing/2014/main" id="{10767390-8581-E456-5A90-AD8D17F90993}"/>
              </a:ext>
            </a:extLst>
          </p:cNvPr>
          <p:cNvSpPr/>
          <p:nvPr/>
        </p:nvSpPr>
        <p:spPr>
          <a:xfrm>
            <a:off x="6967676" y="4873819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21E49DC0-38DF-6EAC-4F15-776BF40DB74F}"/>
              </a:ext>
            </a:extLst>
          </p:cNvPr>
          <p:cNvCxnSpPr>
            <a:cxnSpLocks/>
          </p:cNvCxnSpPr>
          <p:nvPr/>
        </p:nvCxnSpPr>
        <p:spPr>
          <a:xfrm>
            <a:off x="7091501" y="5164764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1406A590-44AD-E918-6BE6-0152A38B79CC}"/>
              </a:ext>
            </a:extLst>
          </p:cNvPr>
          <p:cNvSpPr txBox="1"/>
          <p:nvPr/>
        </p:nvSpPr>
        <p:spPr>
          <a:xfrm>
            <a:off x="7091501" y="5190482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91" name="Oval 90">
            <a:extLst>
              <a:ext uri="{FF2B5EF4-FFF2-40B4-BE49-F238E27FC236}">
                <a16:creationId xmlns:a16="http://schemas.microsoft.com/office/drawing/2014/main" id="{A7624453-1DAE-1E23-15AB-4A805A818ED4}"/>
              </a:ext>
            </a:extLst>
          </p:cNvPr>
          <p:cNvSpPr/>
          <p:nvPr/>
        </p:nvSpPr>
        <p:spPr>
          <a:xfrm>
            <a:off x="6679571" y="5441001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6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4</a:t>
            </a:r>
          </a:p>
        </p:txBody>
      </p: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2706E56B-F711-87BA-0FD3-92850B04BB8E}"/>
              </a:ext>
            </a:extLst>
          </p:cNvPr>
          <p:cNvCxnSpPr>
            <a:cxnSpLocks/>
          </p:cNvCxnSpPr>
          <p:nvPr/>
        </p:nvCxnSpPr>
        <p:spPr>
          <a:xfrm>
            <a:off x="8567876" y="5164764"/>
            <a:ext cx="0" cy="27432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89F62301-03A5-7CB7-A123-A2C02BD66BB9}"/>
              </a:ext>
            </a:extLst>
          </p:cNvPr>
          <p:cNvSpPr txBox="1"/>
          <p:nvPr/>
        </p:nvSpPr>
        <p:spPr>
          <a:xfrm>
            <a:off x="8567876" y="5190482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3EC27052-A1E0-4931-3FD8-D5D808AC6AD5}"/>
              </a:ext>
            </a:extLst>
          </p:cNvPr>
          <p:cNvSpPr/>
          <p:nvPr/>
        </p:nvSpPr>
        <p:spPr>
          <a:xfrm>
            <a:off x="8155946" y="5441001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9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E1261378-E78D-EED8-E2A3-D6C2DBBE5BE9}"/>
              </a:ext>
            </a:extLst>
          </p:cNvPr>
          <p:cNvSpPr txBox="1"/>
          <p:nvPr/>
        </p:nvSpPr>
        <p:spPr>
          <a:xfrm>
            <a:off x="2787181" y="3851601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E43B11A1-0F61-2609-3B72-376A5CDA72B4}"/>
              </a:ext>
            </a:extLst>
          </p:cNvPr>
          <p:cNvCxnSpPr>
            <a:cxnSpLocks/>
          </p:cNvCxnSpPr>
          <p:nvPr/>
        </p:nvCxnSpPr>
        <p:spPr>
          <a:xfrm>
            <a:off x="2787181" y="3841206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A5C61E5F-E162-31CD-A2F9-D52348947BA9}"/>
              </a:ext>
            </a:extLst>
          </p:cNvPr>
          <p:cNvSpPr txBox="1"/>
          <p:nvPr/>
        </p:nvSpPr>
        <p:spPr>
          <a:xfrm>
            <a:off x="5150215" y="3833515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6B9C4F51-F5FE-EFE0-8FEB-71220DB1EFAC}"/>
              </a:ext>
            </a:extLst>
          </p:cNvPr>
          <p:cNvSpPr/>
          <p:nvPr/>
        </p:nvSpPr>
        <p:spPr>
          <a:xfrm>
            <a:off x="4737305" y="4128294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01</a:t>
            </a:r>
          </a:p>
        </p:txBody>
      </p: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9F0B65DC-F3A9-C7B7-96F1-70E1A2FD7376}"/>
              </a:ext>
            </a:extLst>
          </p:cNvPr>
          <p:cNvCxnSpPr>
            <a:cxnSpLocks/>
          </p:cNvCxnSpPr>
          <p:nvPr/>
        </p:nvCxnSpPr>
        <p:spPr>
          <a:xfrm>
            <a:off x="5149235" y="4572393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161473F3-0633-FF0A-AFAB-F576C7579E2A}"/>
              </a:ext>
            </a:extLst>
          </p:cNvPr>
          <p:cNvCxnSpPr>
            <a:cxnSpLocks/>
          </p:cNvCxnSpPr>
          <p:nvPr/>
        </p:nvCxnSpPr>
        <p:spPr>
          <a:xfrm>
            <a:off x="5149235" y="3841206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ectangle 101">
            <a:extLst>
              <a:ext uri="{FF2B5EF4-FFF2-40B4-BE49-F238E27FC236}">
                <a16:creationId xmlns:a16="http://schemas.microsoft.com/office/drawing/2014/main" id="{3FB55661-9761-9918-8116-61D2278DA046}"/>
              </a:ext>
            </a:extLst>
          </p:cNvPr>
          <p:cNvSpPr/>
          <p:nvPr/>
        </p:nvSpPr>
        <p:spPr>
          <a:xfrm>
            <a:off x="4242766" y="4841809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9CB7931E-002C-A244-29F9-A70B91302C08}"/>
              </a:ext>
            </a:extLst>
          </p:cNvPr>
          <p:cNvCxnSpPr>
            <a:cxnSpLocks/>
          </p:cNvCxnSpPr>
          <p:nvPr/>
        </p:nvCxnSpPr>
        <p:spPr>
          <a:xfrm>
            <a:off x="4366591" y="5132754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4F490231-39EE-CD6E-CBE1-9C1F737280D2}"/>
              </a:ext>
            </a:extLst>
          </p:cNvPr>
          <p:cNvSpPr txBox="1"/>
          <p:nvPr/>
        </p:nvSpPr>
        <p:spPr>
          <a:xfrm>
            <a:off x="4366591" y="5158472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27032A28-16A9-FFB3-32D8-AEB5352EC85D}"/>
              </a:ext>
            </a:extLst>
          </p:cNvPr>
          <p:cNvSpPr/>
          <p:nvPr/>
        </p:nvSpPr>
        <p:spPr>
          <a:xfrm>
            <a:off x="3954662" y="5441001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8</a:t>
            </a:r>
          </a:p>
        </p:txBody>
      </p: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1B759161-3107-FB19-B061-C71788ABE582}"/>
              </a:ext>
            </a:extLst>
          </p:cNvPr>
          <p:cNvCxnSpPr>
            <a:cxnSpLocks/>
          </p:cNvCxnSpPr>
          <p:nvPr/>
        </p:nvCxnSpPr>
        <p:spPr>
          <a:xfrm>
            <a:off x="5842966" y="5132754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600551F5-4F2D-DCD3-10F7-551225FF76C7}"/>
              </a:ext>
            </a:extLst>
          </p:cNvPr>
          <p:cNvSpPr txBox="1"/>
          <p:nvPr/>
        </p:nvSpPr>
        <p:spPr>
          <a:xfrm>
            <a:off x="5842966" y="5158472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08" name="Oval 107">
            <a:extLst>
              <a:ext uri="{FF2B5EF4-FFF2-40B4-BE49-F238E27FC236}">
                <a16:creationId xmlns:a16="http://schemas.microsoft.com/office/drawing/2014/main" id="{C50D1F85-D397-655C-FEB6-3744CB30CD9B}"/>
              </a:ext>
            </a:extLst>
          </p:cNvPr>
          <p:cNvSpPr/>
          <p:nvPr/>
        </p:nvSpPr>
        <p:spPr>
          <a:xfrm>
            <a:off x="5431036" y="5441001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3</a:t>
            </a:r>
          </a:p>
        </p:txBody>
      </p: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E38A8045-A98F-7A83-6396-FC1CF350A1CD}"/>
              </a:ext>
            </a:extLst>
          </p:cNvPr>
          <p:cNvCxnSpPr>
            <a:cxnSpLocks/>
          </p:cNvCxnSpPr>
          <p:nvPr/>
        </p:nvCxnSpPr>
        <p:spPr>
          <a:xfrm>
            <a:off x="3413843" y="5152376"/>
            <a:ext cx="0" cy="279881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4B5DF145-B305-593C-1949-DC2D22D84D14}"/>
              </a:ext>
            </a:extLst>
          </p:cNvPr>
          <p:cNvSpPr txBox="1"/>
          <p:nvPr/>
        </p:nvSpPr>
        <p:spPr>
          <a:xfrm>
            <a:off x="3413843" y="5158472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16" name="Oval 115">
            <a:extLst>
              <a:ext uri="{FF2B5EF4-FFF2-40B4-BE49-F238E27FC236}">
                <a16:creationId xmlns:a16="http://schemas.microsoft.com/office/drawing/2014/main" id="{E1FA297E-173F-CE5D-BB85-DFEB798EE05B}"/>
              </a:ext>
            </a:extLst>
          </p:cNvPr>
          <p:cNvSpPr/>
          <p:nvPr/>
        </p:nvSpPr>
        <p:spPr>
          <a:xfrm>
            <a:off x="3001913" y="5442264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5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37F93DD-4198-4195-B818-85423E9B1E8B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1A: Decision tree predicting HIV testing in the last 12 months among adolescent girls (aged 15-19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8C20E274-51CC-A112-B710-F70051423E78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ctr"/>
            <a:r>
              <a:rPr lang="en-US" sz="1200" dirty="0">
                <a:solidFill>
                  <a:schemeClr val="tx1"/>
                </a:solidFill>
              </a:rPr>
              <a:t>The node at the very top indicates the overall occurrence of this outcome among adolescent girls. Specifically, 73% of all adolescent girls tested for HIV in the last 12 months. This proportion is maximized among adolescent girls who accessed youth-friendly health services (76%), completed social asset building (79%), and received economic social protection (81%) and educational social protection (</a:t>
            </a:r>
            <a:r>
              <a:rPr lang="en-US" sz="1200" b="1" u="sng" dirty="0">
                <a:solidFill>
                  <a:schemeClr val="tx1"/>
                </a:solidFill>
              </a:rPr>
              <a:t>83%</a:t>
            </a:r>
            <a:r>
              <a:rPr lang="en-US" sz="1200" dirty="0">
                <a:solidFill>
                  <a:schemeClr val="tx1"/>
                </a:solidFill>
              </a:rPr>
              <a:t>). The goal for interpreting these trees is to identify which pathway yields the greatest increase from the base value (i.e., overall proportion among the sample).</a:t>
            </a:r>
          </a:p>
        </p:txBody>
      </p:sp>
    </p:spTree>
    <p:extLst>
      <p:ext uri="{BB962C8B-B14F-4D97-AF65-F5344CB8AC3E}">
        <p14:creationId xmlns:p14="http://schemas.microsoft.com/office/powerpoint/2010/main" val="1626579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5875416" y="58730"/>
            <a:ext cx="19368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No non-partner sexual violence in last 12 months</a:t>
            </a:r>
          </a:p>
          <a:p>
            <a:pPr algn="ctr"/>
            <a:r>
              <a:rPr lang="en-US" sz="1000" b="1"/>
              <a:t>87%</a:t>
            </a:r>
          </a:p>
          <a:p>
            <a:pPr algn="ctr"/>
            <a:r>
              <a:rPr lang="en-US" sz="1000" b="1"/>
              <a:t>(n=439)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327A96A-39C5-C698-FC91-0BCEBBCFF434}"/>
              </a:ext>
            </a:extLst>
          </p:cNvPr>
          <p:cNvCxnSpPr>
            <a:cxnSpLocks/>
          </p:cNvCxnSpPr>
          <p:nvPr/>
        </p:nvCxnSpPr>
        <p:spPr>
          <a:xfrm>
            <a:off x="6838218" y="740510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D107C53F-CC0A-1A69-EA67-5DF5ADA51F03}"/>
              </a:ext>
            </a:extLst>
          </p:cNvPr>
          <p:cNvSpPr/>
          <p:nvPr/>
        </p:nvSpPr>
        <p:spPr>
          <a:xfrm>
            <a:off x="4555278" y="1022018"/>
            <a:ext cx="45720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CB197F64-354D-2493-BBEE-02478F9DC056}"/>
              </a:ext>
            </a:extLst>
          </p:cNvPr>
          <p:cNvCxnSpPr>
            <a:cxnSpLocks/>
          </p:cNvCxnSpPr>
          <p:nvPr/>
        </p:nvCxnSpPr>
        <p:spPr>
          <a:xfrm>
            <a:off x="4750006" y="1312963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268F6E88-E53D-ACF0-C30B-8E425240CB27}"/>
              </a:ext>
            </a:extLst>
          </p:cNvPr>
          <p:cNvSpPr txBox="1"/>
          <p:nvPr/>
        </p:nvSpPr>
        <p:spPr>
          <a:xfrm>
            <a:off x="4750006" y="1332089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DF291371-2E71-E378-6953-A4B52C8E3310}"/>
              </a:ext>
            </a:extLst>
          </p:cNvPr>
          <p:cNvSpPr/>
          <p:nvPr/>
        </p:nvSpPr>
        <p:spPr>
          <a:xfrm>
            <a:off x="4338076" y="1602160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47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196F66CD-7CF1-227C-CDE0-B6B3BD522C86}"/>
              </a:ext>
            </a:extLst>
          </p:cNvPr>
          <p:cNvCxnSpPr>
            <a:cxnSpLocks/>
          </p:cNvCxnSpPr>
          <p:nvPr/>
        </p:nvCxnSpPr>
        <p:spPr>
          <a:xfrm>
            <a:off x="4750006" y="2034422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4DB65CFB-C474-3AD7-DE7C-29E908D8C6D2}"/>
              </a:ext>
            </a:extLst>
          </p:cNvPr>
          <p:cNvCxnSpPr>
            <a:cxnSpLocks/>
            <a:endCxn id="13" idx="0"/>
          </p:cNvCxnSpPr>
          <p:nvPr/>
        </p:nvCxnSpPr>
        <p:spPr>
          <a:xfrm>
            <a:off x="8852052" y="1322805"/>
            <a:ext cx="0" cy="28888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1BB4954-C159-824A-F66B-7CE304CB943C}"/>
              </a:ext>
            </a:extLst>
          </p:cNvPr>
          <p:cNvSpPr txBox="1"/>
          <p:nvPr/>
        </p:nvSpPr>
        <p:spPr>
          <a:xfrm>
            <a:off x="8852052" y="1341614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059CB0A5-2AEB-0CD2-8EEF-68BF20D8C13C}"/>
              </a:ext>
            </a:extLst>
          </p:cNvPr>
          <p:cNvSpPr/>
          <p:nvPr/>
        </p:nvSpPr>
        <p:spPr>
          <a:xfrm>
            <a:off x="8440122" y="161168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92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FD5A5ED-4646-9231-DA8D-9EF9F314A8D7}"/>
              </a:ext>
            </a:extLst>
          </p:cNvPr>
          <p:cNvSpPr/>
          <p:nvPr/>
        </p:nvSpPr>
        <p:spPr>
          <a:xfrm>
            <a:off x="8591972" y="2333138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9BD8A38-B2F8-696C-06E2-146D81C77B77}"/>
              </a:ext>
            </a:extLst>
          </p:cNvPr>
          <p:cNvCxnSpPr>
            <a:cxnSpLocks/>
          </p:cNvCxnSpPr>
          <p:nvPr/>
        </p:nvCxnSpPr>
        <p:spPr>
          <a:xfrm>
            <a:off x="8837505" y="2043947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AD2E331D-4D06-E363-A718-8A98B98802D3}"/>
              </a:ext>
            </a:extLst>
          </p:cNvPr>
          <p:cNvCxnSpPr>
            <a:cxnSpLocks/>
            <a:endCxn id="24" idx="0"/>
          </p:cNvCxnSpPr>
          <p:nvPr/>
        </p:nvCxnSpPr>
        <p:spPr>
          <a:xfrm>
            <a:off x="10170963" y="2618854"/>
            <a:ext cx="0" cy="314592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73224180-6556-5A33-0DD6-E704D652B92B}"/>
              </a:ext>
            </a:extLst>
          </p:cNvPr>
          <p:cNvSpPr txBox="1"/>
          <p:nvPr/>
        </p:nvSpPr>
        <p:spPr>
          <a:xfrm>
            <a:off x="10170963" y="2664068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5AE9F5F9-3266-7CC3-1305-FBB3C5C2216D}"/>
              </a:ext>
            </a:extLst>
          </p:cNvPr>
          <p:cNvSpPr/>
          <p:nvPr/>
        </p:nvSpPr>
        <p:spPr>
          <a:xfrm>
            <a:off x="9759033" y="293344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0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3D2645FD-7328-0F77-E06D-FA14AA6DF437}"/>
              </a:ext>
            </a:extLst>
          </p:cNvPr>
          <p:cNvCxnSpPr>
            <a:cxnSpLocks/>
            <a:endCxn id="28" idx="0"/>
          </p:cNvCxnSpPr>
          <p:nvPr/>
        </p:nvCxnSpPr>
        <p:spPr>
          <a:xfrm>
            <a:off x="8855193" y="2624083"/>
            <a:ext cx="0" cy="309363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7EA0514-AAA5-2C3C-CFE6-7CDF1EDE4C1C}"/>
              </a:ext>
            </a:extLst>
          </p:cNvPr>
          <p:cNvSpPr txBox="1"/>
          <p:nvPr/>
        </p:nvSpPr>
        <p:spPr>
          <a:xfrm>
            <a:off x="8856173" y="2662705"/>
            <a:ext cx="504008" cy="2447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3A4ABF7-BB18-BE69-14FC-89C9C668E2D5}"/>
              </a:ext>
            </a:extLst>
          </p:cNvPr>
          <p:cNvSpPr/>
          <p:nvPr/>
        </p:nvSpPr>
        <p:spPr>
          <a:xfrm>
            <a:off x="8443263" y="293344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2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22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81A3E30B-8E74-9148-60D7-84CB3109ABAE}"/>
              </a:ext>
            </a:extLst>
          </p:cNvPr>
          <p:cNvCxnSpPr>
            <a:cxnSpLocks/>
          </p:cNvCxnSpPr>
          <p:nvPr/>
        </p:nvCxnSpPr>
        <p:spPr>
          <a:xfrm>
            <a:off x="8835065" y="337372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FDBBACF5-BC07-9EE5-E0A2-4D436561ABC0}"/>
              </a:ext>
            </a:extLst>
          </p:cNvPr>
          <p:cNvSpPr/>
          <p:nvPr/>
        </p:nvSpPr>
        <p:spPr>
          <a:xfrm>
            <a:off x="7928596" y="3645746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E5105A9F-9FD9-117E-692D-2B85B220ABB8}"/>
              </a:ext>
            </a:extLst>
          </p:cNvPr>
          <p:cNvCxnSpPr>
            <a:cxnSpLocks/>
          </p:cNvCxnSpPr>
          <p:nvPr/>
        </p:nvCxnSpPr>
        <p:spPr>
          <a:xfrm>
            <a:off x="8052421" y="3945073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D2995232-6368-58D3-862C-DCCFC3C738AC}"/>
              </a:ext>
            </a:extLst>
          </p:cNvPr>
          <p:cNvSpPr txBox="1"/>
          <p:nvPr/>
        </p:nvSpPr>
        <p:spPr>
          <a:xfrm>
            <a:off x="8052421" y="3964892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9554DEAA-C486-E73C-9400-6D34702CDAD8}"/>
              </a:ext>
            </a:extLst>
          </p:cNvPr>
          <p:cNvSpPr/>
          <p:nvPr/>
        </p:nvSpPr>
        <p:spPr>
          <a:xfrm>
            <a:off x="7640492" y="4205563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01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AB96B638-000D-869A-8BD8-2F1103C0B58F}"/>
              </a:ext>
            </a:extLst>
          </p:cNvPr>
          <p:cNvCxnSpPr>
            <a:cxnSpLocks/>
          </p:cNvCxnSpPr>
          <p:nvPr/>
        </p:nvCxnSpPr>
        <p:spPr>
          <a:xfrm>
            <a:off x="9528796" y="3945073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FD10C9C9-7D10-52B4-8EBD-EB1CBAAD3E03}"/>
              </a:ext>
            </a:extLst>
          </p:cNvPr>
          <p:cNvSpPr txBox="1"/>
          <p:nvPr/>
        </p:nvSpPr>
        <p:spPr>
          <a:xfrm>
            <a:off x="9528796" y="3964892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BC5ABEEA-8FD7-5B6B-6879-0676313F4EE7}"/>
              </a:ext>
            </a:extLst>
          </p:cNvPr>
          <p:cNvSpPr/>
          <p:nvPr/>
        </p:nvSpPr>
        <p:spPr>
          <a:xfrm>
            <a:off x="9116866" y="4205563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1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28FF8D00-24CC-CDF5-9740-E9399052590A}"/>
              </a:ext>
            </a:extLst>
          </p:cNvPr>
          <p:cNvSpPr/>
          <p:nvPr/>
        </p:nvSpPr>
        <p:spPr>
          <a:xfrm>
            <a:off x="3385011" y="2323613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90E49AED-58D2-85E0-2773-91944FDDDE50}"/>
              </a:ext>
            </a:extLst>
          </p:cNvPr>
          <p:cNvCxnSpPr>
            <a:cxnSpLocks/>
            <a:endCxn id="61" idx="0"/>
          </p:cNvCxnSpPr>
          <p:nvPr/>
        </p:nvCxnSpPr>
        <p:spPr>
          <a:xfrm>
            <a:off x="5881122" y="2599804"/>
            <a:ext cx="0" cy="31402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3EA71C80-F311-F402-EE2D-A834121789E1}"/>
              </a:ext>
            </a:extLst>
          </p:cNvPr>
          <p:cNvSpPr txBox="1"/>
          <p:nvPr/>
        </p:nvSpPr>
        <p:spPr>
          <a:xfrm>
            <a:off x="5881122" y="2654543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E239B4EE-CB4C-74FC-6818-8E38002FB8BE}"/>
              </a:ext>
            </a:extLst>
          </p:cNvPr>
          <p:cNvSpPr/>
          <p:nvPr/>
        </p:nvSpPr>
        <p:spPr>
          <a:xfrm>
            <a:off x="5469192" y="291382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2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57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9EFB9B2-BFBC-5EF9-828D-C1D5E747727A}"/>
              </a:ext>
            </a:extLst>
          </p:cNvPr>
          <p:cNvCxnSpPr>
            <a:cxnSpLocks/>
            <a:endCxn id="64" idx="0"/>
          </p:cNvCxnSpPr>
          <p:nvPr/>
        </p:nvCxnSpPr>
        <p:spPr>
          <a:xfrm>
            <a:off x="3551621" y="2604462"/>
            <a:ext cx="0" cy="309363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F7CCEB5E-5DB0-B4C4-1939-B19746D8E63D}"/>
              </a:ext>
            </a:extLst>
          </p:cNvPr>
          <p:cNvSpPr txBox="1"/>
          <p:nvPr/>
        </p:nvSpPr>
        <p:spPr>
          <a:xfrm>
            <a:off x="3552601" y="2653180"/>
            <a:ext cx="504008" cy="2447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EDF8AABA-2518-00FA-AABA-7F12821E07F5}"/>
              </a:ext>
            </a:extLst>
          </p:cNvPr>
          <p:cNvSpPr/>
          <p:nvPr/>
        </p:nvSpPr>
        <p:spPr>
          <a:xfrm>
            <a:off x="3139691" y="2913825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90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E1B6FA2C-43E9-A014-AA4C-F7E0CA9D6C1D}"/>
              </a:ext>
            </a:extLst>
          </p:cNvPr>
          <p:cNvSpPr/>
          <p:nvPr/>
        </p:nvSpPr>
        <p:spPr>
          <a:xfrm>
            <a:off x="2633237" y="3632209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430D3C2A-D126-646E-B17E-4FD757CBCBC7}"/>
              </a:ext>
            </a:extLst>
          </p:cNvPr>
          <p:cNvCxnSpPr>
            <a:cxnSpLocks/>
            <a:endCxn id="70" idx="0"/>
          </p:cNvCxnSpPr>
          <p:nvPr/>
        </p:nvCxnSpPr>
        <p:spPr>
          <a:xfrm>
            <a:off x="4202957" y="3935854"/>
            <a:ext cx="0" cy="288116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1FCB335A-6F76-7F9D-6402-E872728EA17F}"/>
              </a:ext>
            </a:extLst>
          </p:cNvPr>
          <p:cNvSpPr txBox="1"/>
          <p:nvPr/>
        </p:nvSpPr>
        <p:spPr>
          <a:xfrm>
            <a:off x="4213277" y="3949866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6FEE1AC6-F49C-31CF-BD57-06EBF620317E}"/>
              </a:ext>
            </a:extLst>
          </p:cNvPr>
          <p:cNvSpPr/>
          <p:nvPr/>
        </p:nvSpPr>
        <p:spPr>
          <a:xfrm>
            <a:off x="3791027" y="422397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4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A393EDF9-C2D3-ECF7-2C71-B58597561764}"/>
              </a:ext>
            </a:extLst>
          </p:cNvPr>
          <p:cNvCxnSpPr>
            <a:cxnSpLocks/>
          </p:cNvCxnSpPr>
          <p:nvPr/>
        </p:nvCxnSpPr>
        <p:spPr>
          <a:xfrm>
            <a:off x="3547637" y="3343018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C265FC4B-0293-C904-831F-70BC90D25D5A}"/>
              </a:ext>
            </a:extLst>
          </p:cNvPr>
          <p:cNvCxnSpPr>
            <a:cxnSpLocks/>
          </p:cNvCxnSpPr>
          <p:nvPr/>
        </p:nvCxnSpPr>
        <p:spPr>
          <a:xfrm>
            <a:off x="2811740" y="3931536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45269AC6-3327-BA09-1880-F64C237D4542}"/>
              </a:ext>
            </a:extLst>
          </p:cNvPr>
          <p:cNvSpPr txBox="1"/>
          <p:nvPr/>
        </p:nvSpPr>
        <p:spPr>
          <a:xfrm>
            <a:off x="2812720" y="3951355"/>
            <a:ext cx="504008" cy="2447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BC111614-939E-3E8D-ACC6-CF11829EE4B4}"/>
              </a:ext>
            </a:extLst>
          </p:cNvPr>
          <p:cNvSpPr/>
          <p:nvPr/>
        </p:nvSpPr>
        <p:spPr>
          <a:xfrm>
            <a:off x="2400676" y="4223970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6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584E92DA-793C-ADAF-6653-A31DBC2675A2}"/>
              </a:ext>
            </a:extLst>
          </p:cNvPr>
          <p:cNvCxnSpPr>
            <a:cxnSpLocks/>
          </p:cNvCxnSpPr>
          <p:nvPr/>
        </p:nvCxnSpPr>
        <p:spPr>
          <a:xfrm>
            <a:off x="5870851" y="3357175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>
            <a:extLst>
              <a:ext uri="{FF2B5EF4-FFF2-40B4-BE49-F238E27FC236}">
                <a16:creationId xmlns:a16="http://schemas.microsoft.com/office/drawing/2014/main" id="{2F584839-C4EF-E08B-0C51-361B76F20187}"/>
              </a:ext>
            </a:extLst>
          </p:cNvPr>
          <p:cNvSpPr/>
          <p:nvPr/>
        </p:nvSpPr>
        <p:spPr>
          <a:xfrm>
            <a:off x="4964382" y="3644803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65760952-F183-A6EF-C5A4-BAF573F6D54B}"/>
              </a:ext>
            </a:extLst>
          </p:cNvPr>
          <p:cNvCxnSpPr>
            <a:cxnSpLocks/>
          </p:cNvCxnSpPr>
          <p:nvPr/>
        </p:nvCxnSpPr>
        <p:spPr>
          <a:xfrm>
            <a:off x="5116782" y="3930822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EC55D7FB-BB7B-F44C-667F-0A7EF50F5DF8}"/>
              </a:ext>
            </a:extLst>
          </p:cNvPr>
          <p:cNvSpPr txBox="1"/>
          <p:nvPr/>
        </p:nvSpPr>
        <p:spPr>
          <a:xfrm>
            <a:off x="5116782" y="3950641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A03FC1D0-317F-8086-253B-9C011EEB6699}"/>
              </a:ext>
            </a:extLst>
          </p:cNvPr>
          <p:cNvSpPr/>
          <p:nvPr/>
        </p:nvSpPr>
        <p:spPr>
          <a:xfrm>
            <a:off x="4704853" y="422397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25</a:t>
            </a:r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72715810-9256-D029-4C03-06F8BB2718B9}"/>
              </a:ext>
            </a:extLst>
          </p:cNvPr>
          <p:cNvCxnSpPr>
            <a:cxnSpLocks/>
          </p:cNvCxnSpPr>
          <p:nvPr/>
        </p:nvCxnSpPr>
        <p:spPr>
          <a:xfrm>
            <a:off x="6564582" y="3930822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Oval 93">
            <a:extLst>
              <a:ext uri="{FF2B5EF4-FFF2-40B4-BE49-F238E27FC236}">
                <a16:creationId xmlns:a16="http://schemas.microsoft.com/office/drawing/2014/main" id="{395CC255-8289-3109-D268-A68AF33C7422}"/>
              </a:ext>
            </a:extLst>
          </p:cNvPr>
          <p:cNvSpPr/>
          <p:nvPr/>
        </p:nvSpPr>
        <p:spPr>
          <a:xfrm>
            <a:off x="6152652" y="422397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2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CA8D7B9-6961-861C-7AD9-8515B9664CF9}"/>
              </a:ext>
            </a:extLst>
          </p:cNvPr>
          <p:cNvSpPr txBox="1"/>
          <p:nvPr/>
        </p:nvSpPr>
        <p:spPr>
          <a:xfrm>
            <a:off x="6583510" y="3964416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4476BE-79D4-C5CC-DF23-6E2E7D6F374B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5B: Decision tree predicting no non-partner sexual violence among young women (aged 20-25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4679D688-9062-F84D-F639-850B06E892F2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In total, 87% of young women did not report surviving sexual violence from a non-partner in the last 12 months. This proportion increases to 96% among young women who completed social asset building (85%) and received educational social protection (89%) but not economic social protection (</a:t>
            </a:r>
            <a:r>
              <a:rPr lang="en-US" sz="1200" b="1" u="sng" dirty="0">
                <a:solidFill>
                  <a:schemeClr val="tx1"/>
                </a:solidFill>
              </a:rPr>
              <a:t>96%</a:t>
            </a:r>
            <a:r>
              <a:rPr lang="en-US" sz="12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2110454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5135185" y="58730"/>
            <a:ext cx="193686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Tested for HIV in last 12 months</a:t>
            </a:r>
          </a:p>
          <a:p>
            <a:pPr algn="ctr"/>
            <a:r>
              <a:rPr lang="en-US" sz="1000" b="1"/>
              <a:t>77%</a:t>
            </a:r>
          </a:p>
          <a:p>
            <a:pPr algn="ctr"/>
            <a:r>
              <a:rPr lang="en-US" sz="1000" b="1"/>
              <a:t>(n=388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7EA828D-B9F5-483E-9DAA-9B6D79B3EF02}"/>
              </a:ext>
            </a:extLst>
          </p:cNvPr>
          <p:cNvSpPr/>
          <p:nvPr/>
        </p:nvSpPr>
        <p:spPr>
          <a:xfrm>
            <a:off x="4742901" y="900424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5A77E48-FCCC-3D0F-3244-74D467909D7E}"/>
              </a:ext>
            </a:extLst>
          </p:cNvPr>
          <p:cNvCxnSpPr>
            <a:cxnSpLocks/>
          </p:cNvCxnSpPr>
          <p:nvPr/>
        </p:nvCxnSpPr>
        <p:spPr>
          <a:xfrm flipH="1">
            <a:off x="4947557" y="1191369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9413CA9-10F6-8DF5-AEBB-D60AA7105BDF}"/>
              </a:ext>
            </a:extLst>
          </p:cNvPr>
          <p:cNvSpPr txBox="1"/>
          <p:nvPr/>
        </p:nvSpPr>
        <p:spPr>
          <a:xfrm>
            <a:off x="4982934" y="1217078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9027035E-C213-D913-76AB-7F8408F8148A}"/>
              </a:ext>
            </a:extLst>
          </p:cNvPr>
          <p:cNvSpPr/>
          <p:nvPr/>
        </p:nvSpPr>
        <p:spPr>
          <a:xfrm>
            <a:off x="4533448" y="1487336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4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71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6103618" y="611233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DDDF19F5-BC9F-4FA9-CCC5-A65B6BD18BA3}"/>
              </a:ext>
            </a:extLst>
          </p:cNvPr>
          <p:cNvSpPr/>
          <p:nvPr/>
        </p:nvSpPr>
        <p:spPr>
          <a:xfrm>
            <a:off x="4033070" y="2220854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4E0BBCF-8123-24C5-50CE-28B0484A1C5C}"/>
              </a:ext>
            </a:extLst>
          </p:cNvPr>
          <p:cNvCxnSpPr>
            <a:cxnSpLocks/>
          </p:cNvCxnSpPr>
          <p:nvPr/>
        </p:nvCxnSpPr>
        <p:spPr>
          <a:xfrm>
            <a:off x="4247513" y="2511576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1D60924-238B-728E-A597-FB51D6D406A0}"/>
              </a:ext>
            </a:extLst>
          </p:cNvPr>
          <p:cNvSpPr txBox="1"/>
          <p:nvPr/>
        </p:nvSpPr>
        <p:spPr>
          <a:xfrm>
            <a:off x="4274382" y="2554227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A5A33F7A-C786-FDB6-7656-DBF69CD64173}"/>
              </a:ext>
            </a:extLst>
          </p:cNvPr>
          <p:cNvSpPr/>
          <p:nvPr/>
        </p:nvSpPr>
        <p:spPr>
          <a:xfrm>
            <a:off x="3835583" y="2797382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0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2BFC792D-7D34-7B08-A7BE-FE329113102D}"/>
              </a:ext>
            </a:extLst>
          </p:cNvPr>
          <p:cNvCxnSpPr>
            <a:cxnSpLocks/>
          </p:cNvCxnSpPr>
          <p:nvPr/>
        </p:nvCxnSpPr>
        <p:spPr>
          <a:xfrm>
            <a:off x="4939937" y="1919598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6ED0E8A2-16FD-45A7-2EAD-103F52E1B771}"/>
              </a:ext>
            </a:extLst>
          </p:cNvPr>
          <p:cNvSpPr/>
          <p:nvPr/>
        </p:nvSpPr>
        <p:spPr>
          <a:xfrm>
            <a:off x="3333113" y="3525774"/>
            <a:ext cx="1828800" cy="316650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CDF5CD2-8E8B-01D8-90D5-89720B458DDB}"/>
              </a:ext>
            </a:extLst>
          </p:cNvPr>
          <p:cNvCxnSpPr>
            <a:cxnSpLocks/>
          </p:cNvCxnSpPr>
          <p:nvPr/>
        </p:nvCxnSpPr>
        <p:spPr>
          <a:xfrm flipH="1">
            <a:off x="3523613" y="383957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EE99552-126D-51A7-89E3-1E4546488C94}"/>
              </a:ext>
            </a:extLst>
          </p:cNvPr>
          <p:cNvSpPr txBox="1"/>
          <p:nvPr/>
        </p:nvSpPr>
        <p:spPr>
          <a:xfrm>
            <a:off x="3550482" y="3882230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047F0D2D-ADE3-DA91-A500-37C654E004E0}"/>
              </a:ext>
            </a:extLst>
          </p:cNvPr>
          <p:cNvSpPr/>
          <p:nvPr/>
        </p:nvSpPr>
        <p:spPr>
          <a:xfrm>
            <a:off x="3111683" y="4145119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4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0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120B1FA-B943-29D0-D7B0-FCEB82E5EC66}"/>
              </a:ext>
            </a:extLst>
          </p:cNvPr>
          <p:cNvCxnSpPr>
            <a:cxnSpLocks/>
          </p:cNvCxnSpPr>
          <p:nvPr/>
        </p:nvCxnSpPr>
        <p:spPr>
          <a:xfrm>
            <a:off x="4247513" y="3236578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0869F11D-4739-AD9F-F5C7-92100A727AF3}"/>
              </a:ext>
            </a:extLst>
          </p:cNvPr>
          <p:cNvCxnSpPr>
            <a:cxnSpLocks/>
          </p:cNvCxnSpPr>
          <p:nvPr/>
        </p:nvCxnSpPr>
        <p:spPr>
          <a:xfrm>
            <a:off x="5438589" y="2511576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D786C330-03DA-AB84-AB2D-E86E6AA9E1B6}"/>
              </a:ext>
            </a:extLst>
          </p:cNvPr>
          <p:cNvSpPr txBox="1"/>
          <p:nvPr/>
        </p:nvSpPr>
        <p:spPr>
          <a:xfrm>
            <a:off x="5465458" y="2554227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7D9D274C-8333-02FC-52D8-43FDE55014DA}"/>
              </a:ext>
            </a:extLst>
          </p:cNvPr>
          <p:cNvSpPr/>
          <p:nvPr/>
        </p:nvSpPr>
        <p:spPr>
          <a:xfrm>
            <a:off x="5026659" y="2797382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4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0865811-1DE5-99AE-C42C-C8EE7AE5DAA8}"/>
              </a:ext>
            </a:extLst>
          </p:cNvPr>
          <p:cNvSpPr txBox="1"/>
          <p:nvPr/>
        </p:nvSpPr>
        <p:spPr>
          <a:xfrm>
            <a:off x="7247415" y="1217078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2BD1F758-C7CA-9AB2-2F70-3DFDC9151FEF}"/>
              </a:ext>
            </a:extLst>
          </p:cNvPr>
          <p:cNvSpPr/>
          <p:nvPr/>
        </p:nvSpPr>
        <p:spPr>
          <a:xfrm>
            <a:off x="6834505" y="151185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17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81DB0A19-4084-4715-43A0-32706C0EB71F}"/>
              </a:ext>
            </a:extLst>
          </p:cNvPr>
          <p:cNvCxnSpPr>
            <a:cxnSpLocks/>
          </p:cNvCxnSpPr>
          <p:nvPr/>
        </p:nvCxnSpPr>
        <p:spPr>
          <a:xfrm>
            <a:off x="7246435" y="1955956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206AE71C-03F3-B374-2F64-45956A6C0F07}"/>
              </a:ext>
            </a:extLst>
          </p:cNvPr>
          <p:cNvCxnSpPr>
            <a:cxnSpLocks/>
          </p:cNvCxnSpPr>
          <p:nvPr/>
        </p:nvCxnSpPr>
        <p:spPr>
          <a:xfrm>
            <a:off x="7246435" y="119275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4C60FBCA-B5E0-7F6D-9954-27DD00627730}"/>
              </a:ext>
            </a:extLst>
          </p:cNvPr>
          <p:cNvSpPr/>
          <p:nvPr/>
        </p:nvSpPr>
        <p:spPr>
          <a:xfrm>
            <a:off x="6339966" y="2225372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6EB9D6B4-BBD6-4AFA-EF4B-F8F1B7F800A4}"/>
              </a:ext>
            </a:extLst>
          </p:cNvPr>
          <p:cNvCxnSpPr>
            <a:cxnSpLocks/>
          </p:cNvCxnSpPr>
          <p:nvPr/>
        </p:nvCxnSpPr>
        <p:spPr>
          <a:xfrm>
            <a:off x="6463791" y="2516317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64D16628-2F00-C4AB-9CAC-3A19976CD5A1}"/>
              </a:ext>
            </a:extLst>
          </p:cNvPr>
          <p:cNvSpPr txBox="1"/>
          <p:nvPr/>
        </p:nvSpPr>
        <p:spPr>
          <a:xfrm>
            <a:off x="6463791" y="2542035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71F2A0BF-D2A7-964B-10CB-CC8E6BAEF39F}"/>
              </a:ext>
            </a:extLst>
          </p:cNvPr>
          <p:cNvSpPr/>
          <p:nvPr/>
        </p:nvSpPr>
        <p:spPr>
          <a:xfrm>
            <a:off x="6051861" y="2792554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98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2DF87118-2CBE-BB12-99A5-815C25ABD500}"/>
              </a:ext>
            </a:extLst>
          </p:cNvPr>
          <p:cNvCxnSpPr>
            <a:cxnSpLocks/>
          </p:cNvCxnSpPr>
          <p:nvPr/>
        </p:nvCxnSpPr>
        <p:spPr>
          <a:xfrm>
            <a:off x="7940166" y="2516317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CE60A70B-E562-66BC-B1CB-31038E02CF2F}"/>
              </a:ext>
            </a:extLst>
          </p:cNvPr>
          <p:cNvSpPr txBox="1"/>
          <p:nvPr/>
        </p:nvSpPr>
        <p:spPr>
          <a:xfrm>
            <a:off x="7940166" y="2542035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3DA24045-FB0A-5F9B-1788-29D1BD990B8F}"/>
              </a:ext>
            </a:extLst>
          </p:cNvPr>
          <p:cNvSpPr/>
          <p:nvPr/>
        </p:nvSpPr>
        <p:spPr>
          <a:xfrm>
            <a:off x="7528236" y="2792554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9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37E8ECAF-A08E-194D-F055-0AF3185EC2AF}"/>
              </a:ext>
            </a:extLst>
          </p:cNvPr>
          <p:cNvCxnSpPr>
            <a:cxnSpLocks/>
          </p:cNvCxnSpPr>
          <p:nvPr/>
        </p:nvCxnSpPr>
        <p:spPr>
          <a:xfrm>
            <a:off x="4909457" y="3859251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EA22AB20-077A-2D66-9D26-1625BB037606}"/>
              </a:ext>
            </a:extLst>
          </p:cNvPr>
          <p:cNvSpPr txBox="1"/>
          <p:nvPr/>
        </p:nvSpPr>
        <p:spPr>
          <a:xfrm>
            <a:off x="4909457" y="3884969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9C267704-220A-39DE-1551-0CCBAC5F7AF0}"/>
              </a:ext>
            </a:extLst>
          </p:cNvPr>
          <p:cNvSpPr/>
          <p:nvPr/>
        </p:nvSpPr>
        <p:spPr>
          <a:xfrm>
            <a:off x="4497527" y="4152817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2FFA017-7B0F-989F-F4DC-C3624CD3EEAF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B: Decision tree predicting HIV testing in the last 12 months among young women (aged 20-25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EE6A1E75-2B3F-0CBD-30BA-88E708FBF626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The node at the very top indicates the overall occurrence of this outcome among young women. In total, 77% of all young women tested for HIV in the last 12 months. This proportion is maximized among young women who did not receive economic social protection (74%) yet received educational social protection (79%) but not social asset building (</a:t>
            </a:r>
            <a:r>
              <a:rPr lang="en-US" sz="1200" b="1" u="sng" dirty="0">
                <a:solidFill>
                  <a:schemeClr val="tx1"/>
                </a:solidFill>
              </a:rPr>
              <a:t>91%</a:t>
            </a:r>
            <a:r>
              <a:rPr lang="en-US" sz="12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285761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4947708" y="57235"/>
            <a:ext cx="237744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Consistent condom use in last 12 months 33%</a:t>
            </a:r>
          </a:p>
          <a:p>
            <a:pPr algn="ctr"/>
            <a:r>
              <a:rPr lang="en-US" sz="1000" b="1"/>
              <a:t>(n=13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7EA828D-B9F5-483E-9DAA-9B6D79B3EF02}"/>
              </a:ext>
            </a:extLst>
          </p:cNvPr>
          <p:cNvSpPr/>
          <p:nvPr/>
        </p:nvSpPr>
        <p:spPr>
          <a:xfrm>
            <a:off x="5221878" y="900424"/>
            <a:ext cx="1828800" cy="290945"/>
          </a:xfrm>
          <a:prstGeom prst="rect">
            <a:avLst/>
          </a:prstGeom>
          <a:noFill/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5A77E48-FCCC-3D0F-3244-74D467909D7E}"/>
              </a:ext>
            </a:extLst>
          </p:cNvPr>
          <p:cNvCxnSpPr>
            <a:cxnSpLocks/>
          </p:cNvCxnSpPr>
          <p:nvPr/>
        </p:nvCxnSpPr>
        <p:spPr>
          <a:xfrm>
            <a:off x="6805144" y="1191369"/>
            <a:ext cx="0" cy="306125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9413CA9-10F6-8DF5-AEBB-D60AA7105BDF}"/>
              </a:ext>
            </a:extLst>
          </p:cNvPr>
          <p:cNvSpPr txBox="1"/>
          <p:nvPr/>
        </p:nvSpPr>
        <p:spPr>
          <a:xfrm>
            <a:off x="6806124" y="1253517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9027035E-C213-D913-76AB-7F8408F8148A}"/>
              </a:ext>
            </a:extLst>
          </p:cNvPr>
          <p:cNvSpPr/>
          <p:nvPr/>
        </p:nvSpPr>
        <p:spPr>
          <a:xfrm>
            <a:off x="6393214" y="1497494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4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6136278" y="611233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A1411C30-60E2-5BDC-C832-88A602371D59}"/>
              </a:ext>
            </a:extLst>
          </p:cNvPr>
          <p:cNvSpPr txBox="1"/>
          <p:nvPr/>
        </p:nvSpPr>
        <p:spPr>
          <a:xfrm>
            <a:off x="5478395" y="1253517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E7EE99E2-03BC-6272-9B8D-DF1DDFD31447}"/>
              </a:ext>
            </a:extLst>
          </p:cNvPr>
          <p:cNvSpPr/>
          <p:nvPr/>
        </p:nvSpPr>
        <p:spPr>
          <a:xfrm>
            <a:off x="5065485" y="1501019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2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472007E8-6CF0-3E24-ADD6-09F2C66CF2B4}"/>
              </a:ext>
            </a:extLst>
          </p:cNvPr>
          <p:cNvCxnSpPr>
            <a:cxnSpLocks/>
          </p:cNvCxnSpPr>
          <p:nvPr/>
        </p:nvCxnSpPr>
        <p:spPr>
          <a:xfrm>
            <a:off x="5477415" y="1945118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16410FC-1EAC-E460-8C3D-CB1FC30E04B0}"/>
              </a:ext>
            </a:extLst>
          </p:cNvPr>
          <p:cNvCxnSpPr>
            <a:cxnSpLocks/>
          </p:cNvCxnSpPr>
          <p:nvPr/>
        </p:nvCxnSpPr>
        <p:spPr>
          <a:xfrm>
            <a:off x="5477415" y="1223174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3AE2E5CE-9F01-897F-3493-23DD133E470A}"/>
              </a:ext>
            </a:extLst>
          </p:cNvPr>
          <p:cNvSpPr/>
          <p:nvPr/>
        </p:nvSpPr>
        <p:spPr>
          <a:xfrm>
            <a:off x="4570946" y="2214534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43F21E04-1307-EDF6-4110-FB9D3F7BEF52}"/>
              </a:ext>
            </a:extLst>
          </p:cNvPr>
          <p:cNvCxnSpPr>
            <a:cxnSpLocks/>
          </p:cNvCxnSpPr>
          <p:nvPr/>
        </p:nvCxnSpPr>
        <p:spPr>
          <a:xfrm>
            <a:off x="4694771" y="250547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125B8F95-D845-A001-856B-8018FEAAB3CF}"/>
              </a:ext>
            </a:extLst>
          </p:cNvPr>
          <p:cNvSpPr txBox="1"/>
          <p:nvPr/>
        </p:nvSpPr>
        <p:spPr>
          <a:xfrm>
            <a:off x="4694771" y="2531197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075F78B4-5C22-4837-5FDC-4E18C6314A2A}"/>
              </a:ext>
            </a:extLst>
          </p:cNvPr>
          <p:cNvSpPr/>
          <p:nvPr/>
        </p:nvSpPr>
        <p:spPr>
          <a:xfrm>
            <a:off x="4282841" y="278171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3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358005D6-664D-3C0D-EE5F-67388F02898C}"/>
              </a:ext>
            </a:extLst>
          </p:cNvPr>
          <p:cNvCxnSpPr>
            <a:cxnSpLocks/>
          </p:cNvCxnSpPr>
          <p:nvPr/>
        </p:nvCxnSpPr>
        <p:spPr>
          <a:xfrm>
            <a:off x="6171146" y="250547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1CCF0785-FAE9-ADA6-044A-879DD7681DDC}"/>
              </a:ext>
            </a:extLst>
          </p:cNvPr>
          <p:cNvSpPr txBox="1"/>
          <p:nvPr/>
        </p:nvSpPr>
        <p:spPr>
          <a:xfrm>
            <a:off x="6171146" y="2531197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AD5E27F9-120B-68FF-0AA4-D4DC36293D6B}"/>
              </a:ext>
            </a:extLst>
          </p:cNvPr>
          <p:cNvSpPr/>
          <p:nvPr/>
        </p:nvSpPr>
        <p:spPr>
          <a:xfrm>
            <a:off x="5759216" y="278171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075786F-A472-A64B-2EBF-D897D5877610}"/>
              </a:ext>
            </a:extLst>
          </p:cNvPr>
          <p:cNvCxnSpPr>
            <a:cxnSpLocks/>
          </p:cNvCxnSpPr>
          <p:nvPr/>
        </p:nvCxnSpPr>
        <p:spPr>
          <a:xfrm>
            <a:off x="4691308" y="322079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BD003571-515F-8944-EF01-B641B9A0229B}"/>
              </a:ext>
            </a:extLst>
          </p:cNvPr>
          <p:cNvSpPr/>
          <p:nvPr/>
        </p:nvSpPr>
        <p:spPr>
          <a:xfrm>
            <a:off x="3784839" y="3490215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88A2880-228B-56DD-528E-15B585334263}"/>
              </a:ext>
            </a:extLst>
          </p:cNvPr>
          <p:cNvCxnSpPr>
            <a:cxnSpLocks/>
          </p:cNvCxnSpPr>
          <p:nvPr/>
        </p:nvCxnSpPr>
        <p:spPr>
          <a:xfrm>
            <a:off x="3908664" y="378116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88B2E8F3-5BCA-089B-D76B-451BA41D3F14}"/>
              </a:ext>
            </a:extLst>
          </p:cNvPr>
          <p:cNvSpPr txBox="1"/>
          <p:nvPr/>
        </p:nvSpPr>
        <p:spPr>
          <a:xfrm>
            <a:off x="3908664" y="3806878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CE2EB2AE-22B6-9077-547C-5482D780080E}"/>
              </a:ext>
            </a:extLst>
          </p:cNvPr>
          <p:cNvSpPr/>
          <p:nvPr/>
        </p:nvSpPr>
        <p:spPr>
          <a:xfrm>
            <a:off x="3496734" y="405739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2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4</a:t>
            </a: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2865E122-FA4A-D9BE-BAE0-89D064104383}"/>
              </a:ext>
            </a:extLst>
          </p:cNvPr>
          <p:cNvCxnSpPr>
            <a:cxnSpLocks/>
          </p:cNvCxnSpPr>
          <p:nvPr/>
        </p:nvCxnSpPr>
        <p:spPr>
          <a:xfrm>
            <a:off x="5385039" y="378116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7379706C-28C8-2715-1F28-C29D6EBB591D}"/>
              </a:ext>
            </a:extLst>
          </p:cNvPr>
          <p:cNvSpPr txBox="1"/>
          <p:nvPr/>
        </p:nvSpPr>
        <p:spPr>
          <a:xfrm>
            <a:off x="5385039" y="3806878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ECCC83E6-AE73-4EF7-DEDB-2C7C3BFDABCD}"/>
              </a:ext>
            </a:extLst>
          </p:cNvPr>
          <p:cNvSpPr/>
          <p:nvPr/>
        </p:nvSpPr>
        <p:spPr>
          <a:xfrm>
            <a:off x="4973109" y="405739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4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52344827-1609-BABB-5FDC-E4389A8ED1C0}"/>
              </a:ext>
            </a:extLst>
          </p:cNvPr>
          <p:cNvCxnSpPr>
            <a:cxnSpLocks/>
          </p:cNvCxnSpPr>
          <p:nvPr/>
        </p:nvCxnSpPr>
        <p:spPr>
          <a:xfrm>
            <a:off x="3903114" y="450344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385A5995-AF15-105D-21FE-7F17C73894D9}"/>
              </a:ext>
            </a:extLst>
          </p:cNvPr>
          <p:cNvSpPr/>
          <p:nvPr/>
        </p:nvSpPr>
        <p:spPr>
          <a:xfrm>
            <a:off x="2996645" y="4772865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8A435A16-1297-B541-A909-9A2DB3BACC2B}"/>
              </a:ext>
            </a:extLst>
          </p:cNvPr>
          <p:cNvCxnSpPr>
            <a:cxnSpLocks/>
          </p:cNvCxnSpPr>
          <p:nvPr/>
        </p:nvCxnSpPr>
        <p:spPr>
          <a:xfrm>
            <a:off x="3120470" y="506381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D56B44D7-330B-8299-D884-4C5982E68646}"/>
              </a:ext>
            </a:extLst>
          </p:cNvPr>
          <p:cNvSpPr txBox="1"/>
          <p:nvPr/>
        </p:nvSpPr>
        <p:spPr>
          <a:xfrm>
            <a:off x="3120470" y="5089528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AC92470A-D1C0-1498-D169-328B8CD451EF}"/>
              </a:ext>
            </a:extLst>
          </p:cNvPr>
          <p:cNvSpPr/>
          <p:nvPr/>
        </p:nvSpPr>
        <p:spPr>
          <a:xfrm>
            <a:off x="2708540" y="534004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2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3A8AED67-8434-0071-8050-F58B1A101807}"/>
              </a:ext>
            </a:extLst>
          </p:cNvPr>
          <p:cNvCxnSpPr>
            <a:cxnSpLocks/>
          </p:cNvCxnSpPr>
          <p:nvPr/>
        </p:nvCxnSpPr>
        <p:spPr>
          <a:xfrm>
            <a:off x="4596845" y="506381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1BB779F6-1634-E24B-10CF-C0269C95017F}"/>
              </a:ext>
            </a:extLst>
          </p:cNvPr>
          <p:cNvSpPr txBox="1"/>
          <p:nvPr/>
        </p:nvSpPr>
        <p:spPr>
          <a:xfrm>
            <a:off x="4596845" y="5089528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A615924E-FEFC-B662-67DE-F74F35B04E8E}"/>
              </a:ext>
            </a:extLst>
          </p:cNvPr>
          <p:cNvSpPr/>
          <p:nvPr/>
        </p:nvSpPr>
        <p:spPr>
          <a:xfrm>
            <a:off x="4184915" y="534004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2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FBE6CFA-D5D1-FD58-EB6E-1AAAD58E35B4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A: Decision tree predicting consistent condom use among adolescent girls (aged 15-19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id="{B6D6C500-14D5-B1D9-CEBD-5E5079CA7AC8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Overall, 33% of adolescent girls consistently used condoms in the last 12 months. This proportion increases to </a:t>
            </a:r>
            <a:r>
              <a:rPr lang="en-US" sz="1200" b="1" u="sng" dirty="0">
                <a:solidFill>
                  <a:schemeClr val="tx1"/>
                </a:solidFill>
              </a:rPr>
              <a:t>46%</a:t>
            </a:r>
            <a:r>
              <a:rPr lang="en-US" sz="1200" dirty="0">
                <a:solidFill>
                  <a:schemeClr val="tx1"/>
                </a:solidFill>
              </a:rPr>
              <a:t> among adolescent girls who received economic social protection.</a:t>
            </a:r>
          </a:p>
        </p:txBody>
      </p:sp>
    </p:spTree>
    <p:extLst>
      <p:ext uri="{BB962C8B-B14F-4D97-AF65-F5344CB8AC3E}">
        <p14:creationId xmlns:p14="http://schemas.microsoft.com/office/powerpoint/2010/main" val="985054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4866670" y="58730"/>
            <a:ext cx="24688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Consistent condom use in last 12 months 36%</a:t>
            </a:r>
          </a:p>
          <a:p>
            <a:pPr algn="ctr"/>
            <a:r>
              <a:rPr lang="en-US" sz="1000" b="1"/>
              <a:t>(n=57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470C7-4FF4-D342-99E8-E8F821044953}"/>
              </a:ext>
            </a:extLst>
          </p:cNvPr>
          <p:cNvSpPr/>
          <p:nvPr/>
        </p:nvSpPr>
        <p:spPr>
          <a:xfrm>
            <a:off x="5200106" y="902696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A32A644-ADF7-B3AD-56F1-67002BDA0FAA}"/>
              </a:ext>
            </a:extLst>
          </p:cNvPr>
          <p:cNvCxnSpPr>
            <a:cxnSpLocks/>
          </p:cNvCxnSpPr>
          <p:nvPr/>
        </p:nvCxnSpPr>
        <p:spPr>
          <a:xfrm>
            <a:off x="5428702" y="1193641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7F66CB6-4E6C-859F-482C-E5DC7F7A965E}"/>
              </a:ext>
            </a:extLst>
          </p:cNvPr>
          <p:cNvSpPr txBox="1"/>
          <p:nvPr/>
        </p:nvSpPr>
        <p:spPr>
          <a:xfrm>
            <a:off x="5428702" y="121935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EF87472D-AF95-9A97-3335-2A576870F4F7}"/>
              </a:ext>
            </a:extLst>
          </p:cNvPr>
          <p:cNvSpPr/>
          <p:nvPr/>
        </p:nvSpPr>
        <p:spPr>
          <a:xfrm>
            <a:off x="5016772" y="148283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4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4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7EA828D-B9F5-483E-9DAA-9B6D79B3EF02}"/>
              </a:ext>
            </a:extLst>
          </p:cNvPr>
          <p:cNvSpPr/>
          <p:nvPr/>
        </p:nvSpPr>
        <p:spPr>
          <a:xfrm>
            <a:off x="4514302" y="2204291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5A77E48-FCCC-3D0F-3244-74D467909D7E}"/>
              </a:ext>
            </a:extLst>
          </p:cNvPr>
          <p:cNvCxnSpPr>
            <a:cxnSpLocks/>
            <a:endCxn id="22" idx="0"/>
          </p:cNvCxnSpPr>
          <p:nvPr/>
        </p:nvCxnSpPr>
        <p:spPr>
          <a:xfrm>
            <a:off x="6091061" y="2495236"/>
            <a:ext cx="0" cy="289484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9413CA9-10F6-8DF5-AEBB-D60AA7105BDF}"/>
              </a:ext>
            </a:extLst>
          </p:cNvPr>
          <p:cNvSpPr txBox="1"/>
          <p:nvPr/>
        </p:nvSpPr>
        <p:spPr>
          <a:xfrm>
            <a:off x="6092041" y="2521241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9027035E-C213-D913-76AB-7F8408F8148A}"/>
              </a:ext>
            </a:extLst>
          </p:cNvPr>
          <p:cNvSpPr/>
          <p:nvPr/>
        </p:nvSpPr>
        <p:spPr>
          <a:xfrm>
            <a:off x="5679131" y="2784720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4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0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5428702" y="1915100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327A96A-39C5-C698-FC91-0BCEBBCFF434}"/>
              </a:ext>
            </a:extLst>
          </p:cNvPr>
          <p:cNvCxnSpPr>
            <a:cxnSpLocks/>
          </p:cNvCxnSpPr>
          <p:nvPr/>
        </p:nvCxnSpPr>
        <p:spPr>
          <a:xfrm>
            <a:off x="6108875" y="638906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DDDF19F5-BC9F-4FA9-CCC5-A65B6BD18BA3}"/>
              </a:ext>
            </a:extLst>
          </p:cNvPr>
          <p:cNvSpPr/>
          <p:nvPr/>
        </p:nvSpPr>
        <p:spPr>
          <a:xfrm>
            <a:off x="5182518" y="3526838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4E0BBCF-8123-24C5-50CE-28B0484A1C5C}"/>
              </a:ext>
            </a:extLst>
          </p:cNvPr>
          <p:cNvCxnSpPr>
            <a:cxnSpLocks/>
          </p:cNvCxnSpPr>
          <p:nvPr/>
        </p:nvCxnSpPr>
        <p:spPr>
          <a:xfrm>
            <a:off x="6759272" y="3823645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1D60924-238B-728E-A597-FB51D6D406A0}"/>
              </a:ext>
            </a:extLst>
          </p:cNvPr>
          <p:cNvSpPr txBox="1"/>
          <p:nvPr/>
        </p:nvSpPr>
        <p:spPr>
          <a:xfrm>
            <a:off x="6759272" y="3842848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A5A33F7A-C786-FDB6-7656-DBF69CD64173}"/>
              </a:ext>
            </a:extLst>
          </p:cNvPr>
          <p:cNvSpPr/>
          <p:nvPr/>
        </p:nvSpPr>
        <p:spPr>
          <a:xfrm>
            <a:off x="6347342" y="4102413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4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7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2BFC792D-7D34-7B08-A7BE-FE329113102D}"/>
              </a:ext>
            </a:extLst>
          </p:cNvPr>
          <p:cNvCxnSpPr>
            <a:cxnSpLocks/>
          </p:cNvCxnSpPr>
          <p:nvPr/>
        </p:nvCxnSpPr>
        <p:spPr>
          <a:xfrm>
            <a:off x="6096918" y="3237642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6ED0E8A2-16FD-45A7-2EAD-103F52E1B771}"/>
              </a:ext>
            </a:extLst>
          </p:cNvPr>
          <p:cNvSpPr/>
          <p:nvPr/>
        </p:nvSpPr>
        <p:spPr>
          <a:xfrm>
            <a:off x="5830325" y="4830805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CDF5CD2-8E8B-01D8-90D5-89720B458DDB}"/>
              </a:ext>
            </a:extLst>
          </p:cNvPr>
          <p:cNvCxnSpPr>
            <a:cxnSpLocks/>
          </p:cNvCxnSpPr>
          <p:nvPr/>
        </p:nvCxnSpPr>
        <p:spPr>
          <a:xfrm>
            <a:off x="7407072" y="5139002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EE99552-126D-51A7-89E3-1E4546488C94}"/>
              </a:ext>
            </a:extLst>
          </p:cNvPr>
          <p:cNvSpPr txBox="1"/>
          <p:nvPr/>
        </p:nvSpPr>
        <p:spPr>
          <a:xfrm>
            <a:off x="7407072" y="5164401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047F0D2D-ADE3-DA91-A500-37C654E004E0}"/>
              </a:ext>
            </a:extLst>
          </p:cNvPr>
          <p:cNvSpPr/>
          <p:nvPr/>
        </p:nvSpPr>
        <p:spPr>
          <a:xfrm>
            <a:off x="6995142" y="5428199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4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4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120B1FA-B943-29D0-D7B0-FCEB82E5EC66}"/>
              </a:ext>
            </a:extLst>
          </p:cNvPr>
          <p:cNvCxnSpPr>
            <a:cxnSpLocks/>
          </p:cNvCxnSpPr>
          <p:nvPr/>
        </p:nvCxnSpPr>
        <p:spPr>
          <a:xfrm>
            <a:off x="6744725" y="4534675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A5317E44-7AE0-8490-2D73-24AAB02EE670}"/>
              </a:ext>
            </a:extLst>
          </p:cNvPr>
          <p:cNvCxnSpPr>
            <a:cxnSpLocks/>
          </p:cNvCxnSpPr>
          <p:nvPr/>
        </p:nvCxnSpPr>
        <p:spPr>
          <a:xfrm>
            <a:off x="6782355" y="119364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8F4EC9D0-9E23-18A9-FB1F-D40F8119600C}"/>
              </a:ext>
            </a:extLst>
          </p:cNvPr>
          <p:cNvSpPr txBox="1"/>
          <p:nvPr/>
        </p:nvSpPr>
        <p:spPr>
          <a:xfrm>
            <a:off x="6782355" y="121935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0B771CF8-8AFB-D704-C83F-F6FAD08EBBF2}"/>
              </a:ext>
            </a:extLst>
          </p:cNvPr>
          <p:cNvSpPr/>
          <p:nvPr/>
        </p:nvSpPr>
        <p:spPr>
          <a:xfrm>
            <a:off x="6370425" y="148283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3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3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4065078-9BC4-ACFE-5EB1-7C43181F3759}"/>
              </a:ext>
            </a:extLst>
          </p:cNvPr>
          <p:cNvCxnSpPr>
            <a:cxnSpLocks/>
          </p:cNvCxnSpPr>
          <p:nvPr/>
        </p:nvCxnSpPr>
        <p:spPr>
          <a:xfrm>
            <a:off x="4693031" y="2495523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5ECFE6E3-CBC6-10F7-D54C-3CA3E0D123A8}"/>
              </a:ext>
            </a:extLst>
          </p:cNvPr>
          <p:cNvSpPr txBox="1"/>
          <p:nvPr/>
        </p:nvSpPr>
        <p:spPr>
          <a:xfrm>
            <a:off x="4693031" y="2521241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F613E8A1-AE98-97E9-9C33-D1A71E681341}"/>
              </a:ext>
            </a:extLst>
          </p:cNvPr>
          <p:cNvSpPr/>
          <p:nvPr/>
        </p:nvSpPr>
        <p:spPr>
          <a:xfrm>
            <a:off x="4281101" y="278472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3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4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F4241FD3-CF8C-D302-1135-A7835E2A0753}"/>
              </a:ext>
            </a:extLst>
          </p:cNvPr>
          <p:cNvCxnSpPr>
            <a:cxnSpLocks/>
          </p:cNvCxnSpPr>
          <p:nvPr/>
        </p:nvCxnSpPr>
        <p:spPr>
          <a:xfrm>
            <a:off x="5356641" y="381461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2F78C71-E1C4-022D-420D-0D14BAB0096D}"/>
              </a:ext>
            </a:extLst>
          </p:cNvPr>
          <p:cNvSpPr txBox="1"/>
          <p:nvPr/>
        </p:nvSpPr>
        <p:spPr>
          <a:xfrm>
            <a:off x="5356641" y="384032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C24EBE17-2960-DCA3-5B50-216DA8CC84B7}"/>
              </a:ext>
            </a:extLst>
          </p:cNvPr>
          <p:cNvSpPr/>
          <p:nvPr/>
        </p:nvSpPr>
        <p:spPr>
          <a:xfrm>
            <a:off x="4944711" y="410380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3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F0FBD3CA-BBEE-B44F-FA53-11F08A6ECD7E}"/>
              </a:ext>
            </a:extLst>
          </p:cNvPr>
          <p:cNvCxnSpPr>
            <a:cxnSpLocks/>
          </p:cNvCxnSpPr>
          <p:nvPr/>
        </p:nvCxnSpPr>
        <p:spPr>
          <a:xfrm>
            <a:off x="6011877" y="5139002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45851F7E-F8AB-1B23-B665-0C0E41B27987}"/>
              </a:ext>
            </a:extLst>
          </p:cNvPr>
          <p:cNvSpPr txBox="1"/>
          <p:nvPr/>
        </p:nvSpPr>
        <p:spPr>
          <a:xfrm>
            <a:off x="6011877" y="5164720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E3DEC511-9FD5-45DD-E65C-0BC34732714D}"/>
              </a:ext>
            </a:extLst>
          </p:cNvPr>
          <p:cNvSpPr/>
          <p:nvPr/>
        </p:nvSpPr>
        <p:spPr>
          <a:xfrm>
            <a:off x="5599947" y="5428199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52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DB83AD6-C5CF-9A36-A4AC-1D075931E0C0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B: Decision tree predicting consistent condom use among young women (aged 20-25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3B50BAD7-44F0-4A2D-2AF6-5BAED6716943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In sum, 36% of young women consistently used condoms in the last 12 months. This proportion increases among those who completed the social asset building (41%) but did not receive economic social protection (46%) and educational social protection (49%) but was exposed to youth-friendly health services (</a:t>
            </a:r>
            <a:r>
              <a:rPr lang="en-US" sz="1200" b="1" u="sng" dirty="0">
                <a:solidFill>
                  <a:schemeClr val="tx1"/>
                </a:solidFill>
              </a:rPr>
              <a:t>52%</a:t>
            </a:r>
            <a:r>
              <a:rPr lang="en-US" sz="12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536820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Oval 21">
            <a:extLst>
              <a:ext uri="{FF2B5EF4-FFF2-40B4-BE49-F238E27FC236}">
                <a16:creationId xmlns:a16="http://schemas.microsoft.com/office/drawing/2014/main" id="{9027035E-C213-D913-76AB-7F8408F8148A}"/>
              </a:ext>
            </a:extLst>
          </p:cNvPr>
          <p:cNvSpPr/>
          <p:nvPr/>
        </p:nvSpPr>
        <p:spPr>
          <a:xfrm>
            <a:off x="5208004" y="2797821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0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4899330" y="58730"/>
            <a:ext cx="24688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No transactional sex in last 12 months</a:t>
            </a:r>
          </a:p>
          <a:p>
            <a:pPr algn="ctr"/>
            <a:r>
              <a:rPr lang="en-US" sz="1000" b="1"/>
              <a:t>94%</a:t>
            </a:r>
          </a:p>
          <a:p>
            <a:pPr algn="ctr"/>
            <a:r>
              <a:rPr lang="en-US" sz="1000" b="1"/>
              <a:t>(n=91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470C7-4FF4-D342-99E8-E8F821044953}"/>
              </a:ext>
            </a:extLst>
          </p:cNvPr>
          <p:cNvSpPr/>
          <p:nvPr/>
        </p:nvSpPr>
        <p:spPr>
          <a:xfrm>
            <a:off x="4767098" y="902696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A32A644-ADF7-B3AD-56F1-67002BDA0FAA}"/>
              </a:ext>
            </a:extLst>
          </p:cNvPr>
          <p:cNvCxnSpPr>
            <a:cxnSpLocks/>
          </p:cNvCxnSpPr>
          <p:nvPr/>
        </p:nvCxnSpPr>
        <p:spPr>
          <a:xfrm>
            <a:off x="4961826" y="1193641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7F66CB6-4E6C-859F-482C-E5DC7F7A965E}"/>
              </a:ext>
            </a:extLst>
          </p:cNvPr>
          <p:cNvSpPr txBox="1"/>
          <p:nvPr/>
        </p:nvSpPr>
        <p:spPr>
          <a:xfrm>
            <a:off x="4961826" y="1219359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EF87472D-AF95-9A97-3335-2A576870F4F7}"/>
              </a:ext>
            </a:extLst>
          </p:cNvPr>
          <p:cNvSpPr/>
          <p:nvPr/>
        </p:nvSpPr>
        <p:spPr>
          <a:xfrm>
            <a:off x="4549896" y="148283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40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7EA828D-B9F5-483E-9DAA-9B6D79B3EF02}"/>
              </a:ext>
            </a:extLst>
          </p:cNvPr>
          <p:cNvSpPr/>
          <p:nvPr/>
        </p:nvSpPr>
        <p:spPr>
          <a:xfrm>
            <a:off x="4047426" y="2204291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5A77E48-FCCC-3D0F-3244-74D467909D7E}"/>
              </a:ext>
            </a:extLst>
          </p:cNvPr>
          <p:cNvCxnSpPr>
            <a:cxnSpLocks/>
          </p:cNvCxnSpPr>
          <p:nvPr/>
        </p:nvCxnSpPr>
        <p:spPr>
          <a:xfrm>
            <a:off x="4322914" y="2508624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69413CA9-10F6-8DF5-AEBB-D60AA7105BDF}"/>
              </a:ext>
            </a:extLst>
          </p:cNvPr>
          <p:cNvSpPr txBox="1"/>
          <p:nvPr/>
        </p:nvSpPr>
        <p:spPr>
          <a:xfrm>
            <a:off x="4323894" y="2528443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4961826" y="1915100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327A96A-39C5-C698-FC91-0BCEBBCFF434}"/>
              </a:ext>
            </a:extLst>
          </p:cNvPr>
          <p:cNvCxnSpPr>
            <a:cxnSpLocks/>
          </p:cNvCxnSpPr>
          <p:nvPr/>
        </p:nvCxnSpPr>
        <p:spPr>
          <a:xfrm>
            <a:off x="6141535" y="618125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4E0BBCF-8123-24C5-50CE-28B0484A1C5C}"/>
              </a:ext>
            </a:extLst>
          </p:cNvPr>
          <p:cNvCxnSpPr>
            <a:cxnSpLocks/>
            <a:endCxn id="33" idx="0"/>
          </p:cNvCxnSpPr>
          <p:nvPr/>
        </p:nvCxnSpPr>
        <p:spPr>
          <a:xfrm>
            <a:off x="7262377" y="1193958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1D60924-238B-728E-A597-FB51D6D406A0}"/>
              </a:ext>
            </a:extLst>
          </p:cNvPr>
          <p:cNvSpPr txBox="1"/>
          <p:nvPr/>
        </p:nvSpPr>
        <p:spPr>
          <a:xfrm>
            <a:off x="7262376" y="121935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A5A33F7A-C786-FDB6-7656-DBF69CD64173}"/>
              </a:ext>
            </a:extLst>
          </p:cNvPr>
          <p:cNvSpPr/>
          <p:nvPr/>
        </p:nvSpPr>
        <p:spPr>
          <a:xfrm>
            <a:off x="6850447" y="148283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51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ED0E8A2-16FD-45A7-2EAD-103F52E1B771}"/>
              </a:ext>
            </a:extLst>
          </p:cNvPr>
          <p:cNvSpPr/>
          <p:nvPr/>
        </p:nvSpPr>
        <p:spPr>
          <a:xfrm>
            <a:off x="6333430" y="2204291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CDF5CD2-8E8B-01D8-90D5-89720B458DDB}"/>
              </a:ext>
            </a:extLst>
          </p:cNvPr>
          <p:cNvCxnSpPr>
            <a:cxnSpLocks/>
          </p:cNvCxnSpPr>
          <p:nvPr/>
        </p:nvCxnSpPr>
        <p:spPr>
          <a:xfrm>
            <a:off x="7904331" y="2508624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EE99552-126D-51A7-89E3-1E4546488C94}"/>
              </a:ext>
            </a:extLst>
          </p:cNvPr>
          <p:cNvSpPr txBox="1"/>
          <p:nvPr/>
        </p:nvSpPr>
        <p:spPr>
          <a:xfrm>
            <a:off x="7904331" y="2533523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047F0D2D-ADE3-DA91-A500-37C654E004E0}"/>
              </a:ext>
            </a:extLst>
          </p:cNvPr>
          <p:cNvSpPr/>
          <p:nvPr/>
        </p:nvSpPr>
        <p:spPr>
          <a:xfrm>
            <a:off x="7492401" y="2797821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0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1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120B1FA-B943-29D0-D7B0-FCEB82E5EC66}"/>
              </a:ext>
            </a:extLst>
          </p:cNvPr>
          <p:cNvCxnSpPr>
            <a:cxnSpLocks/>
          </p:cNvCxnSpPr>
          <p:nvPr/>
        </p:nvCxnSpPr>
        <p:spPr>
          <a:xfrm>
            <a:off x="7247830" y="1915100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B5123BEC-9EE8-8D6D-4529-91A7ECF83355}"/>
              </a:ext>
            </a:extLst>
          </p:cNvPr>
          <p:cNvCxnSpPr>
            <a:cxnSpLocks/>
          </p:cNvCxnSpPr>
          <p:nvPr/>
        </p:nvCxnSpPr>
        <p:spPr>
          <a:xfrm>
            <a:off x="5619934" y="2508624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DB4E0D4-B156-9889-F2C1-CFEEC4C63BE0}"/>
              </a:ext>
            </a:extLst>
          </p:cNvPr>
          <p:cNvSpPr txBox="1"/>
          <p:nvPr/>
        </p:nvSpPr>
        <p:spPr>
          <a:xfrm>
            <a:off x="5619934" y="2534342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FB22B6D4-CCB3-579A-C094-E6B0BE114EF3}"/>
              </a:ext>
            </a:extLst>
          </p:cNvPr>
          <p:cNvSpPr/>
          <p:nvPr/>
        </p:nvSpPr>
        <p:spPr>
          <a:xfrm>
            <a:off x="3906735" y="2797821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0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866714FB-B66D-37D6-BE5E-71D9FAA5AD9B}"/>
              </a:ext>
            </a:extLst>
          </p:cNvPr>
          <p:cNvCxnSpPr>
            <a:cxnSpLocks/>
          </p:cNvCxnSpPr>
          <p:nvPr/>
        </p:nvCxnSpPr>
        <p:spPr>
          <a:xfrm>
            <a:off x="6544423" y="2508624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9153D536-BCF8-7D4F-D6B9-B15516B48858}"/>
              </a:ext>
            </a:extLst>
          </p:cNvPr>
          <p:cNvSpPr txBox="1"/>
          <p:nvPr/>
        </p:nvSpPr>
        <p:spPr>
          <a:xfrm>
            <a:off x="6545403" y="2528443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399F9E72-2B3F-3F4A-BAA8-E8CB1385D0FC}"/>
              </a:ext>
            </a:extLst>
          </p:cNvPr>
          <p:cNvSpPr/>
          <p:nvPr/>
        </p:nvSpPr>
        <p:spPr>
          <a:xfrm>
            <a:off x="6127009" y="2797821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D035347-DC2A-A261-F12A-E0C6116DB04D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A: Decision tree predicting no transactional sex among adolescent girls (aged 15-19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D79F8225-6627-663C-75A4-156BBB815897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Collectively, 94% of adolescent girls did not engage in transitional sex. This proportion increases to 100% via two pathways. </a:t>
            </a:r>
            <a:r>
              <a:rPr lang="en-US" sz="1200" i="1" u="sng" dirty="0">
                <a:solidFill>
                  <a:schemeClr val="tx1"/>
                </a:solidFill>
              </a:rPr>
              <a:t>Pathway 1</a:t>
            </a:r>
            <a:r>
              <a:rPr lang="en-US" sz="1200" dirty="0">
                <a:solidFill>
                  <a:schemeClr val="tx1"/>
                </a:solidFill>
              </a:rPr>
              <a:t> includes non-completion of social asset building (91%) and non-exposure to youth-friendly health services (</a:t>
            </a:r>
            <a:r>
              <a:rPr lang="en-US" sz="1200" b="1" u="sng" dirty="0">
                <a:solidFill>
                  <a:schemeClr val="tx1"/>
                </a:solidFill>
              </a:rPr>
              <a:t>100%</a:t>
            </a:r>
            <a:r>
              <a:rPr lang="en-US" sz="1200" dirty="0">
                <a:solidFill>
                  <a:schemeClr val="tx1"/>
                </a:solidFill>
              </a:rPr>
              <a:t>). </a:t>
            </a:r>
            <a:r>
              <a:rPr lang="en-US" sz="1200" i="1" u="sng" dirty="0">
                <a:solidFill>
                  <a:schemeClr val="tx1"/>
                </a:solidFill>
              </a:rPr>
              <a:t>Pathway 2</a:t>
            </a:r>
            <a:r>
              <a:rPr lang="en-US" sz="1200" dirty="0">
                <a:solidFill>
                  <a:schemeClr val="tx1"/>
                </a:solidFill>
              </a:rPr>
              <a:t> includes completion of social asset building (96%) and receipt of educational social protection (</a:t>
            </a:r>
            <a:r>
              <a:rPr lang="en-US" sz="1200" b="1" u="sng" dirty="0">
                <a:solidFill>
                  <a:schemeClr val="tx1"/>
                </a:solidFill>
              </a:rPr>
              <a:t>100%</a:t>
            </a:r>
            <a:r>
              <a:rPr lang="en-US" sz="12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0013505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5877232" y="49205"/>
            <a:ext cx="24688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No transactional sex in last 12 months</a:t>
            </a:r>
          </a:p>
          <a:p>
            <a:pPr algn="ctr"/>
            <a:r>
              <a:rPr lang="en-US" sz="1000" b="1"/>
              <a:t>95%</a:t>
            </a:r>
          </a:p>
          <a:p>
            <a:pPr algn="ctr"/>
            <a:r>
              <a:rPr lang="en-US" sz="1000" b="1"/>
              <a:t>(n=326)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DC470C7-4FF4-D342-99E8-E8F821044953}"/>
              </a:ext>
            </a:extLst>
          </p:cNvPr>
          <p:cNvSpPr/>
          <p:nvPr/>
        </p:nvSpPr>
        <p:spPr>
          <a:xfrm>
            <a:off x="4827425" y="893171"/>
            <a:ext cx="45720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A32A644-ADF7-B3AD-56F1-67002BDA0FAA}"/>
              </a:ext>
            </a:extLst>
          </p:cNvPr>
          <p:cNvCxnSpPr>
            <a:cxnSpLocks/>
          </p:cNvCxnSpPr>
          <p:nvPr/>
        </p:nvCxnSpPr>
        <p:spPr>
          <a:xfrm>
            <a:off x="5022153" y="1184116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87F66CB6-4E6C-859F-482C-E5DC7F7A965E}"/>
              </a:ext>
            </a:extLst>
          </p:cNvPr>
          <p:cNvSpPr txBox="1"/>
          <p:nvPr/>
        </p:nvSpPr>
        <p:spPr>
          <a:xfrm>
            <a:off x="5022153" y="1203242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EF87472D-AF95-9A97-3335-2A576870F4F7}"/>
              </a:ext>
            </a:extLst>
          </p:cNvPr>
          <p:cNvSpPr/>
          <p:nvPr/>
        </p:nvSpPr>
        <p:spPr>
          <a:xfrm>
            <a:off x="4610223" y="1473313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36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5022153" y="1905575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327A96A-39C5-C698-FC91-0BCEBBCFF434}"/>
              </a:ext>
            </a:extLst>
          </p:cNvPr>
          <p:cNvCxnSpPr>
            <a:cxnSpLocks/>
          </p:cNvCxnSpPr>
          <p:nvPr/>
        </p:nvCxnSpPr>
        <p:spPr>
          <a:xfrm>
            <a:off x="7111672" y="623031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54E0BBCF-8123-24C5-50CE-28B0484A1C5C}"/>
              </a:ext>
            </a:extLst>
          </p:cNvPr>
          <p:cNvCxnSpPr>
            <a:cxnSpLocks/>
            <a:endCxn id="33" idx="0"/>
          </p:cNvCxnSpPr>
          <p:nvPr/>
        </p:nvCxnSpPr>
        <p:spPr>
          <a:xfrm>
            <a:off x="9124199" y="1193958"/>
            <a:ext cx="0" cy="28888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1D60924-238B-728E-A597-FB51D6D406A0}"/>
              </a:ext>
            </a:extLst>
          </p:cNvPr>
          <p:cNvSpPr txBox="1"/>
          <p:nvPr/>
        </p:nvSpPr>
        <p:spPr>
          <a:xfrm>
            <a:off x="9124199" y="1212767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A5A33F7A-C786-FDB6-7656-DBF69CD64173}"/>
              </a:ext>
            </a:extLst>
          </p:cNvPr>
          <p:cNvSpPr/>
          <p:nvPr/>
        </p:nvSpPr>
        <p:spPr>
          <a:xfrm>
            <a:off x="8712269" y="148283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90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ED0E8A2-16FD-45A7-2EAD-103F52E1B771}"/>
              </a:ext>
            </a:extLst>
          </p:cNvPr>
          <p:cNvSpPr/>
          <p:nvPr/>
        </p:nvSpPr>
        <p:spPr>
          <a:xfrm>
            <a:off x="8864119" y="2204291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8120B1FA-B943-29D0-D7B0-FCEB82E5EC66}"/>
              </a:ext>
            </a:extLst>
          </p:cNvPr>
          <p:cNvCxnSpPr>
            <a:cxnSpLocks/>
          </p:cNvCxnSpPr>
          <p:nvPr/>
        </p:nvCxnSpPr>
        <p:spPr>
          <a:xfrm>
            <a:off x="9109652" y="1915100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ED8F1B60-8A3F-7E24-5982-ADB968A0B23A}"/>
              </a:ext>
            </a:extLst>
          </p:cNvPr>
          <p:cNvCxnSpPr>
            <a:cxnSpLocks/>
            <a:endCxn id="34" idx="0"/>
          </p:cNvCxnSpPr>
          <p:nvPr/>
        </p:nvCxnSpPr>
        <p:spPr>
          <a:xfrm>
            <a:off x="10443110" y="2490007"/>
            <a:ext cx="0" cy="314592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066E8B6B-BAC3-503F-2616-819A7B91AE92}"/>
              </a:ext>
            </a:extLst>
          </p:cNvPr>
          <p:cNvSpPr txBox="1"/>
          <p:nvPr/>
        </p:nvSpPr>
        <p:spPr>
          <a:xfrm>
            <a:off x="10443110" y="2535221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D90A1DF4-A5A3-EF8C-B980-F218BA892DE0}"/>
              </a:ext>
            </a:extLst>
          </p:cNvPr>
          <p:cNvSpPr/>
          <p:nvPr/>
        </p:nvSpPr>
        <p:spPr>
          <a:xfrm>
            <a:off x="10031180" y="2804599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0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4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EA9DD346-C537-7536-2646-54F77321DE81}"/>
              </a:ext>
            </a:extLst>
          </p:cNvPr>
          <p:cNvCxnSpPr>
            <a:cxnSpLocks/>
            <a:endCxn id="37" idx="0"/>
          </p:cNvCxnSpPr>
          <p:nvPr/>
        </p:nvCxnSpPr>
        <p:spPr>
          <a:xfrm>
            <a:off x="9127340" y="2495236"/>
            <a:ext cx="0" cy="309363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BEA5CB09-F4D6-1999-80D8-A3EA7BD7992B}"/>
              </a:ext>
            </a:extLst>
          </p:cNvPr>
          <p:cNvSpPr txBox="1"/>
          <p:nvPr/>
        </p:nvSpPr>
        <p:spPr>
          <a:xfrm>
            <a:off x="9128320" y="2533858"/>
            <a:ext cx="504008" cy="244732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8C2B35C2-2CE8-B093-FEEA-FE81268E3597}"/>
              </a:ext>
            </a:extLst>
          </p:cNvPr>
          <p:cNvSpPr/>
          <p:nvPr/>
        </p:nvSpPr>
        <p:spPr>
          <a:xfrm>
            <a:off x="8715410" y="2804599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86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622B485C-39D7-706C-B18A-4B90F8ABCEC3}"/>
              </a:ext>
            </a:extLst>
          </p:cNvPr>
          <p:cNvCxnSpPr>
            <a:cxnSpLocks/>
          </p:cNvCxnSpPr>
          <p:nvPr/>
        </p:nvCxnSpPr>
        <p:spPr>
          <a:xfrm>
            <a:off x="10703987" y="3806960"/>
            <a:ext cx="0" cy="28888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F697738D-2852-C82A-0D4C-290446B990BF}"/>
              </a:ext>
            </a:extLst>
          </p:cNvPr>
          <p:cNvSpPr txBox="1"/>
          <p:nvPr/>
        </p:nvSpPr>
        <p:spPr>
          <a:xfrm>
            <a:off x="10703987" y="3825769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B8A300DF-CCA7-D051-1034-2F4F67A18BB6}"/>
              </a:ext>
            </a:extLst>
          </p:cNvPr>
          <p:cNvSpPr/>
          <p:nvPr/>
        </p:nvSpPr>
        <p:spPr>
          <a:xfrm>
            <a:off x="10292057" y="4095123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56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6B6873F1-9576-717B-C4A0-3A341FBA713B}"/>
              </a:ext>
            </a:extLst>
          </p:cNvPr>
          <p:cNvSpPr/>
          <p:nvPr/>
        </p:nvSpPr>
        <p:spPr>
          <a:xfrm>
            <a:off x="9775040" y="4817293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69D5851D-7D84-4BEC-1223-1B824AA35BA4}"/>
              </a:ext>
            </a:extLst>
          </p:cNvPr>
          <p:cNvCxnSpPr>
            <a:cxnSpLocks/>
            <a:endCxn id="49" idx="0"/>
          </p:cNvCxnSpPr>
          <p:nvPr/>
        </p:nvCxnSpPr>
        <p:spPr>
          <a:xfrm>
            <a:off x="11344760" y="5108238"/>
            <a:ext cx="0" cy="268872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C348594B-A530-0A31-4F4B-FEBCCBCF7527}"/>
              </a:ext>
            </a:extLst>
          </p:cNvPr>
          <p:cNvSpPr txBox="1"/>
          <p:nvPr/>
        </p:nvSpPr>
        <p:spPr>
          <a:xfrm>
            <a:off x="11344760" y="5128488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2C263D87-786A-6ACF-3C7A-5F8EA7062FC3}"/>
              </a:ext>
            </a:extLst>
          </p:cNvPr>
          <p:cNvSpPr/>
          <p:nvPr/>
        </p:nvSpPr>
        <p:spPr>
          <a:xfrm>
            <a:off x="10932830" y="5377110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0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E750C4CB-D64D-EB34-273B-3B3B130F1519}"/>
              </a:ext>
            </a:extLst>
          </p:cNvPr>
          <p:cNvCxnSpPr>
            <a:cxnSpLocks/>
          </p:cNvCxnSpPr>
          <p:nvPr/>
        </p:nvCxnSpPr>
        <p:spPr>
          <a:xfrm>
            <a:off x="10689440" y="4528102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Rectangle 50">
            <a:extLst>
              <a:ext uri="{FF2B5EF4-FFF2-40B4-BE49-F238E27FC236}">
                <a16:creationId xmlns:a16="http://schemas.microsoft.com/office/drawing/2014/main" id="{EFD281FA-6659-C669-8958-649C0D1040A5}"/>
              </a:ext>
            </a:extLst>
          </p:cNvPr>
          <p:cNvSpPr/>
          <p:nvPr/>
        </p:nvSpPr>
        <p:spPr>
          <a:xfrm>
            <a:off x="8212940" y="3515956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A003AC44-C9F9-3684-4396-5488F2357645}"/>
              </a:ext>
            </a:extLst>
          </p:cNvPr>
          <p:cNvCxnSpPr>
            <a:cxnSpLocks/>
          </p:cNvCxnSpPr>
          <p:nvPr/>
        </p:nvCxnSpPr>
        <p:spPr>
          <a:xfrm>
            <a:off x="9127340" y="3236290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8241C0BE-DC91-751A-531E-D27A027F9DBF}"/>
              </a:ext>
            </a:extLst>
          </p:cNvPr>
          <p:cNvCxnSpPr>
            <a:cxnSpLocks/>
          </p:cNvCxnSpPr>
          <p:nvPr/>
        </p:nvCxnSpPr>
        <p:spPr>
          <a:xfrm>
            <a:off x="9953543" y="511662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4EDE5319-B3EF-74F1-0132-EBA6467FDC67}"/>
              </a:ext>
            </a:extLst>
          </p:cNvPr>
          <p:cNvSpPr txBox="1"/>
          <p:nvPr/>
        </p:nvSpPr>
        <p:spPr>
          <a:xfrm>
            <a:off x="9954523" y="5136439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2006F54F-823B-BF83-7B08-86E375028EA4}"/>
              </a:ext>
            </a:extLst>
          </p:cNvPr>
          <p:cNvSpPr/>
          <p:nvPr/>
        </p:nvSpPr>
        <p:spPr>
          <a:xfrm>
            <a:off x="9536129" y="537711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49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915C397-D34E-CB54-9ABB-A8A897D6ABC9}"/>
              </a:ext>
            </a:extLst>
          </p:cNvPr>
          <p:cNvSpPr txBox="1"/>
          <p:nvPr/>
        </p:nvSpPr>
        <p:spPr>
          <a:xfrm>
            <a:off x="8378981" y="3829249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43312A6B-22C2-BB4A-4EF8-9978448CD463}"/>
              </a:ext>
            </a:extLst>
          </p:cNvPr>
          <p:cNvSpPr/>
          <p:nvPr/>
        </p:nvSpPr>
        <p:spPr>
          <a:xfrm>
            <a:off x="7966071" y="4095123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0</a:t>
            </a:r>
          </a:p>
        </p:txBody>
      </p: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FA46B5DA-1C0A-1507-6D83-CD2022B0648E}"/>
              </a:ext>
            </a:extLst>
          </p:cNvPr>
          <p:cNvCxnSpPr>
            <a:cxnSpLocks/>
          </p:cNvCxnSpPr>
          <p:nvPr/>
        </p:nvCxnSpPr>
        <p:spPr>
          <a:xfrm>
            <a:off x="8378001" y="4568127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FAF202DA-3853-5812-CA21-044F4D2E310B}"/>
              </a:ext>
            </a:extLst>
          </p:cNvPr>
          <p:cNvCxnSpPr>
            <a:cxnSpLocks/>
          </p:cNvCxnSpPr>
          <p:nvPr/>
        </p:nvCxnSpPr>
        <p:spPr>
          <a:xfrm>
            <a:off x="8378001" y="382152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>
            <a:extLst>
              <a:ext uri="{FF2B5EF4-FFF2-40B4-BE49-F238E27FC236}">
                <a16:creationId xmlns:a16="http://schemas.microsoft.com/office/drawing/2014/main" id="{4C9090F2-2CBF-2848-E142-4719BFAFEE56}"/>
              </a:ext>
            </a:extLst>
          </p:cNvPr>
          <p:cNvSpPr/>
          <p:nvPr/>
        </p:nvSpPr>
        <p:spPr>
          <a:xfrm>
            <a:off x="7471532" y="4817293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48B72D99-BBE7-A5F2-6FD9-90372FAC42F7}"/>
              </a:ext>
            </a:extLst>
          </p:cNvPr>
          <p:cNvCxnSpPr>
            <a:cxnSpLocks/>
          </p:cNvCxnSpPr>
          <p:nvPr/>
        </p:nvCxnSpPr>
        <p:spPr>
          <a:xfrm>
            <a:off x="7595357" y="511662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88A74595-322C-17FE-2BA0-931500314D67}"/>
              </a:ext>
            </a:extLst>
          </p:cNvPr>
          <p:cNvSpPr txBox="1"/>
          <p:nvPr/>
        </p:nvSpPr>
        <p:spPr>
          <a:xfrm>
            <a:off x="7595357" y="513643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9CDE1B19-F451-06EA-F5A8-F3BE95364030}"/>
              </a:ext>
            </a:extLst>
          </p:cNvPr>
          <p:cNvSpPr/>
          <p:nvPr/>
        </p:nvSpPr>
        <p:spPr>
          <a:xfrm>
            <a:off x="7183428" y="537711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2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3</a:t>
            </a:r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7D314D96-3D4C-FEF8-04BC-917168CD2E2A}"/>
              </a:ext>
            </a:extLst>
          </p:cNvPr>
          <p:cNvCxnSpPr>
            <a:cxnSpLocks/>
          </p:cNvCxnSpPr>
          <p:nvPr/>
        </p:nvCxnSpPr>
        <p:spPr>
          <a:xfrm>
            <a:off x="9071732" y="511662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AE5A708E-A237-33AC-14C0-A1ABBC77DC23}"/>
              </a:ext>
            </a:extLst>
          </p:cNvPr>
          <p:cNvSpPr txBox="1"/>
          <p:nvPr/>
        </p:nvSpPr>
        <p:spPr>
          <a:xfrm>
            <a:off x="9071732" y="5136439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84" name="Oval 83">
            <a:extLst>
              <a:ext uri="{FF2B5EF4-FFF2-40B4-BE49-F238E27FC236}">
                <a16:creationId xmlns:a16="http://schemas.microsoft.com/office/drawing/2014/main" id="{91C8740C-A74E-CD1B-2386-71ABA6AFE895}"/>
              </a:ext>
            </a:extLst>
          </p:cNvPr>
          <p:cNvSpPr/>
          <p:nvPr/>
        </p:nvSpPr>
        <p:spPr>
          <a:xfrm>
            <a:off x="8659802" y="5377110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8100C1DF-1DF2-E432-6F1C-703C82B5A3A3}"/>
              </a:ext>
            </a:extLst>
          </p:cNvPr>
          <p:cNvSpPr/>
          <p:nvPr/>
        </p:nvSpPr>
        <p:spPr>
          <a:xfrm>
            <a:off x="3657158" y="2194766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A60EB0D2-693A-A805-C2EE-2EA3C410E72E}"/>
              </a:ext>
            </a:extLst>
          </p:cNvPr>
          <p:cNvCxnSpPr>
            <a:cxnSpLocks/>
            <a:endCxn id="89" idx="0"/>
          </p:cNvCxnSpPr>
          <p:nvPr/>
        </p:nvCxnSpPr>
        <p:spPr>
          <a:xfrm>
            <a:off x="6153269" y="2470957"/>
            <a:ext cx="0" cy="314021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9EA38032-10CB-409F-1F3A-BB73B6AF0B78}"/>
              </a:ext>
            </a:extLst>
          </p:cNvPr>
          <p:cNvSpPr txBox="1"/>
          <p:nvPr/>
        </p:nvSpPr>
        <p:spPr>
          <a:xfrm>
            <a:off x="6153269" y="2525696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AEDFDA35-50E5-36CF-DAA1-D17AC596F0D5}"/>
              </a:ext>
            </a:extLst>
          </p:cNvPr>
          <p:cNvSpPr/>
          <p:nvPr/>
        </p:nvSpPr>
        <p:spPr>
          <a:xfrm>
            <a:off x="5741339" y="278497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5</a:t>
            </a:r>
          </a:p>
        </p:txBody>
      </p: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D92F2700-4F28-4B00-59EC-F3AE7CC1D233}"/>
              </a:ext>
            </a:extLst>
          </p:cNvPr>
          <p:cNvCxnSpPr>
            <a:cxnSpLocks/>
            <a:endCxn id="92" idx="0"/>
          </p:cNvCxnSpPr>
          <p:nvPr/>
        </p:nvCxnSpPr>
        <p:spPr>
          <a:xfrm>
            <a:off x="3909493" y="2475615"/>
            <a:ext cx="0" cy="309363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54F3F5EB-2E16-6DDA-CA80-80F876F23F73}"/>
              </a:ext>
            </a:extLst>
          </p:cNvPr>
          <p:cNvSpPr txBox="1"/>
          <p:nvPr/>
        </p:nvSpPr>
        <p:spPr>
          <a:xfrm>
            <a:off x="3910473" y="2524333"/>
            <a:ext cx="504008" cy="2447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6DB0A5E7-8C0B-15B6-36E3-BCD1AF5930FC}"/>
              </a:ext>
            </a:extLst>
          </p:cNvPr>
          <p:cNvSpPr/>
          <p:nvPr/>
        </p:nvSpPr>
        <p:spPr>
          <a:xfrm>
            <a:off x="3497563" y="278497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71</a:t>
            </a:r>
          </a:p>
        </p:txBody>
      </p: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69A49EBC-7D43-3374-F39C-A19464DCEB96}"/>
              </a:ext>
            </a:extLst>
          </p:cNvPr>
          <p:cNvCxnSpPr>
            <a:cxnSpLocks/>
          </p:cNvCxnSpPr>
          <p:nvPr/>
        </p:nvCxnSpPr>
        <p:spPr>
          <a:xfrm>
            <a:off x="3914515" y="3797435"/>
            <a:ext cx="0" cy="28888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A0B829EA-4F4E-23EC-88B5-8E69510DE8D3}"/>
              </a:ext>
            </a:extLst>
          </p:cNvPr>
          <p:cNvSpPr txBox="1"/>
          <p:nvPr/>
        </p:nvSpPr>
        <p:spPr>
          <a:xfrm>
            <a:off x="3914515" y="3816244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F13738EC-3793-09D7-BBDF-2F5AE551B241}"/>
              </a:ext>
            </a:extLst>
          </p:cNvPr>
          <p:cNvSpPr/>
          <p:nvPr/>
        </p:nvSpPr>
        <p:spPr>
          <a:xfrm>
            <a:off x="3007340" y="4807768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19D28DF2-180B-6D57-A416-E41C05AB7032}"/>
              </a:ext>
            </a:extLst>
          </p:cNvPr>
          <p:cNvCxnSpPr>
            <a:cxnSpLocks/>
            <a:endCxn id="99" idx="0"/>
          </p:cNvCxnSpPr>
          <p:nvPr/>
        </p:nvCxnSpPr>
        <p:spPr>
          <a:xfrm>
            <a:off x="4577060" y="5111413"/>
            <a:ext cx="0" cy="268872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ACBC534E-C1CB-51F2-5761-C5FEA608B2EA}"/>
              </a:ext>
            </a:extLst>
          </p:cNvPr>
          <p:cNvSpPr txBox="1"/>
          <p:nvPr/>
        </p:nvSpPr>
        <p:spPr>
          <a:xfrm>
            <a:off x="4605635" y="5118963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99" name="Oval 98">
            <a:extLst>
              <a:ext uri="{FF2B5EF4-FFF2-40B4-BE49-F238E27FC236}">
                <a16:creationId xmlns:a16="http://schemas.microsoft.com/office/drawing/2014/main" id="{B1F4A3DF-9610-4A0E-2797-3A67395288AB}"/>
              </a:ext>
            </a:extLst>
          </p:cNvPr>
          <p:cNvSpPr/>
          <p:nvPr/>
        </p:nvSpPr>
        <p:spPr>
          <a:xfrm>
            <a:off x="4165130" y="538028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9</a:t>
            </a:r>
          </a:p>
        </p:txBody>
      </p: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1E1081AE-11F8-7A2F-8D52-CFEDF189E03A}"/>
              </a:ext>
            </a:extLst>
          </p:cNvPr>
          <p:cNvCxnSpPr>
            <a:cxnSpLocks/>
          </p:cNvCxnSpPr>
          <p:nvPr/>
        </p:nvCxnSpPr>
        <p:spPr>
          <a:xfrm>
            <a:off x="3921740" y="4518577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Rectangle 100">
            <a:extLst>
              <a:ext uri="{FF2B5EF4-FFF2-40B4-BE49-F238E27FC236}">
                <a16:creationId xmlns:a16="http://schemas.microsoft.com/office/drawing/2014/main" id="{70C7A87C-FF42-7891-7F4A-1D18F3319790}"/>
              </a:ext>
            </a:extLst>
          </p:cNvPr>
          <p:cNvSpPr/>
          <p:nvPr/>
        </p:nvSpPr>
        <p:spPr>
          <a:xfrm>
            <a:off x="1423468" y="3515956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71A494D3-417E-391A-D042-4AD968653450}"/>
              </a:ext>
            </a:extLst>
          </p:cNvPr>
          <p:cNvCxnSpPr>
            <a:cxnSpLocks/>
          </p:cNvCxnSpPr>
          <p:nvPr/>
        </p:nvCxnSpPr>
        <p:spPr>
          <a:xfrm>
            <a:off x="3909493" y="3228328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AA2783FE-AF51-1DDF-A099-67B6B34F53E8}"/>
              </a:ext>
            </a:extLst>
          </p:cNvPr>
          <p:cNvCxnSpPr>
            <a:cxnSpLocks/>
          </p:cNvCxnSpPr>
          <p:nvPr/>
        </p:nvCxnSpPr>
        <p:spPr>
          <a:xfrm>
            <a:off x="3185843" y="5107095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>
            <a:extLst>
              <a:ext uri="{FF2B5EF4-FFF2-40B4-BE49-F238E27FC236}">
                <a16:creationId xmlns:a16="http://schemas.microsoft.com/office/drawing/2014/main" id="{F7721222-8524-D2B3-E4C0-BC9432442520}"/>
              </a:ext>
            </a:extLst>
          </p:cNvPr>
          <p:cNvSpPr txBox="1"/>
          <p:nvPr/>
        </p:nvSpPr>
        <p:spPr>
          <a:xfrm>
            <a:off x="3186823" y="5126914"/>
            <a:ext cx="504008" cy="2447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CEC01645-D6EC-6BA5-66A4-CFCDDEBA913E}"/>
              </a:ext>
            </a:extLst>
          </p:cNvPr>
          <p:cNvSpPr/>
          <p:nvPr/>
        </p:nvSpPr>
        <p:spPr>
          <a:xfrm>
            <a:off x="2774779" y="538028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4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7BAC0B7-BE9B-84F9-A6E8-91AF9A3E0724}"/>
              </a:ext>
            </a:extLst>
          </p:cNvPr>
          <p:cNvSpPr txBox="1"/>
          <p:nvPr/>
        </p:nvSpPr>
        <p:spPr>
          <a:xfrm>
            <a:off x="1589509" y="3819724"/>
            <a:ext cx="504008" cy="244732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07" name="Oval 106">
            <a:extLst>
              <a:ext uri="{FF2B5EF4-FFF2-40B4-BE49-F238E27FC236}">
                <a16:creationId xmlns:a16="http://schemas.microsoft.com/office/drawing/2014/main" id="{00620076-0E0D-0016-8557-4281810614F6}"/>
              </a:ext>
            </a:extLst>
          </p:cNvPr>
          <p:cNvSpPr/>
          <p:nvPr/>
        </p:nvSpPr>
        <p:spPr>
          <a:xfrm>
            <a:off x="1176599" y="4095123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88</a:t>
            </a:r>
          </a:p>
        </p:txBody>
      </p:sp>
      <p:cxnSp>
        <p:nvCxnSpPr>
          <p:cNvPr id="108" name="Straight Arrow Connector 107">
            <a:extLst>
              <a:ext uri="{FF2B5EF4-FFF2-40B4-BE49-F238E27FC236}">
                <a16:creationId xmlns:a16="http://schemas.microsoft.com/office/drawing/2014/main" id="{7CBF821E-407B-7162-39EF-58D403605A24}"/>
              </a:ext>
            </a:extLst>
          </p:cNvPr>
          <p:cNvCxnSpPr>
            <a:cxnSpLocks/>
          </p:cNvCxnSpPr>
          <p:nvPr/>
        </p:nvCxnSpPr>
        <p:spPr>
          <a:xfrm>
            <a:off x="1588529" y="4518577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:a16="http://schemas.microsoft.com/office/drawing/2014/main" id="{149DB441-C6FF-D618-B5DA-3D8B98CEE864}"/>
              </a:ext>
            </a:extLst>
          </p:cNvPr>
          <p:cNvCxnSpPr>
            <a:cxnSpLocks/>
          </p:cNvCxnSpPr>
          <p:nvPr/>
        </p:nvCxnSpPr>
        <p:spPr>
          <a:xfrm>
            <a:off x="1588529" y="3811995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Rectangle 109">
            <a:extLst>
              <a:ext uri="{FF2B5EF4-FFF2-40B4-BE49-F238E27FC236}">
                <a16:creationId xmlns:a16="http://schemas.microsoft.com/office/drawing/2014/main" id="{906CE280-783E-A2B9-4D8E-2FC8A4A82A7E}"/>
              </a:ext>
            </a:extLst>
          </p:cNvPr>
          <p:cNvSpPr/>
          <p:nvPr/>
        </p:nvSpPr>
        <p:spPr>
          <a:xfrm>
            <a:off x="682060" y="4807768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111" name="Straight Arrow Connector 110">
            <a:extLst>
              <a:ext uri="{FF2B5EF4-FFF2-40B4-BE49-F238E27FC236}">
                <a16:creationId xmlns:a16="http://schemas.microsoft.com/office/drawing/2014/main" id="{7E51D1CE-53E2-0BAC-5029-FE4BF186C8BC}"/>
              </a:ext>
            </a:extLst>
          </p:cNvPr>
          <p:cNvCxnSpPr>
            <a:cxnSpLocks/>
          </p:cNvCxnSpPr>
          <p:nvPr/>
        </p:nvCxnSpPr>
        <p:spPr>
          <a:xfrm>
            <a:off x="805885" y="5107095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16CC2ACF-BE35-B439-3E06-15033B03E77B}"/>
              </a:ext>
            </a:extLst>
          </p:cNvPr>
          <p:cNvSpPr txBox="1"/>
          <p:nvPr/>
        </p:nvSpPr>
        <p:spPr>
          <a:xfrm>
            <a:off x="805885" y="5126914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13" name="Oval 112">
            <a:extLst>
              <a:ext uri="{FF2B5EF4-FFF2-40B4-BE49-F238E27FC236}">
                <a16:creationId xmlns:a16="http://schemas.microsoft.com/office/drawing/2014/main" id="{4C4ADB03-972E-8FCC-76F5-FE8B9AA61069}"/>
              </a:ext>
            </a:extLst>
          </p:cNvPr>
          <p:cNvSpPr/>
          <p:nvPr/>
        </p:nvSpPr>
        <p:spPr>
          <a:xfrm>
            <a:off x="393956" y="538028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5</a:t>
            </a:r>
          </a:p>
        </p:txBody>
      </p: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927EF341-1DB8-2948-ADE2-CED8A3E28304}"/>
              </a:ext>
            </a:extLst>
          </p:cNvPr>
          <p:cNvCxnSpPr>
            <a:cxnSpLocks/>
          </p:cNvCxnSpPr>
          <p:nvPr/>
        </p:nvCxnSpPr>
        <p:spPr>
          <a:xfrm>
            <a:off x="2282260" y="5107095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0C55CC25-9DBC-5DD3-08EB-E4041C8B1ABF}"/>
              </a:ext>
            </a:extLst>
          </p:cNvPr>
          <p:cNvSpPr txBox="1"/>
          <p:nvPr/>
        </p:nvSpPr>
        <p:spPr>
          <a:xfrm>
            <a:off x="2282260" y="5126914"/>
            <a:ext cx="507075" cy="246221"/>
          </a:xfrm>
          <a:prstGeom prst="rect">
            <a:avLst/>
          </a:prstGeom>
          <a:noFill/>
          <a:ln w="381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16" name="Oval 115">
            <a:extLst>
              <a:ext uri="{FF2B5EF4-FFF2-40B4-BE49-F238E27FC236}">
                <a16:creationId xmlns:a16="http://schemas.microsoft.com/office/drawing/2014/main" id="{8E69D99E-A10C-FA97-AED3-1E40422D28E7}"/>
              </a:ext>
            </a:extLst>
          </p:cNvPr>
          <p:cNvSpPr/>
          <p:nvPr/>
        </p:nvSpPr>
        <p:spPr>
          <a:xfrm>
            <a:off x="1870330" y="5380285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0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3</a:t>
            </a:r>
          </a:p>
        </p:txBody>
      </p: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CA5130FD-207D-9E0F-B907-2E35499EF8D3}"/>
              </a:ext>
            </a:extLst>
          </p:cNvPr>
          <p:cNvCxnSpPr>
            <a:cxnSpLocks/>
          </p:cNvCxnSpPr>
          <p:nvPr/>
        </p:nvCxnSpPr>
        <p:spPr>
          <a:xfrm>
            <a:off x="6142998" y="3228328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Rectangle 117">
            <a:extLst>
              <a:ext uri="{FF2B5EF4-FFF2-40B4-BE49-F238E27FC236}">
                <a16:creationId xmlns:a16="http://schemas.microsoft.com/office/drawing/2014/main" id="{C511D52A-B224-A69D-2B47-8ECB5A80BFF3}"/>
              </a:ext>
            </a:extLst>
          </p:cNvPr>
          <p:cNvSpPr/>
          <p:nvPr/>
        </p:nvSpPr>
        <p:spPr>
          <a:xfrm>
            <a:off x="5236529" y="3515956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58B31A0B-9045-E94B-809B-064B63D2E95A}"/>
              </a:ext>
            </a:extLst>
          </p:cNvPr>
          <p:cNvCxnSpPr>
            <a:cxnSpLocks/>
          </p:cNvCxnSpPr>
          <p:nvPr/>
        </p:nvCxnSpPr>
        <p:spPr>
          <a:xfrm>
            <a:off x="5360354" y="3801975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418AFEC1-B275-A413-35FE-208A62AD2767}"/>
              </a:ext>
            </a:extLst>
          </p:cNvPr>
          <p:cNvSpPr txBox="1"/>
          <p:nvPr/>
        </p:nvSpPr>
        <p:spPr>
          <a:xfrm>
            <a:off x="5360354" y="3821794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21" name="Oval 120">
            <a:extLst>
              <a:ext uri="{FF2B5EF4-FFF2-40B4-BE49-F238E27FC236}">
                <a16:creationId xmlns:a16="http://schemas.microsoft.com/office/drawing/2014/main" id="{53DB3850-ACAE-4334-67BF-58B62A581E66}"/>
              </a:ext>
            </a:extLst>
          </p:cNvPr>
          <p:cNvSpPr/>
          <p:nvPr/>
        </p:nvSpPr>
        <p:spPr>
          <a:xfrm>
            <a:off x="4948425" y="4095123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4</a:t>
            </a: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CBF31E32-6AA4-DFE8-90E2-EA3663BE6681}"/>
              </a:ext>
            </a:extLst>
          </p:cNvPr>
          <p:cNvCxnSpPr>
            <a:cxnSpLocks/>
          </p:cNvCxnSpPr>
          <p:nvPr/>
        </p:nvCxnSpPr>
        <p:spPr>
          <a:xfrm>
            <a:off x="6836729" y="3801975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Oval 122">
            <a:extLst>
              <a:ext uri="{FF2B5EF4-FFF2-40B4-BE49-F238E27FC236}">
                <a16:creationId xmlns:a16="http://schemas.microsoft.com/office/drawing/2014/main" id="{E861D594-4D24-0AA8-4ECE-6AD548120272}"/>
              </a:ext>
            </a:extLst>
          </p:cNvPr>
          <p:cNvSpPr/>
          <p:nvPr/>
        </p:nvSpPr>
        <p:spPr>
          <a:xfrm>
            <a:off x="6424799" y="4095123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51</a:t>
            </a:r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838C66D9-8824-3AD5-394D-DF4DA351F83A}"/>
              </a:ext>
            </a:extLst>
          </p:cNvPr>
          <p:cNvSpPr/>
          <p:nvPr/>
        </p:nvSpPr>
        <p:spPr>
          <a:xfrm>
            <a:off x="3513944" y="4095123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83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16E4E9F-58D1-ADBD-90E6-E6F89B2438FF}"/>
              </a:ext>
            </a:extLst>
          </p:cNvPr>
          <p:cNvSpPr txBox="1"/>
          <p:nvPr/>
        </p:nvSpPr>
        <p:spPr>
          <a:xfrm>
            <a:off x="6855657" y="3835569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C2A85C-E661-04AE-4A41-7CE8F184B27F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3B: Decision tree predicting no transactional sex among young women (aged 20-25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D99B5647-EFD4-71B5-6EC2-5AD59E87E46D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100" dirty="0">
                <a:solidFill>
                  <a:schemeClr val="tx1"/>
                </a:solidFill>
              </a:rPr>
              <a:t>In total, 95% of young women did not engage in transactional sex, increasing to 100% through three pathways. </a:t>
            </a:r>
            <a:r>
              <a:rPr lang="en-US" sz="1100" i="1" u="sng" dirty="0">
                <a:solidFill>
                  <a:schemeClr val="tx1"/>
                </a:solidFill>
              </a:rPr>
              <a:t>Pathway 1</a:t>
            </a:r>
            <a:r>
              <a:rPr lang="en-US" sz="1100" dirty="0">
                <a:solidFill>
                  <a:schemeClr val="tx1"/>
                </a:solidFill>
              </a:rPr>
              <a:t> entails exposure to economic social protection (93%) but not youth-friendly health services (</a:t>
            </a:r>
            <a:r>
              <a:rPr lang="en-US" sz="1100" b="1" u="sng" dirty="0">
                <a:solidFill>
                  <a:schemeClr val="tx1"/>
                </a:solidFill>
              </a:rPr>
              <a:t>100%</a:t>
            </a:r>
            <a:r>
              <a:rPr lang="en-US" sz="1100" dirty="0">
                <a:solidFill>
                  <a:schemeClr val="tx1"/>
                </a:solidFill>
              </a:rPr>
              <a:t>). </a:t>
            </a:r>
            <a:r>
              <a:rPr lang="en-US" sz="1100" i="1" u="sng" dirty="0">
                <a:solidFill>
                  <a:schemeClr val="tx1"/>
                </a:solidFill>
              </a:rPr>
              <a:t>Pathway 2</a:t>
            </a:r>
            <a:r>
              <a:rPr lang="en-US" sz="1100" dirty="0">
                <a:solidFill>
                  <a:schemeClr val="tx1"/>
                </a:solidFill>
              </a:rPr>
              <a:t> includes exposure to economic social protection (93%), youth-friendly health services (93%), and educational social protection (93%) but not social asset building (</a:t>
            </a:r>
            <a:r>
              <a:rPr lang="en-US" sz="1100" b="1" u="sng" dirty="0">
                <a:solidFill>
                  <a:schemeClr val="tx1"/>
                </a:solidFill>
              </a:rPr>
              <a:t>100%</a:t>
            </a:r>
            <a:r>
              <a:rPr lang="en-US" sz="1100" dirty="0">
                <a:solidFill>
                  <a:schemeClr val="tx1"/>
                </a:solidFill>
              </a:rPr>
              <a:t>). </a:t>
            </a:r>
            <a:r>
              <a:rPr lang="en-US" sz="1100" i="1" u="sng" dirty="0">
                <a:solidFill>
                  <a:schemeClr val="tx1"/>
                </a:solidFill>
              </a:rPr>
              <a:t>Pathway 3</a:t>
            </a:r>
            <a:r>
              <a:rPr lang="en-US" sz="1100" dirty="0">
                <a:solidFill>
                  <a:schemeClr val="tx1"/>
                </a:solidFill>
              </a:rPr>
              <a:t> includes non-exposure to economic social protection (96%) and exposure to youth-friendly health services (97%), social asset building (98%), and educational social protection (</a:t>
            </a:r>
            <a:r>
              <a:rPr lang="en-US" sz="1100" b="1" u="sng" dirty="0">
                <a:solidFill>
                  <a:schemeClr val="tx1"/>
                </a:solidFill>
              </a:rPr>
              <a:t>100%</a:t>
            </a:r>
            <a:r>
              <a:rPr lang="en-US" sz="11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9623121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4936823" y="57235"/>
            <a:ext cx="23774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No intimate partner sexual violence in last 12 months </a:t>
            </a:r>
          </a:p>
          <a:p>
            <a:pPr algn="ctr"/>
            <a:r>
              <a:rPr lang="en-US" sz="1000" b="1"/>
              <a:t>76%</a:t>
            </a:r>
          </a:p>
          <a:p>
            <a:pPr algn="ctr"/>
            <a:r>
              <a:rPr lang="en-US" sz="1000" b="1"/>
              <a:t>(n=74)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6125393" y="746703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Oval 7">
            <a:extLst>
              <a:ext uri="{FF2B5EF4-FFF2-40B4-BE49-F238E27FC236}">
                <a16:creationId xmlns:a16="http://schemas.microsoft.com/office/drawing/2014/main" id="{232354EC-E368-F142-1F7B-DE6A9A089AB6}"/>
              </a:ext>
            </a:extLst>
          </p:cNvPr>
          <p:cNvSpPr/>
          <p:nvPr/>
        </p:nvSpPr>
        <p:spPr>
          <a:xfrm>
            <a:off x="5194699" y="291614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9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3482616-1E30-DD0B-711E-7BE1D622F80E}"/>
              </a:ext>
            </a:extLst>
          </p:cNvPr>
          <p:cNvSpPr/>
          <p:nvPr/>
        </p:nvSpPr>
        <p:spPr>
          <a:xfrm>
            <a:off x="4753793" y="1021023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3F606B4-2CFF-D123-4F6A-89399555D405}"/>
              </a:ext>
            </a:extLst>
          </p:cNvPr>
          <p:cNvCxnSpPr>
            <a:cxnSpLocks/>
          </p:cNvCxnSpPr>
          <p:nvPr/>
        </p:nvCxnSpPr>
        <p:spPr>
          <a:xfrm>
            <a:off x="4948521" y="1311968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23EF734-2799-72DC-C0C5-2C33D0EFF3AB}"/>
              </a:ext>
            </a:extLst>
          </p:cNvPr>
          <p:cNvSpPr txBox="1"/>
          <p:nvPr/>
        </p:nvSpPr>
        <p:spPr>
          <a:xfrm>
            <a:off x="4948521" y="1337686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D631172A-9D04-D0B3-1E67-FA7C22C76A3F}"/>
              </a:ext>
            </a:extLst>
          </p:cNvPr>
          <p:cNvSpPr/>
          <p:nvPr/>
        </p:nvSpPr>
        <p:spPr>
          <a:xfrm>
            <a:off x="4536591" y="160116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2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6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10AC049-3B87-889C-3853-00BEDCF6CDEB}"/>
              </a:ext>
            </a:extLst>
          </p:cNvPr>
          <p:cNvSpPr/>
          <p:nvPr/>
        </p:nvSpPr>
        <p:spPr>
          <a:xfrm>
            <a:off x="4034121" y="2322618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0CA136D-4BC9-7C12-C163-E00EA43CBD4A}"/>
              </a:ext>
            </a:extLst>
          </p:cNvPr>
          <p:cNvCxnSpPr>
            <a:cxnSpLocks/>
          </p:cNvCxnSpPr>
          <p:nvPr/>
        </p:nvCxnSpPr>
        <p:spPr>
          <a:xfrm>
            <a:off x="4309609" y="262695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05F4B0A-8CC3-A126-DBE0-398EC7CE5BF5}"/>
              </a:ext>
            </a:extLst>
          </p:cNvPr>
          <p:cNvSpPr txBox="1"/>
          <p:nvPr/>
        </p:nvSpPr>
        <p:spPr>
          <a:xfrm>
            <a:off x="4310589" y="2646770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CD8CCBA-7C66-E596-C9B4-330A47E4A5BD}"/>
              </a:ext>
            </a:extLst>
          </p:cNvPr>
          <p:cNvCxnSpPr>
            <a:cxnSpLocks/>
          </p:cNvCxnSpPr>
          <p:nvPr/>
        </p:nvCxnSpPr>
        <p:spPr>
          <a:xfrm>
            <a:off x="4948521" y="2033427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E252079-14BD-A672-CD06-73247FDB535B}"/>
              </a:ext>
            </a:extLst>
          </p:cNvPr>
          <p:cNvCxnSpPr>
            <a:cxnSpLocks/>
            <a:endCxn id="24" idx="0"/>
          </p:cNvCxnSpPr>
          <p:nvPr/>
        </p:nvCxnSpPr>
        <p:spPr>
          <a:xfrm>
            <a:off x="7249072" y="1312285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063459B-7483-7724-4A1A-EA1A98E6C5B0}"/>
              </a:ext>
            </a:extLst>
          </p:cNvPr>
          <p:cNvSpPr txBox="1"/>
          <p:nvPr/>
        </p:nvSpPr>
        <p:spPr>
          <a:xfrm>
            <a:off x="7249071" y="1337686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D5574D0B-A138-CF59-E408-8D7379EB08EC}"/>
              </a:ext>
            </a:extLst>
          </p:cNvPr>
          <p:cNvSpPr/>
          <p:nvPr/>
        </p:nvSpPr>
        <p:spPr>
          <a:xfrm>
            <a:off x="6837142" y="1601165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8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7757A16-76B0-F0C6-AAE7-0A4A3942E16B}"/>
              </a:ext>
            </a:extLst>
          </p:cNvPr>
          <p:cNvSpPr/>
          <p:nvPr/>
        </p:nvSpPr>
        <p:spPr>
          <a:xfrm>
            <a:off x="6320125" y="2322618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E48F76C-8EA4-BAE2-6DDD-2DD445569A41}"/>
              </a:ext>
            </a:extLst>
          </p:cNvPr>
          <p:cNvCxnSpPr>
            <a:cxnSpLocks/>
          </p:cNvCxnSpPr>
          <p:nvPr/>
        </p:nvCxnSpPr>
        <p:spPr>
          <a:xfrm>
            <a:off x="7891026" y="262695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C44E87E5-88B7-7A95-462C-EA52102387E9}"/>
              </a:ext>
            </a:extLst>
          </p:cNvPr>
          <p:cNvSpPr txBox="1"/>
          <p:nvPr/>
        </p:nvSpPr>
        <p:spPr>
          <a:xfrm>
            <a:off x="7891026" y="2651850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81734FE5-2638-980D-B973-7BBBD5A2075B}"/>
              </a:ext>
            </a:extLst>
          </p:cNvPr>
          <p:cNvSpPr/>
          <p:nvPr/>
        </p:nvSpPr>
        <p:spPr>
          <a:xfrm>
            <a:off x="7479096" y="291614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8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B7066324-5D12-3914-0AE3-24AED75DDF44}"/>
              </a:ext>
            </a:extLst>
          </p:cNvPr>
          <p:cNvCxnSpPr>
            <a:cxnSpLocks/>
          </p:cNvCxnSpPr>
          <p:nvPr/>
        </p:nvCxnSpPr>
        <p:spPr>
          <a:xfrm>
            <a:off x="7234525" y="2033427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D8BEBF3-7F68-0EA3-B301-1C6F8099EDFB}"/>
              </a:ext>
            </a:extLst>
          </p:cNvPr>
          <p:cNvCxnSpPr>
            <a:cxnSpLocks/>
          </p:cNvCxnSpPr>
          <p:nvPr/>
        </p:nvCxnSpPr>
        <p:spPr>
          <a:xfrm>
            <a:off x="5606629" y="262695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AC71F4D-F218-79D0-A594-0DE96D540763}"/>
              </a:ext>
            </a:extLst>
          </p:cNvPr>
          <p:cNvSpPr txBox="1"/>
          <p:nvPr/>
        </p:nvSpPr>
        <p:spPr>
          <a:xfrm>
            <a:off x="5606629" y="265266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CEECA03B-9A4A-96CE-D93C-57A376D23B6A}"/>
              </a:ext>
            </a:extLst>
          </p:cNvPr>
          <p:cNvSpPr/>
          <p:nvPr/>
        </p:nvSpPr>
        <p:spPr>
          <a:xfrm>
            <a:off x="3893430" y="291614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7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DBECC9C3-21FA-CB36-FBE8-CDA5E06E15E3}"/>
              </a:ext>
            </a:extLst>
          </p:cNvPr>
          <p:cNvCxnSpPr>
            <a:cxnSpLocks/>
          </p:cNvCxnSpPr>
          <p:nvPr/>
        </p:nvCxnSpPr>
        <p:spPr>
          <a:xfrm>
            <a:off x="6531118" y="2626951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12D592D0-353E-39A0-D901-FE3DFFF18592}"/>
              </a:ext>
            </a:extLst>
          </p:cNvPr>
          <p:cNvSpPr txBox="1"/>
          <p:nvPr/>
        </p:nvSpPr>
        <p:spPr>
          <a:xfrm>
            <a:off x="6532098" y="2646770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1F55F188-9BBB-ECD5-33EA-CD8B5122AF36}"/>
              </a:ext>
            </a:extLst>
          </p:cNvPr>
          <p:cNvSpPr/>
          <p:nvPr/>
        </p:nvSpPr>
        <p:spPr>
          <a:xfrm>
            <a:off x="6113704" y="2916148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0</a:t>
            </a: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55E59B2F-3C83-CBA6-9148-ECFE1628745C}"/>
              </a:ext>
            </a:extLst>
          </p:cNvPr>
          <p:cNvSpPr/>
          <p:nvPr/>
        </p:nvSpPr>
        <p:spPr>
          <a:xfrm>
            <a:off x="4536591" y="424504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5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48FB9DB0-3B62-CDDA-76D9-598F9B94A5AA}"/>
              </a:ext>
            </a:extLst>
          </p:cNvPr>
          <p:cNvSpPr/>
          <p:nvPr/>
        </p:nvSpPr>
        <p:spPr>
          <a:xfrm>
            <a:off x="3376013" y="3651516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550611E6-B548-FCB1-BEDB-4CBB56C08F84}"/>
              </a:ext>
            </a:extLst>
          </p:cNvPr>
          <p:cNvCxnSpPr>
            <a:cxnSpLocks/>
          </p:cNvCxnSpPr>
          <p:nvPr/>
        </p:nvCxnSpPr>
        <p:spPr>
          <a:xfrm>
            <a:off x="3651501" y="395584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806F8C1E-DF32-C540-C728-C12BF999D4DD}"/>
              </a:ext>
            </a:extLst>
          </p:cNvPr>
          <p:cNvSpPr txBox="1"/>
          <p:nvPr/>
        </p:nvSpPr>
        <p:spPr>
          <a:xfrm>
            <a:off x="3652481" y="3975668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207C0CC6-4B87-F525-F921-F3E024D33508}"/>
              </a:ext>
            </a:extLst>
          </p:cNvPr>
          <p:cNvCxnSpPr>
            <a:cxnSpLocks/>
          </p:cNvCxnSpPr>
          <p:nvPr/>
        </p:nvCxnSpPr>
        <p:spPr>
          <a:xfrm>
            <a:off x="4290413" y="3362325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10D947CF-3447-C6D1-7E33-BBA29C4BD42D}"/>
              </a:ext>
            </a:extLst>
          </p:cNvPr>
          <p:cNvCxnSpPr>
            <a:cxnSpLocks/>
          </p:cNvCxnSpPr>
          <p:nvPr/>
        </p:nvCxnSpPr>
        <p:spPr>
          <a:xfrm>
            <a:off x="4948521" y="395584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Oval 41">
            <a:extLst>
              <a:ext uri="{FF2B5EF4-FFF2-40B4-BE49-F238E27FC236}">
                <a16:creationId xmlns:a16="http://schemas.microsoft.com/office/drawing/2014/main" id="{D8E92050-47F4-07EB-A645-0988AE7C72B5}"/>
              </a:ext>
            </a:extLst>
          </p:cNvPr>
          <p:cNvSpPr/>
          <p:nvPr/>
        </p:nvSpPr>
        <p:spPr>
          <a:xfrm>
            <a:off x="3235322" y="424504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6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23922C1-FA6A-C4A0-7AA6-E4D730931E92}"/>
              </a:ext>
            </a:extLst>
          </p:cNvPr>
          <p:cNvSpPr txBox="1"/>
          <p:nvPr/>
        </p:nvSpPr>
        <p:spPr>
          <a:xfrm>
            <a:off x="4950054" y="3985437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F3DE7E5-C64D-90E1-D2AA-9FDBFECF3430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4A: Decision tree predicting no intimate partner sexual violence among adolescent girls (aged 15-19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59276241-0475-DA83-1E9D-D4BD7E5A3187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Together, 76% of adolescent girls did not report instances of intimate partner sexual violence in the last 12 months. This proportion further increases among those who received educational social protection (81%) but not economic social protection (</a:t>
            </a:r>
            <a:r>
              <a:rPr lang="en-US" sz="1200" b="1" u="sng" dirty="0">
                <a:solidFill>
                  <a:schemeClr val="tx1"/>
                </a:solidFill>
              </a:rPr>
              <a:t>83%</a:t>
            </a:r>
            <a:r>
              <a:rPr lang="en-US" sz="12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46611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5113417" y="58730"/>
            <a:ext cx="19368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No intimate partner sexual violence in last 12 months </a:t>
            </a:r>
          </a:p>
          <a:p>
            <a:pPr algn="ctr"/>
            <a:r>
              <a:rPr lang="en-US" sz="1000" b="1"/>
              <a:t>82%</a:t>
            </a:r>
          </a:p>
          <a:p>
            <a:pPr algn="ctr"/>
            <a:r>
              <a:rPr lang="en-US" sz="1000" b="1"/>
              <a:t>(n=279)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19D7140-13B2-90C7-E1AD-911648344B69}"/>
              </a:ext>
            </a:extLst>
          </p:cNvPr>
          <p:cNvCxnSpPr>
            <a:cxnSpLocks/>
          </p:cNvCxnSpPr>
          <p:nvPr/>
        </p:nvCxnSpPr>
        <p:spPr>
          <a:xfrm>
            <a:off x="6081850" y="721300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Oval 1">
            <a:extLst>
              <a:ext uri="{FF2B5EF4-FFF2-40B4-BE49-F238E27FC236}">
                <a16:creationId xmlns:a16="http://schemas.microsoft.com/office/drawing/2014/main" id="{8916E81C-232A-EAFF-D780-C5139479CEAE}"/>
              </a:ext>
            </a:extLst>
          </p:cNvPr>
          <p:cNvSpPr/>
          <p:nvPr/>
        </p:nvSpPr>
        <p:spPr>
          <a:xfrm>
            <a:off x="5151156" y="291614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8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53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6787977-5C09-B334-FD07-217F85302EF9}"/>
              </a:ext>
            </a:extLst>
          </p:cNvPr>
          <p:cNvSpPr/>
          <p:nvPr/>
        </p:nvSpPr>
        <p:spPr>
          <a:xfrm>
            <a:off x="4710250" y="1021023"/>
            <a:ext cx="27432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9F55C2C8-AC13-A136-E80D-73151810EE79}"/>
              </a:ext>
            </a:extLst>
          </p:cNvPr>
          <p:cNvCxnSpPr>
            <a:cxnSpLocks/>
          </p:cNvCxnSpPr>
          <p:nvPr/>
        </p:nvCxnSpPr>
        <p:spPr>
          <a:xfrm>
            <a:off x="4904978" y="1311968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984EE4B4-0514-DB2E-017E-9B8C68ED5EB2}"/>
              </a:ext>
            </a:extLst>
          </p:cNvPr>
          <p:cNvSpPr txBox="1"/>
          <p:nvPr/>
        </p:nvSpPr>
        <p:spPr>
          <a:xfrm>
            <a:off x="4904978" y="1337686"/>
            <a:ext cx="507075" cy="246221"/>
          </a:xfrm>
          <a:prstGeom prst="rect">
            <a:avLst/>
          </a:prstGeom>
          <a:noFill/>
          <a:ln w="28575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7F64FAD7-CB3A-1A0B-60AA-4B9BD3898E14}"/>
              </a:ext>
            </a:extLst>
          </p:cNvPr>
          <p:cNvSpPr/>
          <p:nvPr/>
        </p:nvSpPr>
        <p:spPr>
          <a:xfrm>
            <a:off x="4493048" y="1601165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04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508913D-D366-ABCF-80B4-3F2FC7D90802}"/>
              </a:ext>
            </a:extLst>
          </p:cNvPr>
          <p:cNvSpPr/>
          <p:nvPr/>
        </p:nvSpPr>
        <p:spPr>
          <a:xfrm>
            <a:off x="3990578" y="2322618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CD18F91A-763F-5ED3-DF43-D8C9D956596F}"/>
              </a:ext>
            </a:extLst>
          </p:cNvPr>
          <p:cNvCxnSpPr>
            <a:cxnSpLocks/>
          </p:cNvCxnSpPr>
          <p:nvPr/>
        </p:nvCxnSpPr>
        <p:spPr>
          <a:xfrm>
            <a:off x="4266066" y="2626951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81C68BF-0984-3831-B6E3-EBE44E210CA2}"/>
              </a:ext>
            </a:extLst>
          </p:cNvPr>
          <p:cNvSpPr txBox="1"/>
          <p:nvPr/>
        </p:nvSpPr>
        <p:spPr>
          <a:xfrm>
            <a:off x="4267046" y="2646770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A1FF155A-B469-94FD-781C-68B73CD7C29D}"/>
              </a:ext>
            </a:extLst>
          </p:cNvPr>
          <p:cNvCxnSpPr>
            <a:cxnSpLocks/>
          </p:cNvCxnSpPr>
          <p:nvPr/>
        </p:nvCxnSpPr>
        <p:spPr>
          <a:xfrm>
            <a:off x="4904978" y="2033427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5E4BDB4C-41BA-A1C0-36D5-A6294817F73B}"/>
              </a:ext>
            </a:extLst>
          </p:cNvPr>
          <p:cNvCxnSpPr>
            <a:cxnSpLocks/>
            <a:endCxn id="14" idx="0"/>
          </p:cNvCxnSpPr>
          <p:nvPr/>
        </p:nvCxnSpPr>
        <p:spPr>
          <a:xfrm>
            <a:off x="7205529" y="1312285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915DA16-F32C-861F-0D8A-8F72C157A92F}"/>
              </a:ext>
            </a:extLst>
          </p:cNvPr>
          <p:cNvSpPr txBox="1"/>
          <p:nvPr/>
        </p:nvSpPr>
        <p:spPr>
          <a:xfrm>
            <a:off x="7205528" y="1337686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DF79E916-ED01-0D58-888C-2204CDA5C809}"/>
              </a:ext>
            </a:extLst>
          </p:cNvPr>
          <p:cNvSpPr/>
          <p:nvPr/>
        </p:nvSpPr>
        <p:spPr>
          <a:xfrm>
            <a:off x="6793599" y="1601165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5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777904C-D069-64CE-4D89-374DE3A91C62}"/>
              </a:ext>
            </a:extLst>
          </p:cNvPr>
          <p:cNvSpPr/>
          <p:nvPr/>
        </p:nvSpPr>
        <p:spPr>
          <a:xfrm>
            <a:off x="6276582" y="2322618"/>
            <a:ext cx="1828800" cy="2909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6712DBF5-EB41-7F9D-BECA-7BA27CBEA6F3}"/>
              </a:ext>
            </a:extLst>
          </p:cNvPr>
          <p:cNvCxnSpPr>
            <a:cxnSpLocks/>
          </p:cNvCxnSpPr>
          <p:nvPr/>
        </p:nvCxnSpPr>
        <p:spPr>
          <a:xfrm>
            <a:off x="7847483" y="262695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2BC1F5E7-29B2-9F68-4911-93100FF86C54}"/>
              </a:ext>
            </a:extLst>
          </p:cNvPr>
          <p:cNvSpPr txBox="1"/>
          <p:nvPr/>
        </p:nvSpPr>
        <p:spPr>
          <a:xfrm>
            <a:off x="7847483" y="2651850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0C1DE371-C825-96F3-3F3C-99ECE922B8E4}"/>
              </a:ext>
            </a:extLst>
          </p:cNvPr>
          <p:cNvSpPr/>
          <p:nvPr/>
        </p:nvSpPr>
        <p:spPr>
          <a:xfrm>
            <a:off x="7435553" y="291614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51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564B2B20-304F-92F5-3A5D-CB4AC0480F92}"/>
              </a:ext>
            </a:extLst>
          </p:cNvPr>
          <p:cNvCxnSpPr>
            <a:cxnSpLocks/>
          </p:cNvCxnSpPr>
          <p:nvPr/>
        </p:nvCxnSpPr>
        <p:spPr>
          <a:xfrm>
            <a:off x="7190982" y="2033427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317FD0B6-2D8C-1B07-F675-91655F08F038}"/>
              </a:ext>
            </a:extLst>
          </p:cNvPr>
          <p:cNvCxnSpPr>
            <a:cxnSpLocks/>
          </p:cNvCxnSpPr>
          <p:nvPr/>
        </p:nvCxnSpPr>
        <p:spPr>
          <a:xfrm>
            <a:off x="5563086" y="262695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DA42466-B8F6-9F16-1D38-29411DD716AE}"/>
              </a:ext>
            </a:extLst>
          </p:cNvPr>
          <p:cNvSpPr txBox="1"/>
          <p:nvPr/>
        </p:nvSpPr>
        <p:spPr>
          <a:xfrm>
            <a:off x="5563086" y="2652669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7AB53A6B-14D7-01EC-D4F9-2D50702CD416}"/>
              </a:ext>
            </a:extLst>
          </p:cNvPr>
          <p:cNvSpPr/>
          <p:nvPr/>
        </p:nvSpPr>
        <p:spPr>
          <a:xfrm>
            <a:off x="3849887" y="2916148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51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AA711C6C-0A33-08B6-B171-AA377118345D}"/>
              </a:ext>
            </a:extLst>
          </p:cNvPr>
          <p:cNvCxnSpPr>
            <a:cxnSpLocks/>
          </p:cNvCxnSpPr>
          <p:nvPr/>
        </p:nvCxnSpPr>
        <p:spPr>
          <a:xfrm>
            <a:off x="6487575" y="2626951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70C38928-FD3B-09B3-0FC1-76A17952E29E}"/>
              </a:ext>
            </a:extLst>
          </p:cNvPr>
          <p:cNvSpPr txBox="1"/>
          <p:nvPr/>
        </p:nvSpPr>
        <p:spPr>
          <a:xfrm>
            <a:off x="6488555" y="2646770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D63E7F10-149B-4A1A-0006-CCB962077C11}"/>
              </a:ext>
            </a:extLst>
          </p:cNvPr>
          <p:cNvSpPr/>
          <p:nvPr/>
        </p:nvSpPr>
        <p:spPr>
          <a:xfrm>
            <a:off x="6070161" y="2916148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6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4</a:t>
            </a: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DF471945-5BA5-F6DF-47AF-AEA0CE99DE34}"/>
              </a:ext>
            </a:extLst>
          </p:cNvPr>
          <p:cNvSpPr/>
          <p:nvPr/>
        </p:nvSpPr>
        <p:spPr>
          <a:xfrm>
            <a:off x="4493048" y="4245046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6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9BD0BEEE-8C42-F0D2-EC3B-595D0D22BBF6}"/>
              </a:ext>
            </a:extLst>
          </p:cNvPr>
          <p:cNvSpPr/>
          <p:nvPr/>
        </p:nvSpPr>
        <p:spPr>
          <a:xfrm>
            <a:off x="3332470" y="3651516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F30D7325-30A9-9685-E93A-805C3CCD5868}"/>
              </a:ext>
            </a:extLst>
          </p:cNvPr>
          <p:cNvCxnSpPr>
            <a:cxnSpLocks/>
          </p:cNvCxnSpPr>
          <p:nvPr/>
        </p:nvCxnSpPr>
        <p:spPr>
          <a:xfrm>
            <a:off x="3607958" y="395584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BD93B78F-0324-868D-639A-4D250753BB6B}"/>
              </a:ext>
            </a:extLst>
          </p:cNvPr>
          <p:cNvSpPr txBox="1"/>
          <p:nvPr/>
        </p:nvSpPr>
        <p:spPr>
          <a:xfrm>
            <a:off x="3608938" y="3975668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4DE7840A-7714-0771-D8B0-3335C9319370}"/>
              </a:ext>
            </a:extLst>
          </p:cNvPr>
          <p:cNvCxnSpPr>
            <a:cxnSpLocks/>
          </p:cNvCxnSpPr>
          <p:nvPr/>
        </p:nvCxnSpPr>
        <p:spPr>
          <a:xfrm>
            <a:off x="4246870" y="3362325"/>
            <a:ext cx="1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DC9F9B6C-05B2-A40C-18FA-58310BCCA15B}"/>
              </a:ext>
            </a:extLst>
          </p:cNvPr>
          <p:cNvCxnSpPr>
            <a:cxnSpLocks/>
          </p:cNvCxnSpPr>
          <p:nvPr/>
        </p:nvCxnSpPr>
        <p:spPr>
          <a:xfrm>
            <a:off x="4904978" y="3955849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Oval 41">
            <a:extLst>
              <a:ext uri="{FF2B5EF4-FFF2-40B4-BE49-F238E27FC236}">
                <a16:creationId xmlns:a16="http://schemas.microsoft.com/office/drawing/2014/main" id="{BFD8CD18-90B4-719A-8E0B-64350C7A6326}"/>
              </a:ext>
            </a:extLst>
          </p:cNvPr>
          <p:cNvSpPr/>
          <p:nvPr/>
        </p:nvSpPr>
        <p:spPr>
          <a:xfrm>
            <a:off x="3191779" y="424504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7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B713C29-E318-1EDC-A5BC-E3F643B07797}"/>
              </a:ext>
            </a:extLst>
          </p:cNvPr>
          <p:cNvSpPr txBox="1"/>
          <p:nvPr/>
        </p:nvSpPr>
        <p:spPr>
          <a:xfrm>
            <a:off x="4906511" y="3985437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938C704-C3B8-B0B4-BCF7-ECE9E5EFB9A0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4B: Decision tree predicting no intimate partner sexual violence among young women (aged 20-25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21" name="Rectangle: Rounded Corners 20">
            <a:extLst>
              <a:ext uri="{FF2B5EF4-FFF2-40B4-BE49-F238E27FC236}">
                <a16:creationId xmlns:a16="http://schemas.microsoft.com/office/drawing/2014/main" id="{CE892DCF-4AFC-C13C-737F-060C88EE96C2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Overall, 82% of young women did not report instances of intimate partner sexual violence in the last 12 months, a proportion that is maximized among those who did not receive economic social protection (83%) but did receive youth-friendly health services (85%) but did not complete social asset building (</a:t>
            </a:r>
            <a:r>
              <a:rPr lang="en-US" sz="1200" b="1" u="sng" dirty="0">
                <a:solidFill>
                  <a:schemeClr val="tx1"/>
                </a:solidFill>
              </a:rPr>
              <a:t>87%</a:t>
            </a:r>
            <a:r>
              <a:rPr lang="en-US" sz="1200" dirty="0">
                <a:solidFill>
                  <a:schemeClr val="tx1"/>
                </a:solidFill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59357291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2587FD-7786-B36D-8FF9-0C339E1B82B4}"/>
              </a:ext>
            </a:extLst>
          </p:cNvPr>
          <p:cNvSpPr txBox="1"/>
          <p:nvPr/>
        </p:nvSpPr>
        <p:spPr>
          <a:xfrm>
            <a:off x="5124302" y="58730"/>
            <a:ext cx="19368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/>
              <a:t>No non-partner sexual violence in last 12 months</a:t>
            </a:r>
          </a:p>
          <a:p>
            <a:pPr algn="ctr"/>
            <a:r>
              <a:rPr lang="en-US" sz="1000" b="1"/>
              <a:t>89%</a:t>
            </a:r>
          </a:p>
          <a:p>
            <a:pPr algn="ctr"/>
            <a:r>
              <a:rPr lang="en-US" sz="1000" b="1"/>
              <a:t>(n=337)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327A96A-39C5-C698-FC91-0BCEBBCFF434}"/>
              </a:ext>
            </a:extLst>
          </p:cNvPr>
          <p:cNvCxnSpPr>
            <a:cxnSpLocks/>
          </p:cNvCxnSpPr>
          <p:nvPr/>
        </p:nvCxnSpPr>
        <p:spPr>
          <a:xfrm>
            <a:off x="6087104" y="740510"/>
            <a:ext cx="1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53">
            <a:extLst>
              <a:ext uri="{FF2B5EF4-FFF2-40B4-BE49-F238E27FC236}">
                <a16:creationId xmlns:a16="http://schemas.microsoft.com/office/drawing/2014/main" id="{E1462198-F8B8-E8E0-7072-C184A6EF47D6}"/>
              </a:ext>
            </a:extLst>
          </p:cNvPr>
          <p:cNvSpPr/>
          <p:nvPr/>
        </p:nvSpPr>
        <p:spPr>
          <a:xfrm>
            <a:off x="5178335" y="1014724"/>
            <a:ext cx="1828800" cy="290945"/>
          </a:xfrm>
          <a:prstGeom prst="rect">
            <a:avLst/>
          </a:prstGeom>
          <a:noFill/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ducational social protection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D0E01F58-DB43-1379-1967-F1848B6D2731}"/>
              </a:ext>
            </a:extLst>
          </p:cNvPr>
          <p:cNvCxnSpPr>
            <a:cxnSpLocks/>
          </p:cNvCxnSpPr>
          <p:nvPr/>
        </p:nvCxnSpPr>
        <p:spPr>
          <a:xfrm>
            <a:off x="6761601" y="1305669"/>
            <a:ext cx="0" cy="306125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79542C5C-A0FE-7FEB-7A04-F46DC7762D20}"/>
              </a:ext>
            </a:extLst>
          </p:cNvPr>
          <p:cNvSpPr txBox="1"/>
          <p:nvPr/>
        </p:nvSpPr>
        <p:spPr>
          <a:xfrm>
            <a:off x="6762581" y="1367817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7BE7DB1B-360B-A744-B9AD-1D4525DDBD42}"/>
              </a:ext>
            </a:extLst>
          </p:cNvPr>
          <p:cNvSpPr/>
          <p:nvPr/>
        </p:nvSpPr>
        <p:spPr>
          <a:xfrm>
            <a:off x="6349671" y="1611794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6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6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D8477E5-4CB4-6C36-06CA-708E987BCC04}"/>
              </a:ext>
            </a:extLst>
          </p:cNvPr>
          <p:cNvSpPr txBox="1"/>
          <p:nvPr/>
        </p:nvSpPr>
        <p:spPr>
          <a:xfrm>
            <a:off x="5434852" y="1367817"/>
            <a:ext cx="504008" cy="2447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39D92A48-5392-88E0-6287-BC151CD9E269}"/>
              </a:ext>
            </a:extLst>
          </p:cNvPr>
          <p:cNvSpPr/>
          <p:nvPr/>
        </p:nvSpPr>
        <p:spPr>
          <a:xfrm>
            <a:off x="5021942" y="1611794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1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70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F16BC9A9-378E-D3DA-3316-904892728C2C}"/>
              </a:ext>
            </a:extLst>
          </p:cNvPr>
          <p:cNvCxnSpPr>
            <a:cxnSpLocks/>
          </p:cNvCxnSpPr>
          <p:nvPr/>
        </p:nvCxnSpPr>
        <p:spPr>
          <a:xfrm>
            <a:off x="6752132" y="2059418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08D3627E-2E87-9238-B8CB-9A42A5D9C474}"/>
              </a:ext>
            </a:extLst>
          </p:cNvPr>
          <p:cNvCxnSpPr>
            <a:cxnSpLocks/>
          </p:cNvCxnSpPr>
          <p:nvPr/>
        </p:nvCxnSpPr>
        <p:spPr>
          <a:xfrm>
            <a:off x="5433872" y="1319958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>
            <a:extLst>
              <a:ext uri="{FF2B5EF4-FFF2-40B4-BE49-F238E27FC236}">
                <a16:creationId xmlns:a16="http://schemas.microsoft.com/office/drawing/2014/main" id="{CE08F786-56FB-A473-9BA4-E6C769F28BFD}"/>
              </a:ext>
            </a:extLst>
          </p:cNvPr>
          <p:cNvSpPr/>
          <p:nvPr/>
        </p:nvSpPr>
        <p:spPr>
          <a:xfrm>
            <a:off x="5845664" y="2328834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conomic social protection</a:t>
            </a:r>
          </a:p>
        </p:txBody>
      </p: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C20B4CA9-38AF-821B-4DB0-554839B89E45}"/>
              </a:ext>
            </a:extLst>
          </p:cNvPr>
          <p:cNvCxnSpPr>
            <a:cxnSpLocks/>
          </p:cNvCxnSpPr>
          <p:nvPr/>
        </p:nvCxnSpPr>
        <p:spPr>
          <a:xfrm>
            <a:off x="5969488" y="2619779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id="{0D6F18F1-D861-0D1C-3FC8-3EF3D6267757}"/>
              </a:ext>
            </a:extLst>
          </p:cNvPr>
          <p:cNvSpPr txBox="1"/>
          <p:nvPr/>
        </p:nvSpPr>
        <p:spPr>
          <a:xfrm>
            <a:off x="5969488" y="2645497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EDDEE835-4085-E84A-2BC5-826F5168E100}"/>
              </a:ext>
            </a:extLst>
          </p:cNvPr>
          <p:cNvSpPr/>
          <p:nvPr/>
        </p:nvSpPr>
        <p:spPr>
          <a:xfrm>
            <a:off x="5557558" y="2896016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79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22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2A6C174A-9E2C-3A0E-E44A-E57A78FF765D}"/>
              </a:ext>
            </a:extLst>
          </p:cNvPr>
          <p:cNvCxnSpPr>
            <a:cxnSpLocks/>
          </p:cNvCxnSpPr>
          <p:nvPr/>
        </p:nvCxnSpPr>
        <p:spPr>
          <a:xfrm>
            <a:off x="7445863" y="2619779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27D391F5-B44C-66CF-3358-FA45C521C962}"/>
              </a:ext>
            </a:extLst>
          </p:cNvPr>
          <p:cNvSpPr txBox="1"/>
          <p:nvPr/>
        </p:nvSpPr>
        <p:spPr>
          <a:xfrm>
            <a:off x="7445863" y="2645497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C37B58CA-8074-87A9-A82F-E2A1953EF3C9}"/>
              </a:ext>
            </a:extLst>
          </p:cNvPr>
          <p:cNvSpPr/>
          <p:nvPr/>
        </p:nvSpPr>
        <p:spPr>
          <a:xfrm>
            <a:off x="7033934" y="2896016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7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45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F48654A1-BF9E-99AD-22D5-A0D919A91CAC}"/>
              </a:ext>
            </a:extLst>
          </p:cNvPr>
          <p:cNvCxnSpPr>
            <a:cxnSpLocks/>
          </p:cNvCxnSpPr>
          <p:nvPr/>
        </p:nvCxnSpPr>
        <p:spPr>
          <a:xfrm>
            <a:off x="7444305" y="3335099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Rectangle 69">
            <a:extLst>
              <a:ext uri="{FF2B5EF4-FFF2-40B4-BE49-F238E27FC236}">
                <a16:creationId xmlns:a16="http://schemas.microsoft.com/office/drawing/2014/main" id="{CFD3F218-136B-4CD7-889B-38FF540096E3}"/>
              </a:ext>
            </a:extLst>
          </p:cNvPr>
          <p:cNvSpPr/>
          <p:nvPr/>
        </p:nvSpPr>
        <p:spPr>
          <a:xfrm>
            <a:off x="6537837" y="3604515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Youth-friendly health services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F1E4E0CC-9137-258A-2A6A-2C825E242B29}"/>
              </a:ext>
            </a:extLst>
          </p:cNvPr>
          <p:cNvCxnSpPr>
            <a:cxnSpLocks/>
          </p:cNvCxnSpPr>
          <p:nvPr/>
        </p:nvCxnSpPr>
        <p:spPr>
          <a:xfrm>
            <a:off x="6661661" y="3895460"/>
            <a:ext cx="0" cy="27432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2EBDE31D-12D9-1294-EF34-CA578AAFD2DD}"/>
              </a:ext>
            </a:extLst>
          </p:cNvPr>
          <p:cNvSpPr txBox="1"/>
          <p:nvPr/>
        </p:nvSpPr>
        <p:spPr>
          <a:xfrm>
            <a:off x="6661661" y="3921178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19AA2833-798E-32B9-EC81-698882C7C03C}"/>
              </a:ext>
            </a:extLst>
          </p:cNvPr>
          <p:cNvSpPr/>
          <p:nvPr/>
        </p:nvSpPr>
        <p:spPr>
          <a:xfrm>
            <a:off x="6249731" y="417169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85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103</a:t>
            </a:r>
          </a:p>
        </p:txBody>
      </p: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3DCACE3B-257E-8891-6658-D237996CB62D}"/>
              </a:ext>
            </a:extLst>
          </p:cNvPr>
          <p:cNvCxnSpPr>
            <a:cxnSpLocks/>
          </p:cNvCxnSpPr>
          <p:nvPr/>
        </p:nvCxnSpPr>
        <p:spPr>
          <a:xfrm>
            <a:off x="8138036" y="3895460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7494CA8-BE8B-C73A-EF5C-2B3D649FE4B8}"/>
              </a:ext>
            </a:extLst>
          </p:cNvPr>
          <p:cNvSpPr txBox="1"/>
          <p:nvPr/>
        </p:nvSpPr>
        <p:spPr>
          <a:xfrm>
            <a:off x="8138036" y="3921178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4D11C825-2114-97B8-86E4-3BFBAA9DE036}"/>
              </a:ext>
            </a:extLst>
          </p:cNvPr>
          <p:cNvSpPr/>
          <p:nvPr/>
        </p:nvSpPr>
        <p:spPr>
          <a:xfrm>
            <a:off x="7726107" y="4171697"/>
            <a:ext cx="823860" cy="432262"/>
          </a:xfrm>
          <a:prstGeom prst="ellipse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3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42</a:t>
            </a: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E4C01555-70E7-76CA-5654-118C5765E3A6}"/>
              </a:ext>
            </a:extLst>
          </p:cNvPr>
          <p:cNvCxnSpPr>
            <a:cxnSpLocks/>
          </p:cNvCxnSpPr>
          <p:nvPr/>
        </p:nvCxnSpPr>
        <p:spPr>
          <a:xfrm>
            <a:off x="8141335" y="4617749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>
            <a:extLst>
              <a:ext uri="{FF2B5EF4-FFF2-40B4-BE49-F238E27FC236}">
                <a16:creationId xmlns:a16="http://schemas.microsoft.com/office/drawing/2014/main" id="{63FEEC07-7D58-D23A-8D39-CCC7B94C1C19}"/>
              </a:ext>
            </a:extLst>
          </p:cNvPr>
          <p:cNvSpPr/>
          <p:nvPr/>
        </p:nvSpPr>
        <p:spPr>
          <a:xfrm>
            <a:off x="7234866" y="4887165"/>
            <a:ext cx="1828800" cy="290945"/>
          </a:xfrm>
          <a:prstGeom prst="rect">
            <a:avLst/>
          </a:prstGeom>
          <a:noFill/>
          <a:ln w="28575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chemeClr val="tx1"/>
                </a:solidFill>
              </a:rPr>
              <a:t>Social asset building </a:t>
            </a:r>
          </a:p>
        </p:txBody>
      </p: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C51D8ABA-3191-BA5F-99F4-E4FE4CDE3C45}"/>
              </a:ext>
            </a:extLst>
          </p:cNvPr>
          <p:cNvCxnSpPr>
            <a:cxnSpLocks/>
          </p:cNvCxnSpPr>
          <p:nvPr/>
        </p:nvCxnSpPr>
        <p:spPr>
          <a:xfrm>
            <a:off x="7358691" y="5178110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906ECDBE-00FD-B0BF-ABB1-B34FEC9E1DF6}"/>
              </a:ext>
            </a:extLst>
          </p:cNvPr>
          <p:cNvSpPr txBox="1"/>
          <p:nvPr/>
        </p:nvSpPr>
        <p:spPr>
          <a:xfrm>
            <a:off x="7358691" y="5203828"/>
            <a:ext cx="5070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Yes</a:t>
            </a:r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8273BA44-9E36-CA75-DAF3-8B838E7BADB3}"/>
              </a:ext>
            </a:extLst>
          </p:cNvPr>
          <p:cNvSpPr/>
          <p:nvPr/>
        </p:nvSpPr>
        <p:spPr>
          <a:xfrm>
            <a:off x="6946762" y="5454347"/>
            <a:ext cx="823860" cy="432262"/>
          </a:xfrm>
          <a:prstGeom prst="ellipse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100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6</a:t>
            </a:r>
          </a:p>
        </p:txBody>
      </p: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574C75BE-09E8-ACCE-B889-1D176BA0CDD1}"/>
              </a:ext>
            </a:extLst>
          </p:cNvPr>
          <p:cNvCxnSpPr>
            <a:cxnSpLocks/>
          </p:cNvCxnSpPr>
          <p:nvPr/>
        </p:nvCxnSpPr>
        <p:spPr>
          <a:xfrm>
            <a:off x="8835066" y="5178110"/>
            <a:ext cx="0" cy="274320"/>
          </a:xfrm>
          <a:prstGeom prst="straightConnector1">
            <a:avLst/>
          </a:prstGeom>
          <a:ln w="28575">
            <a:solidFill>
              <a:schemeClr val="tx2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D2638978-65AE-16DE-68DA-F5FCEC44CEF5}"/>
              </a:ext>
            </a:extLst>
          </p:cNvPr>
          <p:cNvSpPr txBox="1"/>
          <p:nvPr/>
        </p:nvSpPr>
        <p:spPr>
          <a:xfrm>
            <a:off x="8835066" y="5203828"/>
            <a:ext cx="507075" cy="246221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r>
              <a:rPr lang="en-US" sz="1000" b="1"/>
              <a:t>No</a:t>
            </a:r>
          </a:p>
        </p:txBody>
      </p:sp>
      <p:sp>
        <p:nvSpPr>
          <p:cNvPr id="84" name="Oval 83">
            <a:extLst>
              <a:ext uri="{FF2B5EF4-FFF2-40B4-BE49-F238E27FC236}">
                <a16:creationId xmlns:a16="http://schemas.microsoft.com/office/drawing/2014/main" id="{5B5D2A3F-43CF-6F73-3991-D9B3D010F694}"/>
              </a:ext>
            </a:extLst>
          </p:cNvPr>
          <p:cNvSpPr/>
          <p:nvPr/>
        </p:nvSpPr>
        <p:spPr>
          <a:xfrm>
            <a:off x="8423136" y="5454347"/>
            <a:ext cx="823860" cy="432262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92%</a:t>
            </a:r>
          </a:p>
          <a:p>
            <a:pPr algn="ctr"/>
            <a:r>
              <a:rPr lang="en-US" sz="1000">
                <a:solidFill>
                  <a:sysClr val="windowText" lastClr="000000"/>
                </a:solidFill>
              </a:rPr>
              <a:t>n=3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F8FCA20-9C57-6350-2A95-508AC379DC38}"/>
              </a:ext>
            </a:extLst>
          </p:cNvPr>
          <p:cNvSpPr txBox="1"/>
          <p:nvPr/>
        </p:nvSpPr>
        <p:spPr>
          <a:xfrm>
            <a:off x="0" y="6482691"/>
            <a:ext cx="12192000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Mangal" panose="02040503050203030202" pitchFamily="18" charset="0"/>
              </a:rPr>
              <a:t>Supplementary Figure </a:t>
            </a:r>
            <a:r>
              <a:rPr lang="en-IN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5A: Decision tree predicting no non-partner sexual violence among adolescent girls (aged 15-19 years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Mangal" panose="02040503050203030202" pitchFamily="18" charset="0"/>
            </a:endParaRP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EDEC26F4-70EB-5AFE-393C-3D44A30B1A09}"/>
              </a:ext>
            </a:extLst>
          </p:cNvPr>
          <p:cNvSpPr/>
          <p:nvPr/>
        </p:nvSpPr>
        <p:spPr>
          <a:xfrm>
            <a:off x="80961" y="52223"/>
            <a:ext cx="3982090" cy="2103120"/>
          </a:xfrm>
          <a:prstGeom prst="roundRect">
            <a:avLst/>
          </a:prstGeom>
          <a:solidFill>
            <a:schemeClr val="tx2">
              <a:lumMod val="25000"/>
              <a:lumOff val="75000"/>
            </a:schemeClr>
          </a:solidFill>
          <a:ln w="38100">
            <a:solidFill>
              <a:schemeClr val="tx2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u="sng" dirty="0">
                <a:solidFill>
                  <a:schemeClr val="tx1"/>
                </a:solidFill>
              </a:rPr>
              <a:t>Interpreting the tree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In sum, 89% of adolescent girls did not report surviving sexual violence from a non-partner in the last 12 months. This proportion is maximized among adolescent girls who did not receive educational social protection (86%), economic social protection (87%), and youth-friendly health services (93%) but completed social asset building (</a:t>
            </a:r>
            <a:r>
              <a:rPr lang="en-US" sz="1200" b="1" u="sng" dirty="0">
                <a:solidFill>
                  <a:schemeClr val="tx1"/>
                </a:solidFill>
              </a:rPr>
              <a:t>100%</a:t>
            </a:r>
            <a:r>
              <a:rPr lang="en-US" sz="1200" dirty="0">
                <a:solidFill>
                  <a:schemeClr val="tx1"/>
                </a:solidFill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475474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PC">
      <a:dk1>
        <a:srgbClr val="000000"/>
      </a:dk1>
      <a:lt1>
        <a:sysClr val="window" lastClr="FFFFFF"/>
      </a:lt1>
      <a:dk2>
        <a:srgbClr val="003A5D"/>
      </a:dk2>
      <a:lt2>
        <a:srgbClr val="FFFFFF"/>
      </a:lt2>
      <a:accent1>
        <a:srgbClr val="6CC04A"/>
      </a:accent1>
      <a:accent2>
        <a:srgbClr val="003A5D"/>
      </a:accent2>
      <a:accent3>
        <a:srgbClr val="00A8E1"/>
      </a:accent3>
      <a:accent4>
        <a:srgbClr val="F47B1F"/>
      </a:accent4>
      <a:accent5>
        <a:srgbClr val="999899"/>
      </a:accent5>
      <a:accent6>
        <a:srgbClr val="A8D597"/>
      </a:accent6>
      <a:hlink>
        <a:srgbClr val="00A8E1"/>
      </a:hlink>
      <a:folHlink>
        <a:srgbClr val="6CC04A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b2eb9176-54a5-4a2f-8a9f-1ce638bc2403">
      <Terms xmlns="http://schemas.microsoft.com/office/infopath/2007/PartnerControls"/>
    </lcf76f155ced4ddcb4097134ff3c332f>
    <TaxCatchAll xmlns="8bf3daf7-1d61-4fbd-824a-c66aa760a3e5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BECF266934C19429BA1D5484EB56617" ma:contentTypeVersion="16" ma:contentTypeDescription="Create a new document." ma:contentTypeScope="" ma:versionID="e07cf1cacfe7d6461937bf089c5941b0">
  <xsd:schema xmlns:xsd="http://www.w3.org/2001/XMLSchema" xmlns:xs="http://www.w3.org/2001/XMLSchema" xmlns:p="http://schemas.microsoft.com/office/2006/metadata/properties" xmlns:ns2="b2eb9176-54a5-4a2f-8a9f-1ce638bc2403" xmlns:ns3="8bf3daf7-1d61-4fbd-824a-c66aa760a3e5" targetNamespace="http://schemas.microsoft.com/office/2006/metadata/properties" ma:root="true" ma:fieldsID="629f3a5f4037d03ae0c1a55da716ad4c" ns2:_="" ns3:_="">
    <xsd:import namespace="b2eb9176-54a5-4a2f-8a9f-1ce638bc2403"/>
    <xsd:import namespace="8bf3daf7-1d61-4fbd-824a-c66aa760a3e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MediaServiceOCR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2eb9176-54a5-4a2f-8a9f-1ce638bc24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021274bc-f60e-43e3-8007-8359870f1b2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f3daf7-1d61-4fbd-824a-c66aa760a3e5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1713bd6d-f165-4536-94a7-1702447d7513}" ma:internalName="TaxCatchAll" ma:showField="CatchAllData" ma:web="8bf3daf7-1d61-4fbd-824a-c66aa760a3e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9CE2733-6F77-457A-B6EA-0B4F2957E733}">
  <ds:schemaRefs>
    <ds:schemaRef ds:uri="http://schemas.microsoft.com/office/2006/metadata/properties"/>
    <ds:schemaRef ds:uri="http://schemas.microsoft.com/office/infopath/2007/PartnerControls"/>
    <ds:schemaRef ds:uri="b2eb9176-54a5-4a2f-8a9f-1ce638bc2403"/>
    <ds:schemaRef ds:uri="8bf3daf7-1d61-4fbd-824a-c66aa760a3e5"/>
  </ds:schemaRefs>
</ds:datastoreItem>
</file>

<file path=customXml/itemProps2.xml><?xml version="1.0" encoding="utf-8"?>
<ds:datastoreItem xmlns:ds="http://schemas.openxmlformats.org/officeDocument/2006/customXml" ds:itemID="{1D8BEBE4-FED1-42AC-BD2F-DE8F6CA1126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2B0BD97-9A4E-437F-AF57-C8396664790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2eb9176-54a5-4a2f-8a9f-1ce638bc2403"/>
    <ds:schemaRef ds:uri="8bf3daf7-1d61-4fbd-824a-c66aa760a3e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768</Words>
  <Application>Microsoft Office PowerPoint</Application>
  <PresentationFormat>Widescreen</PresentationFormat>
  <Paragraphs>408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ry Hutchinson</dc:creator>
  <cp:lastModifiedBy>Craig Heck</cp:lastModifiedBy>
  <cp:revision>1</cp:revision>
  <dcterms:created xsi:type="dcterms:W3CDTF">2023-07-09T14:41:25Z</dcterms:created>
  <dcterms:modified xsi:type="dcterms:W3CDTF">2023-07-27T11:1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BECF266934C19429BA1D5484EB56617</vt:lpwstr>
  </property>
  <property fmtid="{D5CDD505-2E9C-101B-9397-08002B2CF9AE}" pid="3" name="MediaServiceImageTags">
    <vt:lpwstr/>
  </property>
</Properties>
</file>